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s/slide29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s/slide27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2.xml" ContentType="application/vnd.openxmlformats-officedocument.presentationml.slide+xml"/>
  <Override PartName="/ppt/slides/slide16.xml" ContentType="application/vnd.openxmlformats-officedocument.presentationml.slide+xml"/>
  <Override PartName="/ppt/slides/slide2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31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3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notesSlides/notesSlide8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s/slide28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24.xml" ContentType="application/vnd.openxmlformats-officedocument.presentationml.slide+xml"/>
  <Override PartName="/ppt/slideLayouts/slideLayout3.xml" ContentType="application/vnd.openxmlformats-officedocument.presentationml.slideLayout+xml"/>
  <Default Extension="jpeg" ContentType="image/jpe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3"/>
  </p:notesMasterIdLst>
  <p:sldIdLst>
    <p:sldId id="297" r:id="rId2"/>
    <p:sldId id="295" r:id="rId3"/>
    <p:sldId id="258" r:id="rId4"/>
    <p:sldId id="284" r:id="rId5"/>
    <p:sldId id="259" r:id="rId6"/>
    <p:sldId id="260" r:id="rId7"/>
    <p:sldId id="257" r:id="rId8"/>
    <p:sldId id="282" r:id="rId9"/>
    <p:sldId id="298" r:id="rId10"/>
    <p:sldId id="283" r:id="rId11"/>
    <p:sldId id="267" r:id="rId12"/>
    <p:sldId id="296" r:id="rId13"/>
    <p:sldId id="287" r:id="rId14"/>
    <p:sldId id="286" r:id="rId15"/>
    <p:sldId id="288" r:id="rId16"/>
    <p:sldId id="289" r:id="rId17"/>
    <p:sldId id="290" r:id="rId18"/>
    <p:sldId id="291" r:id="rId19"/>
    <p:sldId id="294" r:id="rId20"/>
    <p:sldId id="263" r:id="rId21"/>
    <p:sldId id="293" r:id="rId22"/>
    <p:sldId id="265" r:id="rId23"/>
    <p:sldId id="266" r:id="rId24"/>
    <p:sldId id="274" r:id="rId25"/>
    <p:sldId id="275" r:id="rId26"/>
    <p:sldId id="277" r:id="rId27"/>
    <p:sldId id="278" r:id="rId28"/>
    <p:sldId id="279" r:id="rId29"/>
    <p:sldId id="276" r:id="rId30"/>
    <p:sldId id="281" r:id="rId31"/>
    <p:sldId id="280" r:id="rId3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82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00FF"/>
    <a:srgbClr val="00FF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97" autoAdjust="0"/>
    <p:restoredTop sz="94591" autoAdjust="0"/>
  </p:normalViewPr>
  <p:slideViewPr>
    <p:cSldViewPr snapToGrid="0" showGuides="1">
      <p:cViewPr>
        <p:scale>
          <a:sx n="60" d="100"/>
          <a:sy n="60" d="100"/>
        </p:scale>
        <p:origin x="-1674" y="-18"/>
      </p:cViewPr>
      <p:guideLst>
        <p:guide orient="horz" pos="482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589CB3-B5C1-4BD2-9220-65E393CE3833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2AF75E-D815-49FC-BC47-2D03D60689F6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9704676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2AF75E-D815-49FC-BC47-2D03D60689F6}" type="slidenum">
              <a:rPr lang="en-GB" smtClean="0"/>
              <a:pPr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174919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2AF75E-D815-49FC-BC47-2D03D60689F6}" type="slidenum">
              <a:rPr lang="en-GB" smtClean="0"/>
              <a:pPr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0781397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2AF75E-D815-49FC-BC47-2D03D60689F6}" type="slidenum">
              <a:rPr lang="en-GB" smtClean="0"/>
              <a:pPr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7062351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2AF75E-D815-49FC-BC47-2D03D60689F6}" type="slidenum">
              <a:rPr lang="en-GB" smtClean="0"/>
              <a:pPr/>
              <a:t>1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35350945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2AF75E-D815-49FC-BC47-2D03D60689F6}" type="slidenum">
              <a:rPr lang="en-GB" smtClean="0"/>
              <a:pPr/>
              <a:t>2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94354024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2AF75E-D815-49FC-BC47-2D03D60689F6}" type="slidenum">
              <a:rPr lang="en-GB" smtClean="0"/>
              <a:pPr/>
              <a:t>2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2141832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2AF75E-D815-49FC-BC47-2D03D60689F6}" type="slidenum">
              <a:rPr lang="en-GB" smtClean="0"/>
              <a:pPr/>
              <a:t>2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63170652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2AF75E-D815-49FC-BC47-2D03D60689F6}" type="slidenum">
              <a:rPr lang="en-GB" smtClean="0"/>
              <a:pPr/>
              <a:t>2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1116342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06119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216200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4956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28292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0113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130372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07421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21787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6448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93519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82442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7488F2-5603-4612-B320-E2D980671D81}" type="datetimeFigureOut">
              <a:rPr lang="en-GB" smtClean="0"/>
              <a:pPr/>
              <a:t>27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EF8D5B-D94B-44D8-B485-9739794B0A05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09777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hyperlink" Target="https://pubmed.ncbi.nlm.nih.gov/22308394/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7.png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95793FC-738C-430C-933F-DE1D30EA7938}"/>
              </a:ext>
            </a:extLst>
          </p:cNvPr>
          <p:cNvSpPr txBox="1"/>
          <p:nvPr/>
        </p:nvSpPr>
        <p:spPr>
          <a:xfrm>
            <a:off x="599579" y="1115434"/>
            <a:ext cx="5695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1. </a:t>
            </a:r>
            <a:r>
              <a:rPr lang="en-GB" b="1" dirty="0"/>
              <a:t>Index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5E2F33D1-7B3F-4682-A389-C4877BF81A66}"/>
              </a:ext>
            </a:extLst>
          </p:cNvPr>
          <p:cNvSpPr txBox="1"/>
          <p:nvPr/>
        </p:nvSpPr>
        <p:spPr>
          <a:xfrm>
            <a:off x="599579" y="1537709"/>
            <a:ext cx="3962400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2. </a:t>
            </a:r>
            <a:r>
              <a:rPr lang="en-GB" sz="1400" dirty="0"/>
              <a:t>Key to mapping colours</a:t>
            </a:r>
          </a:p>
          <a:p>
            <a:r>
              <a:rPr lang="en-GB" sz="1400" dirty="0" smtClean="0"/>
              <a:t>3. </a:t>
            </a:r>
            <a:r>
              <a:rPr lang="en-GB" sz="1400" dirty="0"/>
              <a:t>Cathepsin B1.2</a:t>
            </a:r>
          </a:p>
          <a:p>
            <a:r>
              <a:rPr lang="en-GB" sz="1400" dirty="0" smtClean="0"/>
              <a:t>4. </a:t>
            </a:r>
            <a:r>
              <a:rPr lang="en-GB" sz="1400" dirty="0"/>
              <a:t>Cathepsin B2</a:t>
            </a:r>
          </a:p>
          <a:p>
            <a:r>
              <a:rPr lang="en-GB" sz="1400" dirty="0" smtClean="0"/>
              <a:t>5. </a:t>
            </a:r>
            <a:r>
              <a:rPr lang="en-GB" sz="1400" dirty="0"/>
              <a:t>Cathepsin L</a:t>
            </a:r>
          </a:p>
          <a:p>
            <a:r>
              <a:rPr lang="en-GB" sz="1400" dirty="0" smtClean="0"/>
              <a:t>6. </a:t>
            </a:r>
            <a:r>
              <a:rPr lang="en-GB" sz="1400" dirty="0"/>
              <a:t>Cathepsin S</a:t>
            </a:r>
          </a:p>
          <a:p>
            <a:r>
              <a:rPr lang="en-GB" sz="1400" dirty="0" smtClean="0"/>
              <a:t>7. </a:t>
            </a:r>
            <a:r>
              <a:rPr lang="en-GB" sz="1400" dirty="0"/>
              <a:t>Asparaginyl endopeptidase</a:t>
            </a:r>
          </a:p>
          <a:p>
            <a:r>
              <a:rPr lang="en-GB" sz="1400" dirty="0" smtClean="0"/>
              <a:t>8. </a:t>
            </a:r>
            <a:r>
              <a:rPr lang="en-GB" sz="1400" dirty="0"/>
              <a:t>Asparaginyl endopeptidase</a:t>
            </a:r>
          </a:p>
          <a:p>
            <a:r>
              <a:rPr lang="en-GB" sz="1400" dirty="0" smtClean="0"/>
              <a:t>9. </a:t>
            </a:r>
            <a:r>
              <a:rPr lang="en-GB" sz="1400" dirty="0"/>
              <a:t>Ferritin nanocage model</a:t>
            </a:r>
          </a:p>
          <a:p>
            <a:r>
              <a:rPr lang="en-GB" sz="1400" dirty="0" smtClean="0"/>
              <a:t>10. </a:t>
            </a:r>
            <a:r>
              <a:rPr lang="en-GB" sz="1400" dirty="0"/>
              <a:t>Apoferritin</a:t>
            </a:r>
          </a:p>
          <a:p>
            <a:r>
              <a:rPr lang="en-GB" sz="1400" dirty="0" smtClean="0"/>
              <a:t>11. </a:t>
            </a:r>
            <a:r>
              <a:rPr lang="en-GB" sz="1400" dirty="0"/>
              <a:t>Ferritin 2</a:t>
            </a:r>
          </a:p>
          <a:p>
            <a:r>
              <a:rPr lang="en-GB" sz="1400" dirty="0" smtClean="0"/>
              <a:t>12. </a:t>
            </a:r>
            <a:r>
              <a:rPr lang="en-GB" sz="1400" dirty="0" err="1"/>
              <a:t>Saposin</a:t>
            </a:r>
            <a:r>
              <a:rPr lang="en-GB" sz="1400" dirty="0"/>
              <a:t> model</a:t>
            </a:r>
          </a:p>
          <a:p>
            <a:r>
              <a:rPr lang="en-GB" sz="1400" dirty="0" smtClean="0"/>
              <a:t>13. </a:t>
            </a:r>
            <a:r>
              <a:rPr lang="en-GB" sz="1400" dirty="0" err="1"/>
              <a:t>Saposin</a:t>
            </a:r>
            <a:r>
              <a:rPr lang="en-GB" sz="1400" dirty="0"/>
              <a:t> 1</a:t>
            </a:r>
          </a:p>
          <a:p>
            <a:r>
              <a:rPr lang="en-GB" sz="1400" dirty="0" smtClean="0"/>
              <a:t>14. </a:t>
            </a:r>
            <a:r>
              <a:rPr lang="en-GB" sz="1400" dirty="0" err="1"/>
              <a:t>Saposin</a:t>
            </a:r>
            <a:r>
              <a:rPr lang="en-GB" sz="1400" dirty="0"/>
              <a:t> 2</a:t>
            </a:r>
          </a:p>
          <a:p>
            <a:r>
              <a:rPr lang="en-GB" sz="1400" dirty="0" smtClean="0"/>
              <a:t>15. </a:t>
            </a:r>
            <a:r>
              <a:rPr lang="en-GB" sz="1400" dirty="0" err="1"/>
              <a:t>Saposin</a:t>
            </a:r>
            <a:r>
              <a:rPr lang="en-GB" sz="1400" dirty="0"/>
              <a:t> 3</a:t>
            </a:r>
          </a:p>
          <a:p>
            <a:r>
              <a:rPr lang="en-GB" sz="1400" dirty="0" smtClean="0"/>
              <a:t>16. </a:t>
            </a:r>
            <a:r>
              <a:rPr lang="en-GB" sz="1400" dirty="0" err="1"/>
              <a:t>Saposin</a:t>
            </a:r>
            <a:r>
              <a:rPr lang="en-GB" sz="1400" dirty="0"/>
              <a:t> 4</a:t>
            </a:r>
          </a:p>
          <a:p>
            <a:endParaRPr lang="en-GB" sz="14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EBE4CB5D-0E72-4ADD-A35E-0B31D4307C70}"/>
              </a:ext>
            </a:extLst>
          </p:cNvPr>
          <p:cNvSpPr txBox="1"/>
          <p:nvPr/>
        </p:nvSpPr>
        <p:spPr>
          <a:xfrm>
            <a:off x="4572000" y="1494291"/>
            <a:ext cx="4105275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17. </a:t>
            </a:r>
            <a:r>
              <a:rPr lang="en-GB" sz="1400" dirty="0" err="1"/>
              <a:t>Saposin</a:t>
            </a:r>
            <a:r>
              <a:rPr lang="en-GB" sz="1400" dirty="0"/>
              <a:t> 5</a:t>
            </a:r>
          </a:p>
          <a:p>
            <a:r>
              <a:rPr lang="en-GB" sz="1400" dirty="0" smtClean="0"/>
              <a:t>18. </a:t>
            </a:r>
            <a:r>
              <a:rPr lang="en-GB" sz="1400" dirty="0" err="1"/>
              <a:t>Saposin</a:t>
            </a:r>
            <a:r>
              <a:rPr lang="en-GB" sz="1400" dirty="0"/>
              <a:t> 6</a:t>
            </a:r>
          </a:p>
          <a:p>
            <a:r>
              <a:rPr lang="en-GB" sz="1400" dirty="0" smtClean="0"/>
              <a:t>19. </a:t>
            </a:r>
            <a:r>
              <a:rPr lang="en-GB" sz="1400" dirty="0"/>
              <a:t>NPC2</a:t>
            </a:r>
          </a:p>
          <a:p>
            <a:r>
              <a:rPr lang="en-GB" sz="1400" dirty="0" smtClean="0"/>
              <a:t>20. </a:t>
            </a:r>
            <a:r>
              <a:rPr lang="en-GB" sz="1400" dirty="0"/>
              <a:t>ATP </a:t>
            </a:r>
            <a:r>
              <a:rPr lang="en-GB" sz="1400" dirty="0" err="1"/>
              <a:t>diphosphohydrolase</a:t>
            </a:r>
            <a:r>
              <a:rPr lang="en-GB" sz="1400" dirty="0"/>
              <a:t>/Apyrase</a:t>
            </a:r>
          </a:p>
          <a:p>
            <a:r>
              <a:rPr lang="en-GB" sz="1400" dirty="0" smtClean="0"/>
              <a:t>21. </a:t>
            </a:r>
            <a:r>
              <a:rPr lang="en-GB" sz="1400" dirty="0"/>
              <a:t>ADP Ribosyl cyclase</a:t>
            </a:r>
          </a:p>
          <a:p>
            <a:r>
              <a:rPr lang="en-GB" sz="1400" dirty="0" smtClean="0"/>
              <a:t>22. </a:t>
            </a:r>
            <a:r>
              <a:rPr lang="en-GB" sz="1400" dirty="0"/>
              <a:t>Carbonic anhydrase</a:t>
            </a:r>
          </a:p>
          <a:p>
            <a:r>
              <a:rPr lang="en-GB" sz="1400" dirty="0" smtClean="0"/>
              <a:t>23. </a:t>
            </a:r>
            <a:r>
              <a:rPr lang="en-GB" sz="1400" dirty="0"/>
              <a:t>Calpain</a:t>
            </a:r>
          </a:p>
          <a:p>
            <a:r>
              <a:rPr lang="en-GB" sz="1400" dirty="0" smtClean="0"/>
              <a:t>24. </a:t>
            </a:r>
            <a:r>
              <a:rPr lang="en-GB" sz="1400" dirty="0"/>
              <a:t>TSP2</a:t>
            </a:r>
          </a:p>
          <a:p>
            <a:r>
              <a:rPr lang="en-GB" sz="1400" dirty="0" smtClean="0"/>
              <a:t>25. TSP, </a:t>
            </a:r>
            <a:r>
              <a:rPr lang="en-GB" sz="1400" dirty="0"/>
              <a:t>Smp_194970</a:t>
            </a:r>
          </a:p>
          <a:p>
            <a:r>
              <a:rPr lang="en-GB" sz="1400" dirty="0" smtClean="0"/>
              <a:t>26. </a:t>
            </a:r>
            <a:r>
              <a:rPr lang="en-GB" sz="1400" dirty="0"/>
              <a:t>Annexin Smp_074150</a:t>
            </a:r>
          </a:p>
          <a:p>
            <a:r>
              <a:rPr lang="en-GB" sz="1400" dirty="0" smtClean="0"/>
              <a:t>27. </a:t>
            </a:r>
            <a:r>
              <a:rPr lang="en-GB" sz="1400" dirty="0"/>
              <a:t>Annexin Smp_074140</a:t>
            </a:r>
          </a:p>
          <a:p>
            <a:r>
              <a:rPr lang="en-GB" sz="1400" dirty="0" smtClean="0"/>
              <a:t>28. </a:t>
            </a:r>
            <a:r>
              <a:rPr lang="en-GB" sz="1400" dirty="0"/>
              <a:t>Annexin, Smp_077720</a:t>
            </a:r>
          </a:p>
          <a:p>
            <a:r>
              <a:rPr lang="en-GB" sz="1400" dirty="0" smtClean="0"/>
              <a:t>29. </a:t>
            </a:r>
            <a:r>
              <a:rPr lang="en-GB" sz="1400" dirty="0"/>
              <a:t>CD59 105220</a:t>
            </a:r>
          </a:p>
          <a:p>
            <a:r>
              <a:rPr lang="en-GB" sz="1400" dirty="0" smtClean="0"/>
              <a:t>30. </a:t>
            </a:r>
            <a:r>
              <a:rPr lang="en-GB" sz="1400" dirty="0"/>
              <a:t>LAMP-1 C terminus</a:t>
            </a:r>
          </a:p>
          <a:p>
            <a:r>
              <a:rPr lang="en-GB" sz="1400" dirty="0" smtClean="0"/>
              <a:t>31. </a:t>
            </a:r>
            <a:r>
              <a:rPr lang="en-GB" sz="1400" dirty="0"/>
              <a:t>VAL-7</a:t>
            </a:r>
          </a:p>
          <a:p>
            <a:endParaRPr lang="en-GB" sz="1400" dirty="0"/>
          </a:p>
        </p:txBody>
      </p:sp>
      <p:sp>
        <p:nvSpPr>
          <p:cNvPr id="5" name="TextBox 53">
            <a:extLst>
              <a:ext uri="{FF2B5EF4-FFF2-40B4-BE49-F238E27FC236}">
                <a16:creationId xmlns:a16="http://schemas.microsoft.com/office/drawing/2014/main" xmlns="" id="{E17C1EF6-FDF6-4FAC-81B9-5FD2ED70413B}"/>
              </a:ext>
            </a:extLst>
          </p:cNvPr>
          <p:cNvSpPr txBox="1"/>
          <p:nvPr/>
        </p:nvSpPr>
        <p:spPr>
          <a:xfrm>
            <a:off x="583813" y="359574"/>
            <a:ext cx="81502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 smtClean="0"/>
              <a:t>Supplementary Figure 4. </a:t>
            </a:r>
            <a:r>
              <a:rPr lang="en-US" dirty="0" smtClean="0"/>
              <a:t>Reactive regions mapped onto </a:t>
            </a:r>
            <a:r>
              <a:rPr lang="en-US" dirty="0" smtClean="0"/>
              <a:t>26 </a:t>
            </a:r>
            <a:r>
              <a:rPr lang="en-US" dirty="0" smtClean="0"/>
              <a:t>selected crystal structures using CCP4mg</a:t>
            </a:r>
            <a:r>
              <a:rPr lang="en-GB" b="1" dirty="0" smtClean="0"/>
              <a:t> .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xmlns="" val="44204745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xmlns="" id="{F6297AD2-2116-4E3E-BF70-C2EFA5A3FD9D}"/>
              </a:ext>
            </a:extLst>
          </p:cNvPr>
          <p:cNvGrpSpPr/>
          <p:nvPr/>
        </p:nvGrpSpPr>
        <p:grpSpPr>
          <a:xfrm>
            <a:off x="1602575" y="673266"/>
            <a:ext cx="6255772" cy="5227215"/>
            <a:chOff x="1602575" y="673266"/>
            <a:chExt cx="6255772" cy="5227215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xmlns="" id="{3F2B4ED9-F471-4259-BA8D-8248EC7A89A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602575" y="673266"/>
              <a:ext cx="6255772" cy="5227215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E1F1D774-74BB-42CC-911B-D03BECBD77CD}"/>
                </a:ext>
              </a:extLst>
            </p:cNvPr>
            <p:cNvSpPr txBox="1"/>
            <p:nvPr/>
          </p:nvSpPr>
          <p:spPr>
            <a:xfrm>
              <a:off x="6629496" y="3429000"/>
              <a:ext cx="10096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8BE5286D-C4A3-4C9F-BF7F-DF4AA15A6CF8}"/>
                </a:ext>
              </a:extLst>
            </p:cNvPr>
            <p:cNvSpPr txBox="1"/>
            <p:nvPr/>
          </p:nvSpPr>
          <p:spPr>
            <a:xfrm>
              <a:off x="3111228" y="5558387"/>
              <a:ext cx="10096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9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F8B2E078-2976-475B-9EB9-421B6884CE0F}"/>
                </a:ext>
              </a:extLst>
            </p:cNvPr>
            <p:cNvSpPr txBox="1"/>
            <p:nvPr/>
          </p:nvSpPr>
          <p:spPr>
            <a:xfrm>
              <a:off x="3450233" y="2726748"/>
              <a:ext cx="10096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7C9D468A-B4FD-471A-93FF-2A674FD98EAF}"/>
                </a:ext>
              </a:extLst>
            </p:cNvPr>
            <p:cNvSpPr txBox="1"/>
            <p:nvPr/>
          </p:nvSpPr>
          <p:spPr>
            <a:xfrm>
              <a:off x="4359029" y="2131179"/>
              <a:ext cx="10096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4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14E0B2D6-41AB-4F9C-9B97-26D87104080B}"/>
                </a:ext>
              </a:extLst>
            </p:cNvPr>
            <p:cNvSpPr txBox="1"/>
            <p:nvPr/>
          </p:nvSpPr>
          <p:spPr>
            <a:xfrm>
              <a:off x="4863854" y="2864232"/>
              <a:ext cx="10096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9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20A8D8A9-3E55-4CF0-998E-E6C17F13D3BB}"/>
                </a:ext>
              </a:extLst>
            </p:cNvPr>
            <p:cNvSpPr txBox="1"/>
            <p:nvPr/>
          </p:nvSpPr>
          <p:spPr>
            <a:xfrm>
              <a:off x="4067175" y="3582888"/>
              <a:ext cx="10096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8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2C584F31-B481-43CA-8A0E-AAC2E5F35E4F}"/>
              </a:ext>
            </a:extLst>
          </p:cNvPr>
          <p:cNvSpPr txBox="1"/>
          <p:nvPr/>
        </p:nvSpPr>
        <p:spPr>
          <a:xfrm>
            <a:off x="897156" y="399451"/>
            <a:ext cx="3036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10. </a:t>
            </a:r>
            <a:r>
              <a:rPr lang="en-GB" b="1" dirty="0"/>
              <a:t>Apoferritin, </a:t>
            </a:r>
            <a:r>
              <a:rPr lang="en-GB" sz="1800" b="1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Smp_063530</a:t>
            </a:r>
            <a:endParaRPr lang="en-GB" b="1" dirty="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3A0276EE-35E1-4530-AE02-A8D0B2C438AB}"/>
              </a:ext>
            </a:extLst>
          </p:cNvPr>
          <p:cNvGrpSpPr/>
          <p:nvPr/>
        </p:nvGrpSpPr>
        <p:grpSpPr>
          <a:xfrm>
            <a:off x="594070" y="5746981"/>
            <a:ext cx="1822831" cy="646331"/>
            <a:chOff x="1056181" y="1961903"/>
            <a:chExt cx="1822831" cy="646331"/>
          </a:xfrm>
        </p:grpSpPr>
        <p:sp>
          <p:nvSpPr>
            <p:cNvPr id="5" name="Flowchart: Terminator 4">
              <a:extLst>
                <a:ext uri="{FF2B5EF4-FFF2-40B4-BE49-F238E27FC236}">
                  <a16:creationId xmlns:a16="http://schemas.microsoft.com/office/drawing/2014/main" xmlns="" id="{8FFBFAD0-37E9-4298-BEEB-19C5D6F4ECD8}"/>
                </a:ext>
              </a:extLst>
            </p:cNvPr>
            <p:cNvSpPr/>
            <p:nvPr/>
          </p:nvSpPr>
          <p:spPr>
            <a:xfrm>
              <a:off x="1059255" y="2073244"/>
              <a:ext cx="488888" cy="63374"/>
            </a:xfrm>
            <a:prstGeom prst="flowChartTerminator">
              <a:avLst/>
            </a:prstGeom>
            <a:solidFill>
              <a:srgbClr val="00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Flowchart: Terminator 5">
              <a:extLst>
                <a:ext uri="{FF2B5EF4-FFF2-40B4-BE49-F238E27FC236}">
                  <a16:creationId xmlns:a16="http://schemas.microsoft.com/office/drawing/2014/main" xmlns="" id="{7F868BE3-CFAE-490B-9B83-3F35856935E2}"/>
                </a:ext>
              </a:extLst>
            </p:cNvPr>
            <p:cNvSpPr/>
            <p:nvPr/>
          </p:nvSpPr>
          <p:spPr>
            <a:xfrm>
              <a:off x="1059255" y="2449798"/>
              <a:ext cx="488888" cy="63374"/>
            </a:xfrm>
            <a:prstGeom prst="flowChartTerminator">
              <a:avLst/>
            </a:prstGeom>
            <a:solidFill>
              <a:srgbClr val="0000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Flowchart: Terminator 6">
              <a:extLst>
                <a:ext uri="{FF2B5EF4-FFF2-40B4-BE49-F238E27FC236}">
                  <a16:creationId xmlns:a16="http://schemas.microsoft.com/office/drawing/2014/main" xmlns="" id="{13DF83C8-897A-45CD-93EA-88F8AF5370AC}"/>
                </a:ext>
              </a:extLst>
            </p:cNvPr>
            <p:cNvSpPr/>
            <p:nvPr/>
          </p:nvSpPr>
          <p:spPr>
            <a:xfrm>
              <a:off x="1056181" y="2261521"/>
              <a:ext cx="488888" cy="63374"/>
            </a:xfrm>
            <a:prstGeom prst="flowChartTerminator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D304BA1D-9C8D-44F8-B794-156C005CB465}"/>
                </a:ext>
              </a:extLst>
            </p:cNvPr>
            <p:cNvSpPr txBox="1"/>
            <p:nvPr/>
          </p:nvSpPr>
          <p:spPr>
            <a:xfrm>
              <a:off x="1593420" y="1961903"/>
              <a:ext cx="128559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Ferroxidase</a:t>
              </a:r>
            </a:p>
            <a:p>
              <a:r>
                <a:rPr lang="en-GB" sz="1200" dirty="0"/>
                <a:t>Entry channel</a:t>
              </a:r>
            </a:p>
            <a:p>
              <a:r>
                <a:rPr lang="en-GB" sz="1200" dirty="0"/>
                <a:t>Transit site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F5444A7-D37E-44B9-942A-09278EA7C0BA}"/>
              </a:ext>
            </a:extLst>
          </p:cNvPr>
          <p:cNvSpPr txBox="1"/>
          <p:nvPr/>
        </p:nvSpPr>
        <p:spPr>
          <a:xfrm>
            <a:off x="5560001" y="399451"/>
            <a:ext cx="33181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/>
              <a:t>Mapped on</a:t>
            </a:r>
            <a:r>
              <a:rPr lang="en-GB" dirty="0"/>
              <a:t>to PDB 6A4U</a:t>
            </a:r>
          </a:p>
        </p:txBody>
      </p:sp>
    </p:spTree>
    <p:extLst>
      <p:ext uri="{BB962C8B-B14F-4D97-AF65-F5344CB8AC3E}">
        <p14:creationId xmlns:p14="http://schemas.microsoft.com/office/powerpoint/2010/main" xmlns="" val="2147295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xmlns="" id="{7C538009-30E7-468C-BBDF-EA92E5BB1DCA}"/>
              </a:ext>
            </a:extLst>
          </p:cNvPr>
          <p:cNvGrpSpPr/>
          <p:nvPr/>
        </p:nvGrpSpPr>
        <p:grpSpPr>
          <a:xfrm>
            <a:off x="1350618" y="857033"/>
            <a:ext cx="6715614" cy="5712502"/>
            <a:chOff x="1216054" y="640457"/>
            <a:chExt cx="6715614" cy="5712502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F13C2CAB-8733-4995-B388-44784428A8B1}"/>
                </a:ext>
              </a:extLst>
            </p:cNvPr>
            <p:cNvSpPr txBox="1"/>
            <p:nvPr/>
          </p:nvSpPr>
          <p:spPr>
            <a:xfrm>
              <a:off x="7197742" y="2827833"/>
              <a:ext cx="7339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6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xmlns="" id="{AC809706-DFC3-48FF-98EF-58DB6874D58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216054" y="640457"/>
              <a:ext cx="6552935" cy="5712502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E8B8446A-02EF-47DF-AB18-C13E18BF401C}"/>
                </a:ext>
              </a:extLst>
            </p:cNvPr>
            <p:cNvSpPr txBox="1"/>
            <p:nvPr/>
          </p:nvSpPr>
          <p:spPr>
            <a:xfrm>
              <a:off x="6094251" y="4124489"/>
              <a:ext cx="7339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7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3E6DBBC5-CB14-44DE-87F2-8622D4A2EF4B}"/>
                </a:ext>
              </a:extLst>
            </p:cNvPr>
            <p:cNvSpPr txBox="1"/>
            <p:nvPr/>
          </p:nvSpPr>
          <p:spPr>
            <a:xfrm>
              <a:off x="4205037" y="1352404"/>
              <a:ext cx="7339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4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520FBEBF-1116-485F-88B5-373436429D22}"/>
                </a:ext>
              </a:extLst>
            </p:cNvPr>
            <p:cNvSpPr txBox="1"/>
            <p:nvPr/>
          </p:nvSpPr>
          <p:spPr>
            <a:xfrm>
              <a:off x="4351422" y="3070567"/>
              <a:ext cx="7339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6F05B7FE-3BEE-4B12-80EE-04BCF7D981B4}"/>
                </a:ext>
              </a:extLst>
            </p:cNvPr>
            <p:cNvSpPr txBox="1"/>
            <p:nvPr/>
          </p:nvSpPr>
          <p:spPr>
            <a:xfrm>
              <a:off x="7193988" y="2916678"/>
              <a:ext cx="7339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6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5A7C27DA-5ABA-4FEA-8116-461D20BC9730}"/>
              </a:ext>
            </a:extLst>
          </p:cNvPr>
          <p:cNvSpPr txBox="1"/>
          <p:nvPr/>
        </p:nvSpPr>
        <p:spPr>
          <a:xfrm>
            <a:off x="1150894" y="402218"/>
            <a:ext cx="2734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11. </a:t>
            </a:r>
            <a:r>
              <a:rPr lang="en-GB" b="1" dirty="0"/>
              <a:t>Ferritin 2, </a:t>
            </a:r>
            <a:r>
              <a:rPr lang="en-GB" b="1" dirty="0">
                <a:solidFill>
                  <a:srgbClr val="000000"/>
                </a:solidFill>
                <a:ea typeface="Calibri" panose="020F0502020204030204" pitchFamily="34" charset="0"/>
              </a:rPr>
              <a:t>Smp_311630 </a:t>
            </a:r>
            <a:endParaRPr lang="en-GB" b="1" dirty="0"/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BAB7C1D3-DFFC-47ED-AC1D-CFEEC4D8847A}"/>
              </a:ext>
            </a:extLst>
          </p:cNvPr>
          <p:cNvGrpSpPr/>
          <p:nvPr/>
        </p:nvGrpSpPr>
        <p:grpSpPr>
          <a:xfrm>
            <a:off x="375916" y="6023403"/>
            <a:ext cx="1774480" cy="526779"/>
            <a:chOff x="1056181" y="1920547"/>
            <a:chExt cx="1774480" cy="646331"/>
          </a:xfrm>
        </p:grpSpPr>
        <p:sp>
          <p:nvSpPr>
            <p:cNvPr id="17" name="Flowchart: Terminator 16">
              <a:extLst>
                <a:ext uri="{FF2B5EF4-FFF2-40B4-BE49-F238E27FC236}">
                  <a16:creationId xmlns:a16="http://schemas.microsoft.com/office/drawing/2014/main" xmlns="" id="{0B8C82E5-08C0-4818-B846-E2D0C02DC416}"/>
                </a:ext>
              </a:extLst>
            </p:cNvPr>
            <p:cNvSpPr/>
            <p:nvPr/>
          </p:nvSpPr>
          <p:spPr>
            <a:xfrm>
              <a:off x="1059255" y="2073244"/>
              <a:ext cx="488888" cy="63374"/>
            </a:xfrm>
            <a:prstGeom prst="flowChartTerminator">
              <a:avLst/>
            </a:prstGeom>
            <a:solidFill>
              <a:srgbClr val="00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Flowchart: Terminator 17">
              <a:extLst>
                <a:ext uri="{FF2B5EF4-FFF2-40B4-BE49-F238E27FC236}">
                  <a16:creationId xmlns:a16="http://schemas.microsoft.com/office/drawing/2014/main" xmlns="" id="{192FCE2F-ECDB-4A1D-AFFD-11835F0C9990}"/>
                </a:ext>
              </a:extLst>
            </p:cNvPr>
            <p:cNvSpPr/>
            <p:nvPr/>
          </p:nvSpPr>
          <p:spPr>
            <a:xfrm>
              <a:off x="1059255" y="2449798"/>
              <a:ext cx="488888" cy="63374"/>
            </a:xfrm>
            <a:prstGeom prst="flowChartTerminator">
              <a:avLst/>
            </a:prstGeom>
            <a:solidFill>
              <a:srgbClr val="0000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Flowchart: Terminator 18">
              <a:extLst>
                <a:ext uri="{FF2B5EF4-FFF2-40B4-BE49-F238E27FC236}">
                  <a16:creationId xmlns:a16="http://schemas.microsoft.com/office/drawing/2014/main" xmlns="" id="{7DC70F05-40CD-43DA-BE0C-971DBF672640}"/>
                </a:ext>
              </a:extLst>
            </p:cNvPr>
            <p:cNvSpPr/>
            <p:nvPr/>
          </p:nvSpPr>
          <p:spPr>
            <a:xfrm>
              <a:off x="1056181" y="2261521"/>
              <a:ext cx="488888" cy="63374"/>
            </a:xfrm>
            <a:prstGeom prst="flowChartTerminator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C92E36AD-1285-4412-B86F-236C734B18EE}"/>
                </a:ext>
              </a:extLst>
            </p:cNvPr>
            <p:cNvSpPr txBox="1"/>
            <p:nvPr/>
          </p:nvSpPr>
          <p:spPr>
            <a:xfrm>
              <a:off x="1545069" y="1920547"/>
              <a:ext cx="128559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Ferroxidase</a:t>
              </a:r>
            </a:p>
            <a:p>
              <a:r>
                <a:rPr lang="en-GB" sz="1200" dirty="0"/>
                <a:t>Entry channel</a:t>
              </a:r>
            </a:p>
            <a:p>
              <a:r>
                <a:rPr lang="en-GB" sz="1200" dirty="0"/>
                <a:t>Transit site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018AA1A6-1970-448E-B206-7E8B40213302}"/>
              </a:ext>
            </a:extLst>
          </p:cNvPr>
          <p:cNvSpPr txBox="1"/>
          <p:nvPr/>
        </p:nvSpPr>
        <p:spPr>
          <a:xfrm>
            <a:off x="5560001" y="402218"/>
            <a:ext cx="33181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/>
              <a:t>Mapped on</a:t>
            </a:r>
            <a:r>
              <a:rPr lang="en-GB" dirty="0"/>
              <a:t>to PDB 6KZY</a:t>
            </a:r>
          </a:p>
        </p:txBody>
      </p:sp>
    </p:spTree>
    <p:extLst>
      <p:ext uri="{BB962C8B-B14F-4D97-AF65-F5344CB8AC3E}">
        <p14:creationId xmlns:p14="http://schemas.microsoft.com/office/powerpoint/2010/main" xmlns="" val="222112329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26643CD2-10DF-436A-B31E-FE1B2A8BCB59}"/>
              </a:ext>
            </a:extLst>
          </p:cNvPr>
          <p:cNvSpPr txBox="1"/>
          <p:nvPr/>
        </p:nvSpPr>
        <p:spPr>
          <a:xfrm>
            <a:off x="457335" y="474122"/>
            <a:ext cx="383088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12. </a:t>
            </a:r>
            <a:r>
              <a:rPr lang="en-GB" b="1" dirty="0"/>
              <a:t>How </a:t>
            </a:r>
            <a:r>
              <a:rPr lang="en-GB" b="1" dirty="0" err="1"/>
              <a:t>Saposins</a:t>
            </a:r>
            <a:r>
              <a:rPr lang="en-GB" b="1" dirty="0"/>
              <a:t> function in pairs to bind lipids, to assist interpretation of the next six images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A0D7624E-296F-4421-8F75-34B026C2A946}"/>
              </a:ext>
            </a:extLst>
          </p:cNvPr>
          <p:cNvSpPr/>
          <p:nvPr/>
        </p:nvSpPr>
        <p:spPr>
          <a:xfrm>
            <a:off x="335151" y="2643915"/>
            <a:ext cx="353265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>
                <a:hlinkClick r:id="rId2"/>
              </a:rPr>
              <a:t>Structure of </a:t>
            </a:r>
            <a:r>
              <a:rPr lang="en-GB" sz="1400" dirty="0" err="1">
                <a:hlinkClick r:id="rId2"/>
              </a:rPr>
              <a:t>saposin</a:t>
            </a:r>
            <a:r>
              <a:rPr lang="en-GB" sz="1400" dirty="0">
                <a:hlinkClick r:id="rId2"/>
              </a:rPr>
              <a:t> A lipoprotein discs. </a:t>
            </a:r>
            <a:r>
              <a:rPr lang="en-GB" sz="1400" dirty="0"/>
              <a:t>Popovic K, et al. Proc Natl </a:t>
            </a:r>
            <a:r>
              <a:rPr lang="en-GB" sz="1400" dirty="0" err="1"/>
              <a:t>Acad</a:t>
            </a:r>
            <a:r>
              <a:rPr lang="en-GB" sz="1400" dirty="0"/>
              <a:t> Sci U S A. 2012. PMID: 22308394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33E416B8-012F-48F3-A09E-E00B855191A3}"/>
              </a:ext>
            </a:extLst>
          </p:cNvPr>
          <p:cNvGrpSpPr/>
          <p:nvPr/>
        </p:nvGrpSpPr>
        <p:grpSpPr>
          <a:xfrm>
            <a:off x="4134045" y="474122"/>
            <a:ext cx="4601358" cy="5758277"/>
            <a:chOff x="4134045" y="474122"/>
            <a:chExt cx="4601358" cy="5758277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991F1E0E-5CC4-4A6D-8C45-870B10A3DB3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134045" y="1007050"/>
              <a:ext cx="4069945" cy="2757595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xmlns="" id="{9177B748-DE22-4BA6-9450-7620A10879C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5094130" y="4222107"/>
              <a:ext cx="2408269" cy="2010292"/>
            </a:xfrm>
            <a:prstGeom prst="rect">
              <a:avLst/>
            </a:prstGeom>
          </p:spPr>
        </p:pic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xmlns="" id="{5CFC8D5F-877C-4E32-8193-8ABDEB83E63F}"/>
                </a:ext>
              </a:extLst>
            </p:cNvPr>
            <p:cNvSpPr/>
            <p:nvPr/>
          </p:nvSpPr>
          <p:spPr>
            <a:xfrm>
              <a:off x="4922681" y="4107020"/>
              <a:ext cx="685800" cy="6381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3A247830-886B-4B5C-A06D-B5A72F649E3D}"/>
                </a:ext>
              </a:extLst>
            </p:cNvPr>
            <p:cNvSpPr txBox="1"/>
            <p:nvPr/>
          </p:nvSpPr>
          <p:spPr>
            <a:xfrm>
              <a:off x="4533842" y="3827542"/>
              <a:ext cx="36425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The unfolded </a:t>
              </a:r>
              <a:r>
                <a:rPr lang="en-GB" sz="1400" dirty="0" err="1"/>
                <a:t>saposins</a:t>
              </a:r>
              <a:r>
                <a:rPr lang="en-GB" sz="1400" dirty="0"/>
                <a:t> combine in pairs to create the lipid transporting disc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DCCDF516-6D2D-41DB-BD6A-73E08E0442C4}"/>
                </a:ext>
              </a:extLst>
            </p:cNvPr>
            <p:cNvSpPr txBox="1"/>
            <p:nvPr/>
          </p:nvSpPr>
          <p:spPr>
            <a:xfrm>
              <a:off x="4523613" y="474122"/>
              <a:ext cx="3652759" cy="5801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The soluble secreted apoprotein unfolds at acid pH when it binds its cargo of lipids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96F9F2AA-E42B-46D4-B097-934C4922C884}"/>
                </a:ext>
              </a:extLst>
            </p:cNvPr>
            <p:cNvSpPr txBox="1"/>
            <p:nvPr/>
          </p:nvSpPr>
          <p:spPr>
            <a:xfrm>
              <a:off x="7856088" y="1977646"/>
              <a:ext cx="879315" cy="307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Hinge 2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xmlns="" id="{AC7EE491-B4F0-49ED-9D80-AD4C83BC8E8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83410" y="2131229"/>
              <a:ext cx="280751" cy="322952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C7C6A772-7196-4B25-B55C-59E22EAAEBBF}"/>
                </a:ext>
              </a:extLst>
            </p:cNvPr>
            <p:cNvSpPr txBox="1"/>
            <p:nvPr/>
          </p:nvSpPr>
          <p:spPr>
            <a:xfrm>
              <a:off x="5910336" y="1101677"/>
              <a:ext cx="879315" cy="307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Loop</a:t>
              </a: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xmlns="" id="{B00C57E1-AE7E-453E-A953-278222EF7D8F}"/>
                </a:ext>
              </a:extLst>
            </p:cNvPr>
            <p:cNvCxnSpPr>
              <a:cxnSpLocks/>
            </p:cNvCxnSpPr>
            <p:nvPr/>
          </p:nvCxnSpPr>
          <p:spPr>
            <a:xfrm>
              <a:off x="6419814" y="1256485"/>
              <a:ext cx="429479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xmlns="" id="{3F9246E2-57EE-4884-BCE6-AB55EEF25526}"/>
                </a:ext>
              </a:extLst>
            </p:cNvPr>
            <p:cNvCxnSpPr/>
            <p:nvPr/>
          </p:nvCxnSpPr>
          <p:spPr>
            <a:xfrm flipV="1">
              <a:off x="6669490" y="2318909"/>
              <a:ext cx="280017" cy="472119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62FBB433-E730-4355-BA6B-986640486D94}"/>
                </a:ext>
              </a:extLst>
            </p:cNvPr>
            <p:cNvSpPr txBox="1"/>
            <p:nvPr/>
          </p:nvSpPr>
          <p:spPr>
            <a:xfrm>
              <a:off x="6229832" y="2747977"/>
              <a:ext cx="879315" cy="307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Hinge 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32439677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86A4DD69-BB22-4D68-AD17-101AE41DBCBB}"/>
              </a:ext>
            </a:extLst>
          </p:cNvPr>
          <p:cNvSpPr txBox="1"/>
          <p:nvPr/>
        </p:nvSpPr>
        <p:spPr>
          <a:xfrm>
            <a:off x="385010" y="372979"/>
            <a:ext cx="3687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13. </a:t>
            </a:r>
            <a:r>
              <a:rPr lang="en-GB" b="1" dirty="0" err="1"/>
              <a:t>Saposin</a:t>
            </a:r>
            <a:r>
              <a:rPr lang="en-GB" b="1" dirty="0"/>
              <a:t> 1, Smp_194910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5F286A34-D832-49A2-B064-B20972E6C007}"/>
              </a:ext>
            </a:extLst>
          </p:cNvPr>
          <p:cNvGrpSpPr/>
          <p:nvPr/>
        </p:nvGrpSpPr>
        <p:grpSpPr>
          <a:xfrm>
            <a:off x="1826695" y="1019723"/>
            <a:ext cx="4491148" cy="4991106"/>
            <a:chOff x="1826695" y="1019723"/>
            <a:chExt cx="4491148" cy="499110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B85B0CB6-23FC-465C-9B82-317F572235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826695" y="1019723"/>
              <a:ext cx="4491148" cy="499110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D420079C-E6DB-4FB2-BD60-523CC0ED9905}"/>
                </a:ext>
              </a:extLst>
            </p:cNvPr>
            <p:cNvSpPr txBox="1"/>
            <p:nvPr/>
          </p:nvSpPr>
          <p:spPr>
            <a:xfrm>
              <a:off x="4072269" y="4635796"/>
              <a:ext cx="13822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5, hinge 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BAC4006B-1103-40D4-9101-B932DF324011}"/>
                </a:ext>
              </a:extLst>
            </p:cNvPr>
            <p:cNvSpPr txBox="1"/>
            <p:nvPr/>
          </p:nvSpPr>
          <p:spPr>
            <a:xfrm>
              <a:off x="3978681" y="1162494"/>
              <a:ext cx="13822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8, loop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3A2F4C8F-C4D9-4017-9A76-1932B64190A5}"/>
              </a:ext>
            </a:extLst>
          </p:cNvPr>
          <p:cNvGrpSpPr/>
          <p:nvPr/>
        </p:nvGrpSpPr>
        <p:grpSpPr>
          <a:xfrm>
            <a:off x="516578" y="5872329"/>
            <a:ext cx="1525932" cy="276999"/>
            <a:chOff x="507053" y="5425718"/>
            <a:chExt cx="1525932" cy="276999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xmlns="" id="{A572ECBA-A538-4447-92B9-B7FE38BC205C}"/>
                </a:ext>
              </a:extLst>
            </p:cNvPr>
            <p:cNvGrpSpPr/>
            <p:nvPr/>
          </p:nvGrpSpPr>
          <p:grpSpPr>
            <a:xfrm>
              <a:off x="507053" y="5536075"/>
              <a:ext cx="579906" cy="56286"/>
              <a:chOff x="507053" y="5536075"/>
              <a:chExt cx="579906" cy="56286"/>
            </a:xfrm>
          </p:grpSpPr>
          <p:sp>
            <p:nvSpPr>
              <p:cNvPr id="12" name="Flowchart: Terminator 11">
                <a:extLst>
                  <a:ext uri="{FF2B5EF4-FFF2-40B4-BE49-F238E27FC236}">
                    <a16:creationId xmlns:a16="http://schemas.microsoft.com/office/drawing/2014/main" xmlns="" id="{70096C14-E006-465E-A8A9-F866256124AD}"/>
                  </a:ext>
                </a:extLst>
              </p:cNvPr>
              <p:cNvSpPr/>
              <p:nvPr/>
            </p:nvSpPr>
            <p:spPr>
              <a:xfrm>
                <a:off x="507053" y="5536075"/>
                <a:ext cx="579906" cy="56286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xmlns="" id="{21D84A79-1CA4-4AAF-94E1-2BFD65199AB2}"/>
                  </a:ext>
                </a:extLst>
              </p:cNvPr>
              <p:cNvSpPr/>
              <p:nvPr/>
            </p:nvSpPr>
            <p:spPr>
              <a:xfrm>
                <a:off x="704850" y="5543352"/>
                <a:ext cx="177800" cy="45719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xmlns="" id="{06A7349D-9F66-4A22-B050-F0179610DDE5}"/>
                  </a:ext>
                </a:extLst>
              </p:cNvPr>
              <p:cNvCxnSpPr/>
              <p:nvPr/>
            </p:nvCxnSpPr>
            <p:spPr>
              <a:xfrm>
                <a:off x="624689" y="5592361"/>
                <a:ext cx="293383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7B3F9DE1-BCB1-48AA-8370-EA52E123C412}"/>
                </a:ext>
              </a:extLst>
            </p:cNvPr>
            <p:cNvSpPr txBox="1"/>
            <p:nvPr/>
          </p:nvSpPr>
          <p:spPr>
            <a:xfrm>
              <a:off x="1100999" y="5425718"/>
              <a:ext cx="93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 - C bridge 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B13E58E-0CE9-404F-8149-EBAA92947828}"/>
              </a:ext>
            </a:extLst>
          </p:cNvPr>
          <p:cNvSpPr txBox="1"/>
          <p:nvPr/>
        </p:nvSpPr>
        <p:spPr>
          <a:xfrm>
            <a:off x="4772025" y="372979"/>
            <a:ext cx="3733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2R0R</a:t>
            </a:r>
          </a:p>
        </p:txBody>
      </p:sp>
    </p:spTree>
    <p:extLst>
      <p:ext uri="{BB962C8B-B14F-4D97-AF65-F5344CB8AC3E}">
        <p14:creationId xmlns:p14="http://schemas.microsoft.com/office/powerpoint/2010/main" xmlns="" val="15009988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2A51FE5-63EA-434E-AAED-6A75E01C0ABE}"/>
              </a:ext>
            </a:extLst>
          </p:cNvPr>
          <p:cNvSpPr txBox="1"/>
          <p:nvPr/>
        </p:nvSpPr>
        <p:spPr>
          <a:xfrm>
            <a:off x="645781" y="396640"/>
            <a:ext cx="3702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14. </a:t>
            </a:r>
            <a:r>
              <a:rPr lang="en-GB" b="1" dirty="0" err="1"/>
              <a:t>Saposin</a:t>
            </a:r>
            <a:r>
              <a:rPr lang="en-GB" b="1" dirty="0"/>
              <a:t> 2, Smp_130100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FC42EB1D-B2B2-4791-9DAF-672BCA5B6BCA}"/>
              </a:ext>
            </a:extLst>
          </p:cNvPr>
          <p:cNvGrpSpPr/>
          <p:nvPr/>
        </p:nvGrpSpPr>
        <p:grpSpPr>
          <a:xfrm>
            <a:off x="2363233" y="1002267"/>
            <a:ext cx="4417533" cy="4972681"/>
            <a:chOff x="2259492" y="814021"/>
            <a:chExt cx="4789525" cy="553026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2FE5B66A-3BE7-46FE-848C-1FDB0B13E8B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259492" y="814021"/>
              <a:ext cx="4789525" cy="553026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032E439C-154A-4C7B-9CEF-B4F5B4CAF5A6}"/>
                </a:ext>
              </a:extLst>
            </p:cNvPr>
            <p:cNvSpPr txBox="1"/>
            <p:nvPr/>
          </p:nvSpPr>
          <p:spPr>
            <a:xfrm>
              <a:off x="2259492" y="5080744"/>
              <a:ext cx="8045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4,</a:t>
              </a:r>
            </a:p>
            <a:p>
              <a:r>
                <a:rPr lang="en-GB" sz="1400" b="1" dirty="0"/>
                <a:t>hinge 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F1C7B234-6C20-41B0-9C3D-016389D7435B}"/>
                </a:ext>
              </a:extLst>
            </p:cNvPr>
            <p:cNvSpPr txBox="1"/>
            <p:nvPr/>
          </p:nvSpPr>
          <p:spPr>
            <a:xfrm>
              <a:off x="3682410" y="1279451"/>
              <a:ext cx="8895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5, loop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0457586F-0D54-41ED-9655-1FA4820BAD3E}"/>
                </a:ext>
              </a:extLst>
            </p:cNvPr>
            <p:cNvSpPr txBox="1"/>
            <p:nvPr/>
          </p:nvSpPr>
          <p:spPr>
            <a:xfrm>
              <a:off x="5225903" y="5463648"/>
              <a:ext cx="804529" cy="581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8 hinge 2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377A7E8D-9205-4774-952E-C2E97878645D}"/>
              </a:ext>
            </a:extLst>
          </p:cNvPr>
          <p:cNvSpPr txBox="1"/>
          <p:nvPr/>
        </p:nvSpPr>
        <p:spPr>
          <a:xfrm>
            <a:off x="5225903" y="396640"/>
            <a:ext cx="31370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4UEX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0322DE0D-64D7-476E-9857-FD0D46222DF9}"/>
              </a:ext>
            </a:extLst>
          </p:cNvPr>
          <p:cNvGrpSpPr/>
          <p:nvPr/>
        </p:nvGrpSpPr>
        <p:grpSpPr>
          <a:xfrm>
            <a:off x="516578" y="5872329"/>
            <a:ext cx="1525932" cy="276999"/>
            <a:chOff x="507053" y="5425718"/>
            <a:chExt cx="1525932" cy="276999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xmlns="" id="{5AF8C2EE-152C-4EA1-868C-FB78C23585F7}"/>
                </a:ext>
              </a:extLst>
            </p:cNvPr>
            <p:cNvGrpSpPr/>
            <p:nvPr/>
          </p:nvGrpSpPr>
          <p:grpSpPr>
            <a:xfrm>
              <a:off x="507053" y="5536075"/>
              <a:ext cx="579906" cy="56286"/>
              <a:chOff x="507053" y="5536075"/>
              <a:chExt cx="579906" cy="56286"/>
            </a:xfrm>
          </p:grpSpPr>
          <p:sp>
            <p:nvSpPr>
              <p:cNvPr id="13" name="Flowchart: Terminator 12">
                <a:extLst>
                  <a:ext uri="{FF2B5EF4-FFF2-40B4-BE49-F238E27FC236}">
                    <a16:creationId xmlns:a16="http://schemas.microsoft.com/office/drawing/2014/main" xmlns="" id="{C6B04E5E-5B7A-41E3-B098-8E581DB201E8}"/>
                  </a:ext>
                </a:extLst>
              </p:cNvPr>
              <p:cNvSpPr/>
              <p:nvPr/>
            </p:nvSpPr>
            <p:spPr>
              <a:xfrm>
                <a:off x="507053" y="5536075"/>
                <a:ext cx="579906" cy="56286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xmlns="" id="{E84F1A7D-548E-4B43-8066-42AE700EB0E9}"/>
                  </a:ext>
                </a:extLst>
              </p:cNvPr>
              <p:cNvSpPr/>
              <p:nvPr/>
            </p:nvSpPr>
            <p:spPr>
              <a:xfrm>
                <a:off x="704850" y="5543352"/>
                <a:ext cx="177800" cy="45719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xmlns="" id="{AA836F35-E844-430B-862C-B2CD94904F41}"/>
                  </a:ext>
                </a:extLst>
              </p:cNvPr>
              <p:cNvCxnSpPr/>
              <p:nvPr/>
            </p:nvCxnSpPr>
            <p:spPr>
              <a:xfrm>
                <a:off x="624689" y="5592361"/>
                <a:ext cx="293383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B63E6867-5FDD-4971-93E0-870C57BB2EC1}"/>
                </a:ext>
              </a:extLst>
            </p:cNvPr>
            <p:cNvSpPr txBox="1"/>
            <p:nvPr/>
          </p:nvSpPr>
          <p:spPr>
            <a:xfrm>
              <a:off x="1100999" y="5425718"/>
              <a:ext cx="93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 - C bridge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3512541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AD72E919-6609-43E3-B863-252D1CAC8F3D}"/>
              </a:ext>
            </a:extLst>
          </p:cNvPr>
          <p:cNvSpPr txBox="1"/>
          <p:nvPr/>
        </p:nvSpPr>
        <p:spPr>
          <a:xfrm>
            <a:off x="666750" y="391531"/>
            <a:ext cx="2982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15. </a:t>
            </a:r>
            <a:r>
              <a:rPr lang="en-GB" b="1" dirty="0" err="1"/>
              <a:t>Saposin</a:t>
            </a:r>
            <a:r>
              <a:rPr lang="en-GB" b="1" dirty="0"/>
              <a:t> 3, Smp_105420 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EE6F3BA3-A6F0-4B01-8B7B-FD0977F79E15}"/>
              </a:ext>
            </a:extLst>
          </p:cNvPr>
          <p:cNvGrpSpPr/>
          <p:nvPr/>
        </p:nvGrpSpPr>
        <p:grpSpPr>
          <a:xfrm>
            <a:off x="2314575" y="808229"/>
            <a:ext cx="4408634" cy="4976798"/>
            <a:chOff x="2314575" y="808229"/>
            <a:chExt cx="4408634" cy="4976798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DAAB3143-B3FA-4668-90FE-E22678AC89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314575" y="808229"/>
              <a:ext cx="4309619" cy="4976798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020C472C-8007-4F72-AE4B-AA4576C6CC74}"/>
                </a:ext>
              </a:extLst>
            </p:cNvPr>
            <p:cNvSpPr txBox="1"/>
            <p:nvPr/>
          </p:nvSpPr>
          <p:spPr>
            <a:xfrm>
              <a:off x="4968837" y="4844901"/>
              <a:ext cx="17543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6, hinge 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661F4ADA-372E-4F07-91F0-E2C625FB733D}"/>
                </a:ext>
              </a:extLst>
            </p:cNvPr>
            <p:cNvSpPr txBox="1"/>
            <p:nvPr/>
          </p:nvSpPr>
          <p:spPr>
            <a:xfrm>
              <a:off x="3577410" y="1072973"/>
              <a:ext cx="17543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3, loop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A31CE12B-AA23-4C46-A584-3E66961609EE}"/>
                </a:ext>
              </a:extLst>
            </p:cNvPr>
            <p:cNvSpPr txBox="1"/>
            <p:nvPr/>
          </p:nvSpPr>
          <p:spPr>
            <a:xfrm>
              <a:off x="2604974" y="5285261"/>
              <a:ext cx="17543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, hinge 1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DFE3FC11-B9F7-4A07-87F8-81977177FD83}"/>
              </a:ext>
            </a:extLst>
          </p:cNvPr>
          <p:cNvSpPr txBox="1"/>
          <p:nvPr/>
        </p:nvSpPr>
        <p:spPr>
          <a:xfrm>
            <a:off x="5143500" y="391531"/>
            <a:ext cx="3190875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2R0R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62FA89A0-EF82-4177-8FF5-C81DE834C56A}"/>
              </a:ext>
            </a:extLst>
          </p:cNvPr>
          <p:cNvGrpSpPr/>
          <p:nvPr/>
        </p:nvGrpSpPr>
        <p:grpSpPr>
          <a:xfrm>
            <a:off x="516578" y="5872329"/>
            <a:ext cx="1525932" cy="276999"/>
            <a:chOff x="507053" y="5425718"/>
            <a:chExt cx="1525932" cy="276999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xmlns="" id="{A5E84FEE-EE6C-4E0D-8008-6EE3FF3E64CF}"/>
                </a:ext>
              </a:extLst>
            </p:cNvPr>
            <p:cNvGrpSpPr/>
            <p:nvPr/>
          </p:nvGrpSpPr>
          <p:grpSpPr>
            <a:xfrm>
              <a:off x="507053" y="5536075"/>
              <a:ext cx="579906" cy="56286"/>
              <a:chOff x="507053" y="5536075"/>
              <a:chExt cx="579906" cy="56286"/>
            </a:xfrm>
          </p:grpSpPr>
          <p:sp>
            <p:nvSpPr>
              <p:cNvPr id="13" name="Flowchart: Terminator 12">
                <a:extLst>
                  <a:ext uri="{FF2B5EF4-FFF2-40B4-BE49-F238E27FC236}">
                    <a16:creationId xmlns:a16="http://schemas.microsoft.com/office/drawing/2014/main" xmlns="" id="{BA3D03D0-8CB1-4760-81AB-BCDECFE7AE15}"/>
                  </a:ext>
                </a:extLst>
              </p:cNvPr>
              <p:cNvSpPr/>
              <p:nvPr/>
            </p:nvSpPr>
            <p:spPr>
              <a:xfrm>
                <a:off x="507053" y="5536075"/>
                <a:ext cx="579906" cy="56286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xmlns="" id="{98E30943-A488-4690-9034-850DE588405E}"/>
                  </a:ext>
                </a:extLst>
              </p:cNvPr>
              <p:cNvSpPr/>
              <p:nvPr/>
            </p:nvSpPr>
            <p:spPr>
              <a:xfrm>
                <a:off x="704850" y="5543352"/>
                <a:ext cx="177800" cy="45719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xmlns="" id="{79A04C6B-ECBE-4EA9-B3BE-C7B3D0FD2ECA}"/>
                  </a:ext>
                </a:extLst>
              </p:cNvPr>
              <p:cNvCxnSpPr/>
              <p:nvPr/>
            </p:nvCxnSpPr>
            <p:spPr>
              <a:xfrm>
                <a:off x="624689" y="5592361"/>
                <a:ext cx="293383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965CCF46-B34F-409B-8772-137E29D16E8C}"/>
                </a:ext>
              </a:extLst>
            </p:cNvPr>
            <p:cNvSpPr txBox="1"/>
            <p:nvPr/>
          </p:nvSpPr>
          <p:spPr>
            <a:xfrm>
              <a:off x="1100999" y="5425718"/>
              <a:ext cx="93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 - C bridge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12354729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D50D81C0-F9C6-4C5A-A4AE-D53F172B59FB}"/>
              </a:ext>
            </a:extLst>
          </p:cNvPr>
          <p:cNvSpPr/>
          <p:nvPr/>
        </p:nvSpPr>
        <p:spPr>
          <a:xfrm>
            <a:off x="744279" y="395369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b="1" dirty="0" smtClean="0"/>
              <a:t>16. </a:t>
            </a:r>
            <a:r>
              <a:rPr lang="en-GB" b="1" dirty="0" err="1"/>
              <a:t>Saposin</a:t>
            </a:r>
            <a:r>
              <a:rPr lang="en-GB" b="1" dirty="0"/>
              <a:t> 4, Smp_105450 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40472DCA-D02D-4D9C-A03B-8B5D22A01A4D}"/>
              </a:ext>
            </a:extLst>
          </p:cNvPr>
          <p:cNvSpPr txBox="1"/>
          <p:nvPr/>
        </p:nvSpPr>
        <p:spPr>
          <a:xfrm>
            <a:off x="5581650" y="395369"/>
            <a:ext cx="2924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2R0R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6417EED7-2DFC-4425-B8A7-98DDECE67FB6}"/>
              </a:ext>
            </a:extLst>
          </p:cNvPr>
          <p:cNvGrpSpPr/>
          <p:nvPr/>
        </p:nvGrpSpPr>
        <p:grpSpPr>
          <a:xfrm>
            <a:off x="516578" y="5872329"/>
            <a:ext cx="1525932" cy="276999"/>
            <a:chOff x="507053" y="5425718"/>
            <a:chExt cx="1525932" cy="276999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xmlns="" id="{0B04CB86-4A3F-4FE3-A469-89780F75AF08}"/>
                </a:ext>
              </a:extLst>
            </p:cNvPr>
            <p:cNvGrpSpPr/>
            <p:nvPr/>
          </p:nvGrpSpPr>
          <p:grpSpPr>
            <a:xfrm>
              <a:off x="507053" y="5536075"/>
              <a:ext cx="579906" cy="56286"/>
              <a:chOff x="507053" y="5536075"/>
              <a:chExt cx="579906" cy="56286"/>
            </a:xfrm>
          </p:grpSpPr>
          <p:sp>
            <p:nvSpPr>
              <p:cNvPr id="11" name="Flowchart: Terminator 10">
                <a:extLst>
                  <a:ext uri="{FF2B5EF4-FFF2-40B4-BE49-F238E27FC236}">
                    <a16:creationId xmlns:a16="http://schemas.microsoft.com/office/drawing/2014/main" xmlns="" id="{2ACC049C-C473-4E80-9045-2C700D891648}"/>
                  </a:ext>
                </a:extLst>
              </p:cNvPr>
              <p:cNvSpPr/>
              <p:nvPr/>
            </p:nvSpPr>
            <p:spPr>
              <a:xfrm>
                <a:off x="507053" y="5536075"/>
                <a:ext cx="579906" cy="56286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xmlns="" id="{6B468D9F-4751-48D8-AFB9-B28843C4EA24}"/>
                  </a:ext>
                </a:extLst>
              </p:cNvPr>
              <p:cNvSpPr/>
              <p:nvPr/>
            </p:nvSpPr>
            <p:spPr>
              <a:xfrm>
                <a:off x="704850" y="5543352"/>
                <a:ext cx="177800" cy="45719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xmlns="" id="{FDA28E96-20F4-4A39-9054-DFC180357B60}"/>
                  </a:ext>
                </a:extLst>
              </p:cNvPr>
              <p:cNvCxnSpPr/>
              <p:nvPr/>
            </p:nvCxnSpPr>
            <p:spPr>
              <a:xfrm>
                <a:off x="624689" y="5592361"/>
                <a:ext cx="293383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74B79313-F1EC-4A72-BC29-7B117FA42801}"/>
                </a:ext>
              </a:extLst>
            </p:cNvPr>
            <p:cNvSpPr txBox="1"/>
            <p:nvPr/>
          </p:nvSpPr>
          <p:spPr>
            <a:xfrm>
              <a:off x="1100999" y="5425718"/>
              <a:ext cx="93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 - C bridge 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xmlns="" id="{761800F8-E36C-42AF-8ECD-29093F3D1B18}"/>
              </a:ext>
            </a:extLst>
          </p:cNvPr>
          <p:cNvGrpSpPr/>
          <p:nvPr/>
        </p:nvGrpSpPr>
        <p:grpSpPr>
          <a:xfrm>
            <a:off x="2593459" y="1021622"/>
            <a:ext cx="3744099" cy="4968644"/>
            <a:chOff x="2593459" y="1021622"/>
            <a:chExt cx="3744099" cy="4968644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xmlns="" id="{18C848E8-F7A1-4A61-A91D-B9739696E8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806442" y="1243509"/>
              <a:ext cx="3531116" cy="4370982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549EE5E6-8C52-42B0-A30E-C177441D6C67}"/>
                </a:ext>
              </a:extLst>
            </p:cNvPr>
            <p:cNvSpPr txBox="1"/>
            <p:nvPr/>
          </p:nvSpPr>
          <p:spPr>
            <a:xfrm>
              <a:off x="3907909" y="5682489"/>
              <a:ext cx="17357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2, hinge 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AD301101-7278-46C6-AEA6-FD5753441E3B}"/>
                </a:ext>
              </a:extLst>
            </p:cNvPr>
            <p:cNvSpPr txBox="1"/>
            <p:nvPr/>
          </p:nvSpPr>
          <p:spPr>
            <a:xfrm>
              <a:off x="2593459" y="4973654"/>
              <a:ext cx="17357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3, hinge 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2D35AB68-9362-4CA2-87A8-BE4ADC7989A7}"/>
                </a:ext>
              </a:extLst>
            </p:cNvPr>
            <p:cNvSpPr txBox="1"/>
            <p:nvPr/>
          </p:nvSpPr>
          <p:spPr>
            <a:xfrm>
              <a:off x="3845886" y="1021622"/>
              <a:ext cx="17357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5, loo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20116461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B6D8EAE8-9BA2-481F-B930-383E0E02A9CE}"/>
              </a:ext>
            </a:extLst>
          </p:cNvPr>
          <p:cNvSpPr txBox="1"/>
          <p:nvPr/>
        </p:nvSpPr>
        <p:spPr>
          <a:xfrm>
            <a:off x="849160" y="410613"/>
            <a:ext cx="418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17. </a:t>
            </a:r>
            <a:r>
              <a:rPr lang="en-GB" b="1" dirty="0" err="1"/>
              <a:t>Saposin</a:t>
            </a:r>
            <a:r>
              <a:rPr lang="en-GB" b="1" dirty="0"/>
              <a:t> 5, Smp_016490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184737BC-755D-4693-B869-56AFA821048F}"/>
              </a:ext>
            </a:extLst>
          </p:cNvPr>
          <p:cNvGrpSpPr/>
          <p:nvPr/>
        </p:nvGrpSpPr>
        <p:grpSpPr>
          <a:xfrm>
            <a:off x="2099046" y="1156801"/>
            <a:ext cx="4783983" cy="5290586"/>
            <a:chOff x="2099046" y="1156801"/>
            <a:chExt cx="4783983" cy="5290586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F63E8B8D-991E-47A9-8D79-89A53B9DD98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099046" y="1156801"/>
              <a:ext cx="4277036" cy="529058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F4C39A42-F094-4468-A5D2-1CC02802F815}"/>
                </a:ext>
              </a:extLst>
            </p:cNvPr>
            <p:cNvSpPr txBox="1"/>
            <p:nvPr/>
          </p:nvSpPr>
          <p:spPr>
            <a:xfrm>
              <a:off x="2939180" y="5276832"/>
              <a:ext cx="14779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3, hinge 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11EDE9B1-3855-4256-992B-CDDEB3B51A20}"/>
                </a:ext>
              </a:extLst>
            </p:cNvPr>
            <p:cNvSpPr txBox="1"/>
            <p:nvPr/>
          </p:nvSpPr>
          <p:spPr>
            <a:xfrm>
              <a:off x="4237564" y="1307930"/>
              <a:ext cx="14779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5, loop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6FF66B2F-0830-403D-AF12-6DB2D6B1D2F4}"/>
                </a:ext>
              </a:extLst>
            </p:cNvPr>
            <p:cNvSpPr txBox="1"/>
            <p:nvPr/>
          </p:nvSpPr>
          <p:spPr>
            <a:xfrm>
              <a:off x="5190680" y="4934516"/>
              <a:ext cx="16923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8, hinge 2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ADC6F8AF-6B65-484C-80BE-A2D84C3ABF46}"/>
              </a:ext>
            </a:extLst>
          </p:cNvPr>
          <p:cNvSpPr txBox="1"/>
          <p:nvPr/>
        </p:nvSpPr>
        <p:spPr>
          <a:xfrm>
            <a:off x="5467350" y="410613"/>
            <a:ext cx="3219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2R0R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63E739B8-0B25-4299-A8B5-3D43586BA3CE}"/>
              </a:ext>
            </a:extLst>
          </p:cNvPr>
          <p:cNvGrpSpPr/>
          <p:nvPr/>
        </p:nvGrpSpPr>
        <p:grpSpPr>
          <a:xfrm>
            <a:off x="516578" y="5872329"/>
            <a:ext cx="1525932" cy="276999"/>
            <a:chOff x="507053" y="5425718"/>
            <a:chExt cx="1525932" cy="276999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xmlns="" id="{B38B2EC5-9BBC-4EF2-AC1F-36F1BE3DFA49}"/>
                </a:ext>
              </a:extLst>
            </p:cNvPr>
            <p:cNvGrpSpPr/>
            <p:nvPr/>
          </p:nvGrpSpPr>
          <p:grpSpPr>
            <a:xfrm>
              <a:off x="507053" y="5536075"/>
              <a:ext cx="579906" cy="56286"/>
              <a:chOff x="507053" y="5536075"/>
              <a:chExt cx="579906" cy="56286"/>
            </a:xfrm>
          </p:grpSpPr>
          <p:sp>
            <p:nvSpPr>
              <p:cNvPr id="13" name="Flowchart: Terminator 12">
                <a:extLst>
                  <a:ext uri="{FF2B5EF4-FFF2-40B4-BE49-F238E27FC236}">
                    <a16:creationId xmlns:a16="http://schemas.microsoft.com/office/drawing/2014/main" xmlns="" id="{75F6EFA8-2BAF-4A2C-A258-3DB9CAB949C1}"/>
                  </a:ext>
                </a:extLst>
              </p:cNvPr>
              <p:cNvSpPr/>
              <p:nvPr/>
            </p:nvSpPr>
            <p:spPr>
              <a:xfrm>
                <a:off x="507053" y="5536075"/>
                <a:ext cx="579906" cy="56286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xmlns="" id="{F418A1D3-8C0E-4388-B5DC-35465840086E}"/>
                  </a:ext>
                </a:extLst>
              </p:cNvPr>
              <p:cNvSpPr/>
              <p:nvPr/>
            </p:nvSpPr>
            <p:spPr>
              <a:xfrm>
                <a:off x="704850" y="5543352"/>
                <a:ext cx="177800" cy="45719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xmlns="" id="{4A9D7A4C-43C9-44E4-B39F-F0D1274A92E6}"/>
                  </a:ext>
                </a:extLst>
              </p:cNvPr>
              <p:cNvCxnSpPr/>
              <p:nvPr/>
            </p:nvCxnSpPr>
            <p:spPr>
              <a:xfrm>
                <a:off x="624689" y="5592361"/>
                <a:ext cx="293383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2FE94D0A-DA47-486C-BFD5-4B0D8D823BEF}"/>
                </a:ext>
              </a:extLst>
            </p:cNvPr>
            <p:cNvSpPr txBox="1"/>
            <p:nvPr/>
          </p:nvSpPr>
          <p:spPr>
            <a:xfrm>
              <a:off x="1100999" y="5425718"/>
              <a:ext cx="93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 - C bridge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379977268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68E2046-48D4-4498-9C03-0217AA257F1D}"/>
              </a:ext>
            </a:extLst>
          </p:cNvPr>
          <p:cNvSpPr txBox="1"/>
          <p:nvPr/>
        </p:nvSpPr>
        <p:spPr>
          <a:xfrm>
            <a:off x="788088" y="396345"/>
            <a:ext cx="396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18. </a:t>
            </a:r>
            <a:r>
              <a:rPr lang="en-GB" b="1" dirty="0" err="1" smtClean="0"/>
              <a:t>Saposin</a:t>
            </a:r>
            <a:r>
              <a:rPr lang="en-GB" b="1" dirty="0" smtClean="0"/>
              <a:t> </a:t>
            </a:r>
            <a:r>
              <a:rPr lang="en-GB" b="1" dirty="0"/>
              <a:t>6 A domain, Smp_014570  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5D8164E5-130E-490D-A9A2-B23377796681}"/>
              </a:ext>
            </a:extLst>
          </p:cNvPr>
          <p:cNvGrpSpPr/>
          <p:nvPr/>
        </p:nvGrpSpPr>
        <p:grpSpPr>
          <a:xfrm>
            <a:off x="1852373" y="889078"/>
            <a:ext cx="5099012" cy="5769935"/>
            <a:chOff x="1501499" y="336185"/>
            <a:chExt cx="5099012" cy="576993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D43863C3-194E-4486-9F20-52B3E2C026C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501499" y="336185"/>
              <a:ext cx="5099012" cy="576993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5B94F6F8-A1C4-4E64-ACCD-F895D92601AA}"/>
                </a:ext>
              </a:extLst>
            </p:cNvPr>
            <p:cNvSpPr txBox="1"/>
            <p:nvPr/>
          </p:nvSpPr>
          <p:spPr>
            <a:xfrm>
              <a:off x="1605515" y="4916154"/>
              <a:ext cx="12546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4, hinge 1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EA4694E9-458B-4FF5-B27A-F886D7A86A16}"/>
              </a:ext>
            </a:extLst>
          </p:cNvPr>
          <p:cNvSpPr txBox="1"/>
          <p:nvPr/>
        </p:nvSpPr>
        <p:spPr>
          <a:xfrm>
            <a:off x="4752753" y="396345"/>
            <a:ext cx="3267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2GTG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94B949DC-874E-44A1-9B8B-B79FF451A7DF}"/>
              </a:ext>
            </a:extLst>
          </p:cNvPr>
          <p:cNvGrpSpPr/>
          <p:nvPr/>
        </p:nvGrpSpPr>
        <p:grpSpPr>
          <a:xfrm>
            <a:off x="516578" y="5872329"/>
            <a:ext cx="1525932" cy="276999"/>
            <a:chOff x="507053" y="5425718"/>
            <a:chExt cx="1525932" cy="276999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xmlns="" id="{89F189C8-4C52-4417-A0CA-A4B37D23953D}"/>
                </a:ext>
              </a:extLst>
            </p:cNvPr>
            <p:cNvGrpSpPr/>
            <p:nvPr/>
          </p:nvGrpSpPr>
          <p:grpSpPr>
            <a:xfrm>
              <a:off x="507053" y="5536075"/>
              <a:ext cx="579906" cy="56286"/>
              <a:chOff x="507053" y="5536075"/>
              <a:chExt cx="579906" cy="56286"/>
            </a:xfrm>
          </p:grpSpPr>
          <p:sp>
            <p:nvSpPr>
              <p:cNvPr id="12" name="Flowchart: Terminator 11">
                <a:extLst>
                  <a:ext uri="{FF2B5EF4-FFF2-40B4-BE49-F238E27FC236}">
                    <a16:creationId xmlns:a16="http://schemas.microsoft.com/office/drawing/2014/main" xmlns="" id="{0C4FB5FC-AFC0-4B3B-843C-BEA7802A5493}"/>
                  </a:ext>
                </a:extLst>
              </p:cNvPr>
              <p:cNvSpPr/>
              <p:nvPr/>
            </p:nvSpPr>
            <p:spPr>
              <a:xfrm>
                <a:off x="507053" y="5536075"/>
                <a:ext cx="579906" cy="56286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xmlns="" id="{01204344-8827-4F43-A3B5-8357DFF0AC30}"/>
                  </a:ext>
                </a:extLst>
              </p:cNvPr>
              <p:cNvSpPr/>
              <p:nvPr/>
            </p:nvSpPr>
            <p:spPr>
              <a:xfrm>
                <a:off x="704850" y="5543352"/>
                <a:ext cx="177800" cy="45719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xmlns="" id="{773BA1E3-A45E-40A7-B3E8-621A27C91A35}"/>
                  </a:ext>
                </a:extLst>
              </p:cNvPr>
              <p:cNvCxnSpPr/>
              <p:nvPr/>
            </p:nvCxnSpPr>
            <p:spPr>
              <a:xfrm>
                <a:off x="624689" y="5592361"/>
                <a:ext cx="293383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00CE8DC8-396F-4D01-B15A-E555BA34C66A}"/>
                </a:ext>
              </a:extLst>
            </p:cNvPr>
            <p:cNvSpPr txBox="1"/>
            <p:nvPr/>
          </p:nvSpPr>
          <p:spPr>
            <a:xfrm>
              <a:off x="1100999" y="5425718"/>
              <a:ext cx="93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 - C bridge 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53F19BA7-9FAB-4A69-A35C-D704DFF9E2E4}"/>
              </a:ext>
            </a:extLst>
          </p:cNvPr>
          <p:cNvSpPr txBox="1"/>
          <p:nvPr/>
        </p:nvSpPr>
        <p:spPr>
          <a:xfrm>
            <a:off x="4328114" y="5227945"/>
            <a:ext cx="12546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P3, helix 1</a:t>
            </a:r>
          </a:p>
        </p:txBody>
      </p:sp>
    </p:spTree>
    <p:extLst>
      <p:ext uri="{BB962C8B-B14F-4D97-AF65-F5344CB8AC3E}">
        <p14:creationId xmlns:p14="http://schemas.microsoft.com/office/powerpoint/2010/main" xmlns="" val="361171816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1F12974-5DE3-4A7E-A5DA-2CB17CC1E266}"/>
              </a:ext>
            </a:extLst>
          </p:cNvPr>
          <p:cNvSpPr txBox="1"/>
          <p:nvPr/>
        </p:nvSpPr>
        <p:spPr>
          <a:xfrm>
            <a:off x="968721" y="398824"/>
            <a:ext cx="2806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19. </a:t>
            </a:r>
            <a:r>
              <a:rPr lang="en-GB" b="1" dirty="0"/>
              <a:t>NPC2 </a:t>
            </a:r>
            <a:r>
              <a:rPr lang="en-GB" b="1" dirty="0" smtClean="0"/>
              <a:t>,</a:t>
            </a:r>
            <a:r>
              <a:rPr lang="en-GB" b="1" dirty="0" smtClean="0">
                <a:ea typeface="Calibri" panose="020F0502020204030204" pitchFamily="34" charset="0"/>
              </a:rPr>
              <a:t>Smp_194840 </a:t>
            </a:r>
            <a:endParaRPr lang="en-GB" b="1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29B0C874-1D87-4E70-8A38-9C46AE3753DB}"/>
              </a:ext>
            </a:extLst>
          </p:cNvPr>
          <p:cNvGrpSpPr/>
          <p:nvPr/>
        </p:nvGrpSpPr>
        <p:grpSpPr>
          <a:xfrm>
            <a:off x="2091295" y="1127977"/>
            <a:ext cx="4680699" cy="5327891"/>
            <a:chOff x="2091295" y="1127977"/>
            <a:chExt cx="4680699" cy="532789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F584FF6B-3066-4300-AFEC-677E651CB87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 rot="21349447">
              <a:off x="2091295" y="1127977"/>
              <a:ext cx="4680699" cy="5327891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786E9EDE-A0E9-44AE-BABE-5385313BC147}"/>
                </a:ext>
              </a:extLst>
            </p:cNvPr>
            <p:cNvSpPr txBox="1"/>
            <p:nvPr/>
          </p:nvSpPr>
          <p:spPr>
            <a:xfrm>
              <a:off x="3316164" y="5601990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FDCA075C-4D68-4CC5-A6FC-51BB89CD3EB2}"/>
                </a:ext>
              </a:extLst>
            </p:cNvPr>
            <p:cNvSpPr txBox="1"/>
            <p:nvPr/>
          </p:nvSpPr>
          <p:spPr>
            <a:xfrm>
              <a:off x="3165695" y="3121223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2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84CB9F78-A5D8-4ACC-9AA3-502CC400F887}"/>
                </a:ext>
              </a:extLst>
            </p:cNvPr>
            <p:cNvSpPr txBox="1"/>
            <p:nvPr/>
          </p:nvSpPr>
          <p:spPr>
            <a:xfrm>
              <a:off x="3133796" y="4952521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4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EC422092-A1F2-4586-929C-6EDF35EFC7F5}"/>
                </a:ext>
              </a:extLst>
            </p:cNvPr>
            <p:cNvSpPr txBox="1"/>
            <p:nvPr/>
          </p:nvSpPr>
          <p:spPr>
            <a:xfrm>
              <a:off x="4833762" y="3704726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3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BFCF4423-465D-4C78-9CB7-A517DF498D67}"/>
                </a:ext>
              </a:extLst>
            </p:cNvPr>
            <p:cNvSpPr txBox="1"/>
            <p:nvPr/>
          </p:nvSpPr>
          <p:spPr>
            <a:xfrm>
              <a:off x="3239036" y="1547434"/>
              <a:ext cx="14991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Cholesterol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B9168AB6-260E-439C-A839-7E0EED2BB7CE}"/>
              </a:ext>
            </a:extLst>
          </p:cNvPr>
          <p:cNvGrpSpPr/>
          <p:nvPr/>
        </p:nvGrpSpPr>
        <p:grpSpPr>
          <a:xfrm>
            <a:off x="552996" y="5750633"/>
            <a:ext cx="2101194" cy="461665"/>
            <a:chOff x="753756" y="5923242"/>
            <a:chExt cx="1771406" cy="423657"/>
          </a:xfrm>
        </p:grpSpPr>
        <p:sp>
          <p:nvSpPr>
            <p:cNvPr id="14" name="Flowchart: Terminator 13">
              <a:extLst>
                <a:ext uri="{FF2B5EF4-FFF2-40B4-BE49-F238E27FC236}">
                  <a16:creationId xmlns:a16="http://schemas.microsoft.com/office/drawing/2014/main" xmlns="" id="{385F5CF2-5D66-4E7B-A0BD-B9D10BF3A4CB}"/>
                </a:ext>
              </a:extLst>
            </p:cNvPr>
            <p:cNvSpPr/>
            <p:nvPr/>
          </p:nvSpPr>
          <p:spPr>
            <a:xfrm>
              <a:off x="753756" y="6049025"/>
              <a:ext cx="488888" cy="51652"/>
            </a:xfrm>
            <a:prstGeom prst="flowChartTerminator">
              <a:avLst/>
            </a:prstGeom>
            <a:solidFill>
              <a:srgbClr val="00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Flowchart: Terminator 15">
              <a:extLst>
                <a:ext uri="{FF2B5EF4-FFF2-40B4-BE49-F238E27FC236}">
                  <a16:creationId xmlns:a16="http://schemas.microsoft.com/office/drawing/2014/main" xmlns="" id="{2ABDB69F-EC8E-47DB-90EB-F1CF72DFAF1B}"/>
                </a:ext>
              </a:extLst>
            </p:cNvPr>
            <p:cNvSpPr/>
            <p:nvPr/>
          </p:nvSpPr>
          <p:spPr>
            <a:xfrm>
              <a:off x="753756" y="6220564"/>
              <a:ext cx="488888" cy="51652"/>
            </a:xfrm>
            <a:prstGeom prst="flowChartTerminator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57302BC3-61DC-434A-BA5D-4EB869ED125D}"/>
                </a:ext>
              </a:extLst>
            </p:cNvPr>
            <p:cNvSpPr txBox="1"/>
            <p:nvPr/>
          </p:nvSpPr>
          <p:spPr>
            <a:xfrm>
              <a:off x="1239570" y="5923242"/>
              <a:ext cx="1285592" cy="4236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Polar rim</a:t>
              </a:r>
            </a:p>
            <a:p>
              <a:r>
                <a:rPr lang="en-GB" sz="1200" dirty="0"/>
                <a:t>Cholesterol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309CAB24-BA7F-433C-B798-2BA0A5A7801C}"/>
              </a:ext>
            </a:extLst>
          </p:cNvPr>
          <p:cNvSpPr txBox="1"/>
          <p:nvPr/>
        </p:nvSpPr>
        <p:spPr>
          <a:xfrm>
            <a:off x="5467350" y="398824"/>
            <a:ext cx="2806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2HKA</a:t>
            </a:r>
          </a:p>
        </p:txBody>
      </p:sp>
    </p:spTree>
    <p:extLst>
      <p:ext uri="{BB962C8B-B14F-4D97-AF65-F5344CB8AC3E}">
        <p14:creationId xmlns:p14="http://schemas.microsoft.com/office/powerpoint/2010/main" xmlns="" val="14879266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C92B76A-AF55-414B-AD0C-96C55CFF5EC2}"/>
              </a:ext>
            </a:extLst>
          </p:cNvPr>
          <p:cNvSpPr txBox="1"/>
          <p:nvPr/>
        </p:nvSpPr>
        <p:spPr>
          <a:xfrm>
            <a:off x="840950" y="4453522"/>
            <a:ext cx="257118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u="sng" dirty="0"/>
              <a:t>Ligand  atom colours</a:t>
            </a:r>
          </a:p>
          <a:p>
            <a:r>
              <a:rPr lang="en-GB" sz="1400" dirty="0"/>
              <a:t>Ball and stick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5ADA9C18-DE99-4DBB-9905-36B875A81043}"/>
              </a:ext>
            </a:extLst>
          </p:cNvPr>
          <p:cNvGrpSpPr/>
          <p:nvPr/>
        </p:nvGrpSpPr>
        <p:grpSpPr>
          <a:xfrm>
            <a:off x="840950" y="5115304"/>
            <a:ext cx="1983162" cy="1200329"/>
            <a:chOff x="863870" y="4894327"/>
            <a:chExt cx="1983162" cy="1200329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xmlns="" id="{5952B5F7-9E3E-4586-A0FD-0693061086C2}"/>
                </a:ext>
              </a:extLst>
            </p:cNvPr>
            <p:cNvGrpSpPr/>
            <p:nvPr/>
          </p:nvGrpSpPr>
          <p:grpSpPr>
            <a:xfrm>
              <a:off x="863870" y="4994296"/>
              <a:ext cx="200025" cy="85725"/>
              <a:chOff x="1057275" y="2581274"/>
              <a:chExt cx="200025" cy="85725"/>
            </a:xfrm>
            <a:solidFill>
              <a:schemeClr val="tx1"/>
            </a:solidFill>
          </p:grpSpPr>
          <p:sp>
            <p:nvSpPr>
              <p:cNvPr id="4" name="Oval 3">
                <a:extLst>
                  <a:ext uri="{FF2B5EF4-FFF2-40B4-BE49-F238E27FC236}">
                    <a16:creationId xmlns:a16="http://schemas.microsoft.com/office/drawing/2014/main" xmlns="" id="{ECF01121-276D-491F-BFC0-01017A785278}"/>
                  </a:ext>
                </a:extLst>
              </p:cNvPr>
              <p:cNvSpPr/>
              <p:nvPr/>
            </p:nvSpPr>
            <p:spPr>
              <a:xfrm>
                <a:off x="1057275" y="2581274"/>
                <a:ext cx="95250" cy="85725"/>
              </a:xfrm>
              <a:prstGeom prst="ellips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xmlns="" id="{67AAC595-7098-4628-A8D0-C743935D8B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4900" y="2628899"/>
                <a:ext cx="152400" cy="0"/>
              </a:xfrm>
              <a:prstGeom prst="line">
                <a:avLst/>
              </a:prstGeom>
              <a:grpFill/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xmlns="" id="{D20D306E-F980-46D5-A2B8-99E8ED428108}"/>
                </a:ext>
              </a:extLst>
            </p:cNvPr>
            <p:cNvGrpSpPr/>
            <p:nvPr/>
          </p:nvGrpSpPr>
          <p:grpSpPr>
            <a:xfrm>
              <a:off x="863870" y="5175271"/>
              <a:ext cx="200025" cy="85725"/>
              <a:chOff x="1057275" y="2581274"/>
              <a:chExt cx="200025" cy="85725"/>
            </a:xfrm>
            <a:solidFill>
              <a:schemeClr val="tx1"/>
            </a:solidFill>
          </p:grpSpPr>
          <p:sp>
            <p:nvSpPr>
              <p:cNvPr id="11" name="Oval 10">
                <a:extLst>
                  <a:ext uri="{FF2B5EF4-FFF2-40B4-BE49-F238E27FC236}">
                    <a16:creationId xmlns:a16="http://schemas.microsoft.com/office/drawing/2014/main" xmlns="" id="{086A4758-2C91-4C45-AAA8-B1FBFA65AAD6}"/>
                  </a:ext>
                </a:extLst>
              </p:cNvPr>
              <p:cNvSpPr/>
              <p:nvPr/>
            </p:nvSpPr>
            <p:spPr>
              <a:xfrm>
                <a:off x="1057275" y="2581274"/>
                <a:ext cx="95250" cy="85725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xmlns="" id="{754F9973-4AF8-47DA-93C4-982E24E64B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4900" y="2628899"/>
                <a:ext cx="152400" cy="0"/>
              </a:xfrm>
              <a:prstGeom prst="line">
                <a:avLst/>
              </a:prstGeom>
              <a:solidFill>
                <a:srgbClr val="FF0000"/>
              </a:solidFill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xmlns="" id="{611854F3-6910-4FC5-9507-A69CA829DBC7}"/>
                </a:ext>
              </a:extLst>
            </p:cNvPr>
            <p:cNvGrpSpPr/>
            <p:nvPr/>
          </p:nvGrpSpPr>
          <p:grpSpPr>
            <a:xfrm>
              <a:off x="863870" y="5356247"/>
              <a:ext cx="200025" cy="85725"/>
              <a:chOff x="1057275" y="2581274"/>
              <a:chExt cx="200025" cy="85725"/>
            </a:xfrm>
            <a:solidFill>
              <a:srgbClr val="0000FF"/>
            </a:solidFill>
          </p:grpSpPr>
          <p:sp>
            <p:nvSpPr>
              <p:cNvPr id="14" name="Oval 13">
                <a:extLst>
                  <a:ext uri="{FF2B5EF4-FFF2-40B4-BE49-F238E27FC236}">
                    <a16:creationId xmlns:a16="http://schemas.microsoft.com/office/drawing/2014/main" xmlns="" id="{45BFAD04-DCA6-4A76-A41E-1DC4607523C7}"/>
                  </a:ext>
                </a:extLst>
              </p:cNvPr>
              <p:cNvSpPr/>
              <p:nvPr/>
            </p:nvSpPr>
            <p:spPr>
              <a:xfrm>
                <a:off x="1057275" y="2581274"/>
                <a:ext cx="95250" cy="85725"/>
              </a:xfrm>
              <a:prstGeom prst="ellipse">
                <a:avLst/>
              </a:prstGeom>
              <a:grpFill/>
              <a:ln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xmlns="" id="{7EE6A765-045D-4510-9838-F318D8D15C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4900" y="2628899"/>
                <a:ext cx="152400" cy="0"/>
              </a:xfrm>
              <a:prstGeom prst="line">
                <a:avLst/>
              </a:prstGeom>
              <a:grpFill/>
              <a:ln w="28575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xmlns="" id="{FE73A1D6-5ADF-4C49-A982-93FA902AB20B}"/>
                </a:ext>
              </a:extLst>
            </p:cNvPr>
            <p:cNvGrpSpPr/>
            <p:nvPr/>
          </p:nvGrpSpPr>
          <p:grpSpPr>
            <a:xfrm>
              <a:off x="863870" y="5546746"/>
              <a:ext cx="200025" cy="85725"/>
              <a:chOff x="1057275" y="2581274"/>
              <a:chExt cx="200025" cy="85725"/>
            </a:xfrm>
            <a:solidFill>
              <a:schemeClr val="tx1"/>
            </a:solidFill>
          </p:grpSpPr>
          <p:sp>
            <p:nvSpPr>
              <p:cNvPr id="17" name="Oval 16">
                <a:extLst>
                  <a:ext uri="{FF2B5EF4-FFF2-40B4-BE49-F238E27FC236}">
                    <a16:creationId xmlns:a16="http://schemas.microsoft.com/office/drawing/2014/main" xmlns="" id="{465943E3-D7C5-4EF0-A699-774A3D06A3A7}"/>
                  </a:ext>
                </a:extLst>
              </p:cNvPr>
              <p:cNvSpPr/>
              <p:nvPr/>
            </p:nvSpPr>
            <p:spPr>
              <a:xfrm>
                <a:off x="1057275" y="2581274"/>
                <a:ext cx="95250" cy="85725"/>
              </a:xfrm>
              <a:prstGeom prst="ellipse">
                <a:avLst/>
              </a:prstGeom>
              <a:solidFill>
                <a:srgbClr val="FF00FF"/>
              </a:solidFill>
              <a:ln>
                <a:solidFill>
                  <a:srgbClr val="FF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xmlns="" id="{0F1FA128-5BD8-4EFA-8133-B0DD23E335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4900" y="2628899"/>
                <a:ext cx="152400" cy="0"/>
              </a:xfrm>
              <a:prstGeom prst="line">
                <a:avLst/>
              </a:prstGeom>
              <a:grpFill/>
              <a:ln w="28575">
                <a:solidFill>
                  <a:srgbClr val="FF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xmlns="" id="{DE383B00-1493-4EFC-BE3B-A68372BE53D5}"/>
                </a:ext>
              </a:extLst>
            </p:cNvPr>
            <p:cNvGrpSpPr/>
            <p:nvPr/>
          </p:nvGrpSpPr>
          <p:grpSpPr>
            <a:xfrm>
              <a:off x="863870" y="5714048"/>
              <a:ext cx="200025" cy="85725"/>
              <a:chOff x="1057275" y="3352801"/>
              <a:chExt cx="200025" cy="85725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xmlns="" id="{688146DC-FC0A-4524-83BF-EE3A1FBACA51}"/>
                  </a:ext>
                </a:extLst>
              </p:cNvPr>
              <p:cNvGrpSpPr/>
              <p:nvPr/>
            </p:nvGrpSpPr>
            <p:grpSpPr>
              <a:xfrm>
                <a:off x="1057275" y="3352801"/>
                <a:ext cx="200025" cy="85725"/>
                <a:chOff x="1057275" y="2581274"/>
                <a:chExt cx="200025" cy="85725"/>
              </a:xfrm>
              <a:solidFill>
                <a:srgbClr val="FFFF00"/>
              </a:solidFill>
            </p:grpSpPr>
            <p:sp>
              <p:nvSpPr>
                <p:cNvPr id="20" name="Oval 19">
                  <a:extLst>
                    <a:ext uri="{FF2B5EF4-FFF2-40B4-BE49-F238E27FC236}">
                      <a16:creationId xmlns:a16="http://schemas.microsoft.com/office/drawing/2014/main" xmlns="" id="{ED66C3A2-E7B8-4644-9A7A-3BB6318566D0}"/>
                    </a:ext>
                  </a:extLst>
                </p:cNvPr>
                <p:cNvSpPr/>
                <p:nvPr/>
              </p:nvSpPr>
              <p:spPr>
                <a:xfrm>
                  <a:off x="1057275" y="2581274"/>
                  <a:ext cx="95250" cy="85725"/>
                </a:xfrm>
                <a:prstGeom prst="ellipse">
                  <a:avLst/>
                </a:prstGeom>
                <a:grp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21" name="Straight Connector 20">
                  <a:extLst>
                    <a:ext uri="{FF2B5EF4-FFF2-40B4-BE49-F238E27FC236}">
                      <a16:creationId xmlns:a16="http://schemas.microsoft.com/office/drawing/2014/main" xmlns="" id="{39D79566-4739-40BE-A06B-D040CD6E50D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04900" y="2628899"/>
                  <a:ext cx="152400" cy="0"/>
                </a:xfrm>
                <a:prstGeom prst="line">
                  <a:avLst/>
                </a:prstGeom>
                <a:grpFill/>
                <a:ln w="28575">
                  <a:solidFill>
                    <a:srgbClr val="FFFF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xmlns="" id="{1A60D2F9-54ED-4C37-A47C-2A2F0CE48BB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47763" y="3388520"/>
                <a:ext cx="104775" cy="1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xmlns="" id="{874EF048-90FF-4815-AE36-DF212E56FD5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47762" y="3414714"/>
                <a:ext cx="104775" cy="1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xmlns="" id="{99F9C9FF-66EB-457A-8476-3CED9630B38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50162" y="3388510"/>
                <a:ext cx="0" cy="23816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xmlns="" id="{9ECA625A-79C9-4254-827A-DB5CB151300F}"/>
                </a:ext>
              </a:extLst>
            </p:cNvPr>
            <p:cNvGrpSpPr/>
            <p:nvPr/>
          </p:nvGrpSpPr>
          <p:grpSpPr>
            <a:xfrm>
              <a:off x="863870" y="5900576"/>
              <a:ext cx="195263" cy="85725"/>
              <a:chOff x="1057275" y="3487554"/>
              <a:chExt cx="195263" cy="85725"/>
            </a:xfrm>
          </p:grpSpPr>
          <p:sp>
            <p:nvSpPr>
              <p:cNvPr id="34" name="Oval 33">
                <a:extLst>
                  <a:ext uri="{FF2B5EF4-FFF2-40B4-BE49-F238E27FC236}">
                    <a16:creationId xmlns:a16="http://schemas.microsoft.com/office/drawing/2014/main" xmlns="" id="{4A1E8BF8-AC2C-40D1-BBC8-E6AA5336A8A4}"/>
                  </a:ext>
                </a:extLst>
              </p:cNvPr>
              <p:cNvSpPr/>
              <p:nvPr/>
            </p:nvSpPr>
            <p:spPr>
              <a:xfrm>
                <a:off x="1057275" y="3487554"/>
                <a:ext cx="95250" cy="85725"/>
              </a:xfrm>
              <a:prstGeom prst="ellipse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xmlns="" id="{270B3D5F-668E-4045-9AE8-F73D923EBC9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47763" y="3523273"/>
                <a:ext cx="104775" cy="1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xmlns="" id="{04245212-07A7-40B4-9576-FC92BBC565A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47762" y="3549467"/>
                <a:ext cx="104775" cy="1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xmlns="" id="{FC39F437-2A29-41DC-8608-AAF0F3DF137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250162" y="3523263"/>
                <a:ext cx="0" cy="23816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xmlns="" id="{FD863EA9-30EE-4B28-8C94-383CAFCE5835}"/>
                </a:ext>
              </a:extLst>
            </p:cNvPr>
            <p:cNvSpPr txBox="1"/>
            <p:nvPr/>
          </p:nvSpPr>
          <p:spPr>
            <a:xfrm>
              <a:off x="1044358" y="4894327"/>
              <a:ext cx="1802674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Carbon</a:t>
              </a:r>
            </a:p>
            <a:p>
              <a:r>
                <a:rPr lang="en-GB" sz="1200" dirty="0"/>
                <a:t>Oxygen</a:t>
              </a:r>
            </a:p>
            <a:p>
              <a:r>
                <a:rPr lang="en-GB" sz="1200" dirty="0"/>
                <a:t>Nitrogen</a:t>
              </a:r>
            </a:p>
            <a:p>
              <a:r>
                <a:rPr lang="en-GB" sz="1200" dirty="0"/>
                <a:t>Phosphorus</a:t>
              </a:r>
            </a:p>
            <a:p>
              <a:r>
                <a:rPr lang="en-GB" sz="1200" dirty="0"/>
                <a:t>Sulphur</a:t>
              </a:r>
            </a:p>
            <a:p>
              <a:r>
                <a:rPr lang="en-GB" sz="1200" dirty="0"/>
                <a:t>Hydrogen</a:t>
              </a: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xmlns="" id="{EDC19484-E491-46FF-8239-41383A0E9E04}"/>
              </a:ext>
            </a:extLst>
          </p:cNvPr>
          <p:cNvGrpSpPr/>
          <p:nvPr/>
        </p:nvGrpSpPr>
        <p:grpSpPr>
          <a:xfrm>
            <a:off x="759083" y="709667"/>
            <a:ext cx="3151688" cy="3098498"/>
            <a:chOff x="843361" y="2937719"/>
            <a:chExt cx="3151688" cy="3098498"/>
          </a:xfrm>
        </p:grpSpPr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xmlns="" id="{88B82335-7E43-4071-9D16-62A2A64F10A9}"/>
                </a:ext>
              </a:extLst>
            </p:cNvPr>
            <p:cNvGrpSpPr/>
            <p:nvPr/>
          </p:nvGrpSpPr>
          <p:grpSpPr>
            <a:xfrm>
              <a:off x="843361" y="3621251"/>
              <a:ext cx="1102071" cy="2414966"/>
              <a:chOff x="342717" y="3810884"/>
              <a:chExt cx="1102071" cy="2414966"/>
            </a:xfrm>
          </p:grpSpPr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xmlns="" id="{9B075CBC-A5DF-4562-9817-49249718993E}"/>
                  </a:ext>
                </a:extLst>
              </p:cNvPr>
              <p:cNvGrpSpPr/>
              <p:nvPr/>
            </p:nvGrpSpPr>
            <p:grpSpPr>
              <a:xfrm>
                <a:off x="342717" y="4057852"/>
                <a:ext cx="684818" cy="1945474"/>
                <a:chOff x="8243312" y="933558"/>
                <a:chExt cx="684818" cy="1945474"/>
              </a:xfrm>
            </p:grpSpPr>
            <p:pic>
              <p:nvPicPr>
                <p:cNvPr id="44" name="Picture 43">
                  <a:extLst>
                    <a:ext uri="{FF2B5EF4-FFF2-40B4-BE49-F238E27FC236}">
                      <a16:creationId xmlns:a16="http://schemas.microsoft.com/office/drawing/2014/main" xmlns="" id="{51F0F760-2F40-4172-8247-6FCC634D05F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/>
                <a:stretch>
                  <a:fillRect/>
                </a:stretch>
              </p:blipFill>
              <p:spPr>
                <a:xfrm flipH="1">
                  <a:off x="8630837" y="946040"/>
                  <a:ext cx="246007" cy="1905848"/>
                </a:xfrm>
                <a:prstGeom prst="rect">
                  <a:avLst/>
                </a:prstGeom>
              </p:spPr>
            </p:pic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xmlns="" id="{09F64A36-C427-41D1-B27F-7F2A5D6F3656}"/>
                    </a:ext>
                  </a:extLst>
                </p:cNvPr>
                <p:cNvSpPr txBox="1"/>
                <p:nvPr/>
              </p:nvSpPr>
              <p:spPr>
                <a:xfrm>
                  <a:off x="8267127" y="933558"/>
                  <a:ext cx="61390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/>
                    <a:t>200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xmlns="" id="{B649D080-C02B-40C4-9AEA-6011AE49E4AC}"/>
                    </a:ext>
                  </a:extLst>
                </p:cNvPr>
                <p:cNvSpPr txBox="1"/>
                <p:nvPr/>
              </p:nvSpPr>
              <p:spPr>
                <a:xfrm>
                  <a:off x="8314223" y="1774147"/>
                  <a:ext cx="61390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/>
                    <a:t>50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xmlns="" id="{7A95833D-ADBC-4DE5-BC35-8E564E6FBD11}"/>
                    </a:ext>
                  </a:extLst>
                </p:cNvPr>
                <p:cNvSpPr txBox="1"/>
                <p:nvPr/>
              </p:nvSpPr>
              <p:spPr>
                <a:xfrm>
                  <a:off x="8243312" y="2632811"/>
                  <a:ext cx="3982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GB" sz="1000" dirty="0"/>
                    <a:t>0</a:t>
                  </a:r>
                </a:p>
              </p:txBody>
            </p:sp>
          </p:grp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xmlns="" id="{3D60DC46-83DE-49C5-9304-C61FEEF6C3E1}"/>
                  </a:ext>
                </a:extLst>
              </p:cNvPr>
              <p:cNvSpPr txBox="1"/>
              <p:nvPr/>
            </p:nvSpPr>
            <p:spPr>
              <a:xfrm>
                <a:off x="511338" y="5918073"/>
                <a:ext cx="9334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Buried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xmlns="" id="{6838E139-3855-450F-90C8-FE47A9B7C669}"/>
                  </a:ext>
                </a:extLst>
              </p:cNvPr>
              <p:cNvSpPr txBox="1"/>
              <p:nvPr/>
            </p:nvSpPr>
            <p:spPr>
              <a:xfrm>
                <a:off x="413628" y="3810884"/>
                <a:ext cx="9334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Accessible</a:t>
                </a:r>
              </a:p>
            </p:txBody>
          </p:sp>
        </p:grp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xmlns="" id="{F7BD5ADE-3FB0-4A58-9E17-CE98F767560B}"/>
                </a:ext>
              </a:extLst>
            </p:cNvPr>
            <p:cNvSpPr txBox="1"/>
            <p:nvPr/>
          </p:nvSpPr>
          <p:spPr>
            <a:xfrm>
              <a:off x="972853" y="2937719"/>
              <a:ext cx="302219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u="sng" dirty="0"/>
                <a:t>Residue solvent accessibility</a:t>
              </a:r>
            </a:p>
            <a:p>
              <a:r>
                <a:rPr lang="en-GB" sz="1400" dirty="0"/>
                <a:t>Worms </a:t>
              </a:r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xmlns="" id="{87486889-76F1-4795-ABED-9C185AC7DF7E}"/>
              </a:ext>
            </a:extLst>
          </p:cNvPr>
          <p:cNvGrpSpPr/>
          <p:nvPr/>
        </p:nvGrpSpPr>
        <p:grpSpPr>
          <a:xfrm>
            <a:off x="4572000" y="1953989"/>
            <a:ext cx="933450" cy="887649"/>
            <a:chOff x="1292863" y="4489830"/>
            <a:chExt cx="933450" cy="887649"/>
          </a:xfrm>
        </p:grpSpPr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xmlns="" id="{7DD5F546-F0EA-4BA6-AD3F-25F0245D01A8}"/>
                </a:ext>
              </a:extLst>
            </p:cNvPr>
            <p:cNvSpPr/>
            <p:nvPr/>
          </p:nvSpPr>
          <p:spPr>
            <a:xfrm>
              <a:off x="1456180" y="4489830"/>
              <a:ext cx="346349" cy="307777"/>
            </a:xfrm>
            <a:prstGeom prst="rect">
              <a:avLst/>
            </a:prstGeom>
            <a:solidFill>
              <a:srgbClr val="0000FF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xmlns="" id="{C709BD9B-C99F-4F89-A240-B2539D17EAF0}"/>
                </a:ext>
              </a:extLst>
            </p:cNvPr>
            <p:cNvCxnSpPr>
              <a:cxnSpLocks/>
              <a:stCxn id="50" idx="2"/>
            </p:cNvCxnSpPr>
            <p:nvPr/>
          </p:nvCxnSpPr>
          <p:spPr>
            <a:xfrm flipH="1">
              <a:off x="1629354" y="4797607"/>
              <a:ext cx="1" cy="22394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xmlns="" id="{5DC398C8-E272-4B82-B061-FD6017C1C8C6}"/>
                </a:ext>
              </a:extLst>
            </p:cNvPr>
            <p:cNvSpPr txBox="1"/>
            <p:nvPr/>
          </p:nvSpPr>
          <p:spPr>
            <a:xfrm>
              <a:off x="1292863" y="5069702"/>
              <a:ext cx="9334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N glycan</a:t>
              </a:r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E17C1EF6-FDF6-4FAC-81B9-5FD2ED70413B}"/>
              </a:ext>
            </a:extLst>
          </p:cNvPr>
          <p:cNvSpPr txBox="1"/>
          <p:nvPr/>
        </p:nvSpPr>
        <p:spPr>
          <a:xfrm>
            <a:off x="1703165" y="343809"/>
            <a:ext cx="5737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2. </a:t>
            </a:r>
            <a:r>
              <a:rPr lang="en-GB" b="1" dirty="0"/>
              <a:t>KEY TO INTERPRETATION OF CRYSTAL MAPPING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A68EFB0A-ABB7-4FE9-93D2-4F50216B16DA}"/>
              </a:ext>
            </a:extLst>
          </p:cNvPr>
          <p:cNvGrpSpPr/>
          <p:nvPr/>
        </p:nvGrpSpPr>
        <p:grpSpPr>
          <a:xfrm>
            <a:off x="4735317" y="3574360"/>
            <a:ext cx="2101194" cy="711395"/>
            <a:chOff x="4650428" y="3197432"/>
            <a:chExt cx="2101194" cy="711395"/>
          </a:xfrm>
        </p:grpSpPr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xmlns="" id="{63DFFD3F-39B9-410D-BFFA-AAE0C654F95B}"/>
                </a:ext>
              </a:extLst>
            </p:cNvPr>
            <p:cNvGrpSpPr/>
            <p:nvPr/>
          </p:nvGrpSpPr>
          <p:grpSpPr>
            <a:xfrm>
              <a:off x="4650428" y="3197432"/>
              <a:ext cx="1525932" cy="276999"/>
              <a:chOff x="507053" y="5425718"/>
              <a:chExt cx="1525932" cy="276999"/>
            </a:xfrm>
          </p:grpSpPr>
          <p:grpSp>
            <p:nvGrpSpPr>
              <p:cNvPr id="56" name="Group 55">
                <a:extLst>
                  <a:ext uri="{FF2B5EF4-FFF2-40B4-BE49-F238E27FC236}">
                    <a16:creationId xmlns:a16="http://schemas.microsoft.com/office/drawing/2014/main" xmlns="" id="{F2F72F37-E0F5-41D7-AFF9-1ABD120A3043}"/>
                  </a:ext>
                </a:extLst>
              </p:cNvPr>
              <p:cNvGrpSpPr/>
              <p:nvPr/>
            </p:nvGrpSpPr>
            <p:grpSpPr>
              <a:xfrm>
                <a:off x="507053" y="5536075"/>
                <a:ext cx="579906" cy="56286"/>
                <a:chOff x="507053" y="5536075"/>
                <a:chExt cx="579906" cy="56286"/>
              </a:xfrm>
            </p:grpSpPr>
            <p:sp>
              <p:nvSpPr>
                <p:cNvPr id="58" name="Flowchart: Terminator 57">
                  <a:extLst>
                    <a:ext uri="{FF2B5EF4-FFF2-40B4-BE49-F238E27FC236}">
                      <a16:creationId xmlns:a16="http://schemas.microsoft.com/office/drawing/2014/main" xmlns="" id="{16CD65C8-FA07-42C7-BAE3-A648C14B5D80}"/>
                    </a:ext>
                  </a:extLst>
                </p:cNvPr>
                <p:cNvSpPr/>
                <p:nvPr/>
              </p:nvSpPr>
              <p:spPr>
                <a:xfrm>
                  <a:off x="507053" y="5536075"/>
                  <a:ext cx="579906" cy="56286"/>
                </a:xfrm>
                <a:prstGeom prst="flowChartTerminator">
                  <a:avLst/>
                </a:prstGeom>
                <a:solidFill>
                  <a:srgbClr val="00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59" name="Rectangle 58">
                  <a:extLst>
                    <a:ext uri="{FF2B5EF4-FFF2-40B4-BE49-F238E27FC236}">
                      <a16:creationId xmlns:a16="http://schemas.microsoft.com/office/drawing/2014/main" xmlns="" id="{8E5CD55A-172D-44D8-907B-753201133814}"/>
                    </a:ext>
                  </a:extLst>
                </p:cNvPr>
                <p:cNvSpPr/>
                <p:nvPr/>
              </p:nvSpPr>
              <p:spPr>
                <a:xfrm>
                  <a:off x="704850" y="5543352"/>
                  <a:ext cx="177800" cy="45719"/>
                </a:xfrm>
                <a:prstGeom prst="rect">
                  <a:avLst/>
                </a:prstGeom>
                <a:solidFill>
                  <a:srgbClr val="FFFF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60" name="Straight Connector 59">
                  <a:extLst>
                    <a:ext uri="{FF2B5EF4-FFF2-40B4-BE49-F238E27FC236}">
                      <a16:creationId xmlns:a16="http://schemas.microsoft.com/office/drawing/2014/main" xmlns="" id="{4D5064C9-92B3-42B3-AC83-1130E47E9DB3}"/>
                    </a:ext>
                  </a:extLst>
                </p:cNvPr>
                <p:cNvCxnSpPr/>
                <p:nvPr/>
              </p:nvCxnSpPr>
              <p:spPr>
                <a:xfrm>
                  <a:off x="624689" y="5592361"/>
                  <a:ext cx="293383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xmlns="" id="{0F6D486E-EC28-4413-89F0-87AFE64640F1}"/>
                  </a:ext>
                </a:extLst>
              </p:cNvPr>
              <p:cNvSpPr txBox="1"/>
              <p:nvPr/>
            </p:nvSpPr>
            <p:spPr>
              <a:xfrm>
                <a:off x="1100999" y="5425718"/>
                <a:ext cx="9319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 - C bridge </a:t>
                </a:r>
              </a:p>
            </p:txBody>
          </p:sp>
        </p:grp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xmlns="" id="{B1BBAE9D-0CF5-427A-93EA-81EBCEC13A9A}"/>
                </a:ext>
              </a:extLst>
            </p:cNvPr>
            <p:cNvGrpSpPr/>
            <p:nvPr/>
          </p:nvGrpSpPr>
          <p:grpSpPr>
            <a:xfrm>
              <a:off x="4650428" y="3405744"/>
              <a:ext cx="2101194" cy="503083"/>
              <a:chOff x="753756" y="5923242"/>
              <a:chExt cx="1771406" cy="461665"/>
            </a:xfrm>
          </p:grpSpPr>
          <p:sp>
            <p:nvSpPr>
              <p:cNvPr id="62" name="Flowchart: Terminator 61">
                <a:extLst>
                  <a:ext uri="{FF2B5EF4-FFF2-40B4-BE49-F238E27FC236}">
                    <a16:creationId xmlns:a16="http://schemas.microsoft.com/office/drawing/2014/main" xmlns="" id="{9F170785-2516-4D40-8F4D-703BB42A150B}"/>
                  </a:ext>
                </a:extLst>
              </p:cNvPr>
              <p:cNvSpPr/>
              <p:nvPr/>
            </p:nvSpPr>
            <p:spPr>
              <a:xfrm>
                <a:off x="753756" y="6049025"/>
                <a:ext cx="488888" cy="51652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" name="Flowchart: Terminator 62">
                <a:extLst>
                  <a:ext uri="{FF2B5EF4-FFF2-40B4-BE49-F238E27FC236}">
                    <a16:creationId xmlns:a16="http://schemas.microsoft.com/office/drawing/2014/main" xmlns="" id="{D5476E60-37F2-4B3F-B526-884CC188B929}"/>
                  </a:ext>
                </a:extLst>
              </p:cNvPr>
              <p:cNvSpPr/>
              <p:nvPr/>
            </p:nvSpPr>
            <p:spPr>
              <a:xfrm>
                <a:off x="753756" y="6220564"/>
                <a:ext cx="488888" cy="51652"/>
              </a:xfrm>
              <a:prstGeom prst="flowChartTerminator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xmlns="" id="{51804EE9-1F24-4E0B-A80C-A669AFBF1A16}"/>
                  </a:ext>
                </a:extLst>
              </p:cNvPr>
              <p:cNvSpPr txBox="1"/>
              <p:nvPr/>
            </p:nvSpPr>
            <p:spPr>
              <a:xfrm>
                <a:off x="1239570" y="5923242"/>
                <a:ext cx="12855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Active site</a:t>
                </a:r>
              </a:p>
              <a:p>
                <a:r>
                  <a:rPr lang="en-GB" sz="1200" dirty="0"/>
                  <a:t>Ligand</a:t>
                </a:r>
              </a:p>
            </p:txBody>
          </p:sp>
        </p:grpSp>
      </p:grp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6A64EE18-5644-474F-A191-DC65FB87AB0E}"/>
              </a:ext>
            </a:extLst>
          </p:cNvPr>
          <p:cNvSpPr txBox="1"/>
          <p:nvPr/>
        </p:nvSpPr>
        <p:spPr>
          <a:xfrm>
            <a:off x="377340" y="3776139"/>
            <a:ext cx="368398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Residue solvent accessibility has default range of 0-200. Units are 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Å</a:t>
            </a:r>
            <a:r>
              <a:rPr lang="en-GB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400" baseline="30000" dirty="0"/>
              <a:t> </a:t>
            </a:r>
            <a:endParaRPr lang="en-GB" sz="1400" baseline="30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F297506-C373-47FE-B8BC-F7EDB4708413}"/>
              </a:ext>
            </a:extLst>
          </p:cNvPr>
          <p:cNvSpPr txBox="1"/>
          <p:nvPr/>
        </p:nvSpPr>
        <p:spPr>
          <a:xfrm>
            <a:off x="4620744" y="3315683"/>
            <a:ext cx="19702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u="sng" dirty="0"/>
              <a:t>Cylinders</a:t>
            </a:r>
          </a:p>
        </p:txBody>
      </p:sp>
    </p:spTree>
    <p:extLst>
      <p:ext uri="{BB962C8B-B14F-4D97-AF65-F5344CB8AC3E}">
        <p14:creationId xmlns:p14="http://schemas.microsoft.com/office/powerpoint/2010/main" xmlns="" val="407273718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B2C7CAFD-C089-437D-8364-F7B606481EA6}"/>
              </a:ext>
            </a:extLst>
          </p:cNvPr>
          <p:cNvSpPr txBox="1"/>
          <p:nvPr/>
        </p:nvSpPr>
        <p:spPr>
          <a:xfrm>
            <a:off x="147493" y="412750"/>
            <a:ext cx="58562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20. </a:t>
            </a:r>
            <a:r>
              <a:rPr lang="en-GB" b="1" dirty="0"/>
              <a:t>ATP </a:t>
            </a:r>
            <a:r>
              <a:rPr lang="en-GB" b="1" dirty="0" err="1"/>
              <a:t>diphosphohydrolase</a:t>
            </a:r>
            <a:r>
              <a:rPr lang="en-GB" b="1" dirty="0"/>
              <a:t>, external domain, </a:t>
            </a:r>
            <a:r>
              <a:rPr lang="en-GB" b="1" dirty="0">
                <a:ea typeface="Calibri" panose="020F0502020204030204" pitchFamily="34" charset="0"/>
              </a:rPr>
              <a:t>Smp_042020 </a:t>
            </a:r>
            <a:endParaRPr lang="en-GB" b="1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AE215752-0EDD-4247-9412-DF27229B3963}"/>
              </a:ext>
            </a:extLst>
          </p:cNvPr>
          <p:cNvGrpSpPr/>
          <p:nvPr/>
        </p:nvGrpSpPr>
        <p:grpSpPr>
          <a:xfrm>
            <a:off x="2039927" y="1163365"/>
            <a:ext cx="4769445" cy="5108825"/>
            <a:chOff x="2039927" y="1163365"/>
            <a:chExt cx="4769445" cy="510882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A271E7A7-6D99-4BAF-B278-6E773E72213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 rot="20776495">
              <a:off x="2039927" y="1163365"/>
              <a:ext cx="4659538" cy="5108825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F94D09B4-5763-4F57-99C9-7AC155396461}"/>
                </a:ext>
              </a:extLst>
            </p:cNvPr>
            <p:cNvSpPr txBox="1"/>
            <p:nvPr/>
          </p:nvSpPr>
          <p:spPr>
            <a:xfrm>
              <a:off x="5719938" y="2640415"/>
              <a:ext cx="9865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7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27CCCB70-A5C3-4829-B540-59A71880ECD4}"/>
                </a:ext>
              </a:extLst>
            </p:cNvPr>
            <p:cNvSpPr txBox="1"/>
            <p:nvPr/>
          </p:nvSpPr>
          <p:spPr>
            <a:xfrm>
              <a:off x="5822783" y="3323013"/>
              <a:ext cx="9865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2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C76E39A7-6EC9-461C-9627-7115949F7BA6}"/>
              </a:ext>
            </a:extLst>
          </p:cNvPr>
          <p:cNvGrpSpPr/>
          <p:nvPr/>
        </p:nvGrpSpPr>
        <p:grpSpPr>
          <a:xfrm>
            <a:off x="708766" y="5671381"/>
            <a:ext cx="2101194" cy="503083"/>
            <a:chOff x="753756" y="5923242"/>
            <a:chExt cx="1771406" cy="461665"/>
          </a:xfrm>
        </p:grpSpPr>
        <p:sp>
          <p:nvSpPr>
            <p:cNvPr id="17" name="Flowchart: Terminator 16">
              <a:extLst>
                <a:ext uri="{FF2B5EF4-FFF2-40B4-BE49-F238E27FC236}">
                  <a16:creationId xmlns:a16="http://schemas.microsoft.com/office/drawing/2014/main" xmlns="" id="{085A954F-6585-4412-94D0-42EEEE6EBF71}"/>
                </a:ext>
              </a:extLst>
            </p:cNvPr>
            <p:cNvSpPr/>
            <p:nvPr/>
          </p:nvSpPr>
          <p:spPr>
            <a:xfrm>
              <a:off x="753756" y="6049025"/>
              <a:ext cx="488888" cy="51652"/>
            </a:xfrm>
            <a:prstGeom prst="flowChartTerminator">
              <a:avLst/>
            </a:prstGeom>
            <a:solidFill>
              <a:srgbClr val="00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Flowchart: Terminator 17">
              <a:extLst>
                <a:ext uri="{FF2B5EF4-FFF2-40B4-BE49-F238E27FC236}">
                  <a16:creationId xmlns:a16="http://schemas.microsoft.com/office/drawing/2014/main" xmlns="" id="{6716F54F-340B-47EB-B731-906FF972FFE1}"/>
                </a:ext>
              </a:extLst>
            </p:cNvPr>
            <p:cNvSpPr/>
            <p:nvPr/>
          </p:nvSpPr>
          <p:spPr>
            <a:xfrm>
              <a:off x="753756" y="6220564"/>
              <a:ext cx="488888" cy="51652"/>
            </a:xfrm>
            <a:prstGeom prst="flowChartTerminator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85A19D28-F0CA-48F1-AF0F-9C55FDA505F5}"/>
                </a:ext>
              </a:extLst>
            </p:cNvPr>
            <p:cNvSpPr txBox="1"/>
            <p:nvPr/>
          </p:nvSpPr>
          <p:spPr>
            <a:xfrm>
              <a:off x="1239570" y="5923242"/>
              <a:ext cx="12855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Active site</a:t>
              </a:r>
            </a:p>
            <a:p>
              <a:r>
                <a:rPr lang="en-GB" sz="1200" dirty="0"/>
                <a:t>Ligand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B8F62809-1CDA-49EC-A096-79607F89425C}"/>
              </a:ext>
            </a:extLst>
          </p:cNvPr>
          <p:cNvSpPr txBox="1"/>
          <p:nvPr/>
        </p:nvSpPr>
        <p:spPr>
          <a:xfrm>
            <a:off x="6003097" y="399577"/>
            <a:ext cx="3282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3ZX3 &amp; 3CJ7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xmlns="" id="{80640D93-D347-4A56-8BA0-DEA3024DD9A1}"/>
              </a:ext>
            </a:extLst>
          </p:cNvPr>
          <p:cNvCxnSpPr>
            <a:cxnSpLocks/>
          </p:cNvCxnSpPr>
          <p:nvPr/>
        </p:nvCxnSpPr>
        <p:spPr>
          <a:xfrm>
            <a:off x="3651250" y="5473700"/>
            <a:ext cx="0" cy="971550"/>
          </a:xfrm>
          <a:prstGeom prst="line">
            <a:avLst/>
          </a:prstGeom>
          <a:ln w="19050" cap="flat" cmpd="sng" algn="ctr">
            <a:solidFill>
              <a:schemeClr val="bg1">
                <a:lumMod val="50000"/>
              </a:schemeClr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1602B89-1800-4347-8A49-7464B95A5AD3}"/>
              </a:ext>
            </a:extLst>
          </p:cNvPr>
          <p:cNvSpPr txBox="1"/>
          <p:nvPr/>
        </p:nvSpPr>
        <p:spPr>
          <a:xfrm flipH="1">
            <a:off x="3685344" y="6005894"/>
            <a:ext cx="250888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Transmembrane</a:t>
            </a:r>
          </a:p>
          <a:p>
            <a:r>
              <a:rPr lang="en-GB" sz="1400" dirty="0"/>
              <a:t>helix</a:t>
            </a:r>
          </a:p>
        </p:txBody>
      </p:sp>
    </p:spTree>
    <p:extLst>
      <p:ext uri="{BB962C8B-B14F-4D97-AF65-F5344CB8AC3E}">
        <p14:creationId xmlns:p14="http://schemas.microsoft.com/office/powerpoint/2010/main" xmlns="" val="215473622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AA479EB7-C639-496B-BE32-F1EF648F8C63}"/>
              </a:ext>
            </a:extLst>
          </p:cNvPr>
          <p:cNvGrpSpPr/>
          <p:nvPr/>
        </p:nvGrpSpPr>
        <p:grpSpPr>
          <a:xfrm rot="11856352">
            <a:off x="2629123" y="882776"/>
            <a:ext cx="4479313" cy="5059346"/>
            <a:chOff x="2517860" y="873580"/>
            <a:chExt cx="4950405" cy="568830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73F43820-733D-4C15-8557-DC1554F32CD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517860" y="873580"/>
              <a:ext cx="4950405" cy="5688309"/>
            </a:xfrm>
            <a:prstGeom prst="rect">
              <a:avLst/>
            </a:prstGeom>
          </p:spPr>
        </p:pic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xmlns="" id="{F424F327-0C22-4033-9057-C1D79AB214C3}"/>
                </a:ext>
              </a:extLst>
            </p:cNvPr>
            <p:cNvGrpSpPr/>
            <p:nvPr/>
          </p:nvGrpSpPr>
          <p:grpSpPr>
            <a:xfrm>
              <a:off x="3583722" y="2241500"/>
              <a:ext cx="2803211" cy="3602029"/>
              <a:chOff x="1377862" y="1580681"/>
              <a:chExt cx="2858018" cy="3752653"/>
            </a:xfrm>
          </p:grpSpPr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xmlns="" id="{BDF41AC8-F67C-4D1A-8958-C7DB142B0E05}"/>
                  </a:ext>
                </a:extLst>
              </p:cNvPr>
              <p:cNvSpPr txBox="1"/>
              <p:nvPr/>
            </p:nvSpPr>
            <p:spPr>
              <a:xfrm rot="9743648">
                <a:off x="3799152" y="4623778"/>
                <a:ext cx="4367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/>
                  <a:t>P1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xmlns="" id="{BCDEC553-0C6E-449E-9C6A-BDDF6F21A7B4}"/>
                  </a:ext>
                </a:extLst>
              </p:cNvPr>
              <p:cNvSpPr txBox="1"/>
              <p:nvPr/>
            </p:nvSpPr>
            <p:spPr>
              <a:xfrm rot="9743648">
                <a:off x="2975369" y="3327672"/>
                <a:ext cx="4367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/>
                  <a:t>P4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xmlns="" id="{5C3C3210-DB3D-4D6D-8E12-E408D3B48217}"/>
                  </a:ext>
                </a:extLst>
              </p:cNvPr>
              <p:cNvSpPr txBox="1"/>
              <p:nvPr/>
            </p:nvSpPr>
            <p:spPr>
              <a:xfrm rot="9743648">
                <a:off x="2647551" y="5025557"/>
                <a:ext cx="4367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/>
                  <a:t>P2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xmlns="" id="{8E1A8211-4C4B-4035-851E-A202345EBA35}"/>
                  </a:ext>
                </a:extLst>
              </p:cNvPr>
              <p:cNvSpPr txBox="1"/>
              <p:nvPr/>
            </p:nvSpPr>
            <p:spPr>
              <a:xfrm rot="9743648">
                <a:off x="2814937" y="4066479"/>
                <a:ext cx="59822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/>
                  <a:t>P3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xmlns="" id="{F63685F9-5C86-463C-973C-0B451C65B787}"/>
                  </a:ext>
                </a:extLst>
              </p:cNvPr>
              <p:cNvSpPr txBox="1"/>
              <p:nvPr/>
            </p:nvSpPr>
            <p:spPr>
              <a:xfrm rot="9743648">
                <a:off x="2606871" y="2856782"/>
                <a:ext cx="4367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/>
                  <a:t>P6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xmlns="" id="{84572BD5-04ED-4B4E-9E09-43DCAD4C2DD5}"/>
                  </a:ext>
                </a:extLst>
              </p:cNvPr>
              <p:cNvSpPr txBox="1"/>
              <p:nvPr/>
            </p:nvSpPr>
            <p:spPr>
              <a:xfrm rot="9743648">
                <a:off x="3485816" y="3907372"/>
                <a:ext cx="4367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/>
                  <a:t>P7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xmlns="" id="{5297C2CB-14BE-40A7-9219-107A60D6454B}"/>
                  </a:ext>
                </a:extLst>
              </p:cNvPr>
              <p:cNvSpPr txBox="1"/>
              <p:nvPr/>
            </p:nvSpPr>
            <p:spPr>
              <a:xfrm rot="9743648">
                <a:off x="1377862" y="1580681"/>
                <a:ext cx="59822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/>
                  <a:t>P10</a:t>
                </a:r>
              </a:p>
            </p:txBody>
          </p:sp>
        </p:grp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BB2F993B-CF48-42EC-ACA8-B096F1CB0C10}"/>
              </a:ext>
            </a:extLst>
          </p:cNvPr>
          <p:cNvSpPr txBox="1"/>
          <p:nvPr/>
        </p:nvSpPr>
        <p:spPr>
          <a:xfrm>
            <a:off x="584790" y="395610"/>
            <a:ext cx="4450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21. </a:t>
            </a:r>
            <a:r>
              <a:rPr lang="en-GB" b="1" dirty="0"/>
              <a:t>ADP Ribosyl cyclase, </a:t>
            </a:r>
            <a:r>
              <a:rPr lang="en-GB" b="1" dirty="0">
                <a:solidFill>
                  <a:srgbClr val="000000"/>
                </a:solidFill>
                <a:ea typeface="Times New Roman" panose="02020603050405020304" pitchFamily="18" charset="0"/>
              </a:rPr>
              <a:t>Smp_025830 </a:t>
            </a:r>
            <a:endParaRPr lang="en-GB" b="1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660D846B-51C6-469C-A27E-595E86DF9F7E}"/>
              </a:ext>
            </a:extLst>
          </p:cNvPr>
          <p:cNvGrpSpPr/>
          <p:nvPr/>
        </p:nvGrpSpPr>
        <p:grpSpPr>
          <a:xfrm>
            <a:off x="747484" y="5125015"/>
            <a:ext cx="1826887" cy="886629"/>
            <a:chOff x="747484" y="5125015"/>
            <a:chExt cx="1826887" cy="886629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xmlns="" id="{0E2A8B17-CF05-4BC6-9AF0-6B5C7A048F86}"/>
                </a:ext>
              </a:extLst>
            </p:cNvPr>
            <p:cNvGrpSpPr/>
            <p:nvPr/>
          </p:nvGrpSpPr>
          <p:grpSpPr>
            <a:xfrm>
              <a:off x="799891" y="5125015"/>
              <a:ext cx="1774480" cy="646331"/>
              <a:chOff x="1056181" y="1896700"/>
              <a:chExt cx="1774480" cy="793015"/>
            </a:xfrm>
          </p:grpSpPr>
          <p:sp>
            <p:nvSpPr>
              <p:cNvPr id="22" name="Flowchart: Terminator 21">
                <a:extLst>
                  <a:ext uri="{FF2B5EF4-FFF2-40B4-BE49-F238E27FC236}">
                    <a16:creationId xmlns:a16="http://schemas.microsoft.com/office/drawing/2014/main" xmlns="" id="{DCD38AF5-1F9D-4CBF-8610-29E82F6B4809}"/>
                  </a:ext>
                </a:extLst>
              </p:cNvPr>
              <p:cNvSpPr/>
              <p:nvPr/>
            </p:nvSpPr>
            <p:spPr>
              <a:xfrm>
                <a:off x="1059255" y="2073244"/>
                <a:ext cx="488888" cy="63374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" name="Flowchart: Terminator 22">
                <a:extLst>
                  <a:ext uri="{FF2B5EF4-FFF2-40B4-BE49-F238E27FC236}">
                    <a16:creationId xmlns:a16="http://schemas.microsoft.com/office/drawing/2014/main" xmlns="" id="{10F1B4A8-68AC-4B9B-989D-5488C8161920}"/>
                  </a:ext>
                </a:extLst>
              </p:cNvPr>
              <p:cNvSpPr/>
              <p:nvPr/>
            </p:nvSpPr>
            <p:spPr>
              <a:xfrm>
                <a:off x="1059255" y="2449798"/>
                <a:ext cx="488888" cy="63374"/>
              </a:xfrm>
              <a:prstGeom prst="flowChartTerminator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Flowchart: Terminator 23">
                <a:extLst>
                  <a:ext uri="{FF2B5EF4-FFF2-40B4-BE49-F238E27FC236}">
                    <a16:creationId xmlns:a16="http://schemas.microsoft.com/office/drawing/2014/main" xmlns="" id="{023FEEBD-2659-45B0-96C8-D0A5DE3D65E2}"/>
                  </a:ext>
                </a:extLst>
              </p:cNvPr>
              <p:cNvSpPr/>
              <p:nvPr/>
            </p:nvSpPr>
            <p:spPr>
              <a:xfrm>
                <a:off x="1056181" y="2261521"/>
                <a:ext cx="488888" cy="63374"/>
              </a:xfrm>
              <a:prstGeom prst="flowChartTerminator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xmlns="" id="{CFF4FE76-4572-4172-A3C2-79E2DCC322E4}"/>
                  </a:ext>
                </a:extLst>
              </p:cNvPr>
              <p:cNvSpPr txBox="1"/>
              <p:nvPr/>
            </p:nvSpPr>
            <p:spPr>
              <a:xfrm>
                <a:off x="1545069" y="1896700"/>
                <a:ext cx="1285592" cy="7930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Active site</a:t>
                </a:r>
              </a:p>
              <a:p>
                <a:r>
                  <a:rPr lang="en-GB" sz="1200" dirty="0"/>
                  <a:t>Dimer interaction</a:t>
                </a:r>
              </a:p>
              <a:p>
                <a:r>
                  <a:rPr lang="en-GB" sz="1200" dirty="0"/>
                  <a:t>Ligand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xmlns="" id="{79A83A0F-1071-4D42-AC6C-51AD386A90A9}"/>
                </a:ext>
              </a:extLst>
            </p:cNvPr>
            <p:cNvGrpSpPr/>
            <p:nvPr/>
          </p:nvGrpSpPr>
          <p:grpSpPr>
            <a:xfrm>
              <a:off x="747484" y="5734645"/>
              <a:ext cx="1525932" cy="276999"/>
              <a:chOff x="507053" y="5425718"/>
              <a:chExt cx="1525932" cy="276999"/>
            </a:xfrm>
          </p:grpSpPr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xmlns="" id="{1E2B640C-AC3A-4492-BE20-F4B76674A2B1}"/>
                  </a:ext>
                </a:extLst>
              </p:cNvPr>
              <p:cNvGrpSpPr/>
              <p:nvPr/>
            </p:nvGrpSpPr>
            <p:grpSpPr>
              <a:xfrm>
                <a:off x="507053" y="5536075"/>
                <a:ext cx="579906" cy="61083"/>
                <a:chOff x="507053" y="5536075"/>
                <a:chExt cx="579906" cy="61083"/>
              </a:xfrm>
            </p:grpSpPr>
            <p:sp>
              <p:nvSpPr>
                <p:cNvPr id="30" name="Flowchart: Terminator 29">
                  <a:extLst>
                    <a:ext uri="{FF2B5EF4-FFF2-40B4-BE49-F238E27FC236}">
                      <a16:creationId xmlns:a16="http://schemas.microsoft.com/office/drawing/2014/main" xmlns="" id="{94B2295B-6FE7-46C2-9E2A-40C43F9CE088}"/>
                    </a:ext>
                  </a:extLst>
                </p:cNvPr>
                <p:cNvSpPr/>
                <p:nvPr/>
              </p:nvSpPr>
              <p:spPr>
                <a:xfrm>
                  <a:off x="507053" y="5536075"/>
                  <a:ext cx="579906" cy="56286"/>
                </a:xfrm>
                <a:prstGeom prst="flowChartTerminator">
                  <a:avLst/>
                </a:prstGeom>
                <a:solidFill>
                  <a:srgbClr val="00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xmlns="" id="{170D49F6-50B5-4B54-B600-72168231A369}"/>
                    </a:ext>
                  </a:extLst>
                </p:cNvPr>
                <p:cNvSpPr/>
                <p:nvPr/>
              </p:nvSpPr>
              <p:spPr>
                <a:xfrm>
                  <a:off x="704850" y="5539747"/>
                  <a:ext cx="177800" cy="57411"/>
                </a:xfrm>
                <a:prstGeom prst="rect">
                  <a:avLst/>
                </a:prstGeom>
                <a:solidFill>
                  <a:srgbClr val="FFFF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xmlns="" id="{CCD2D3FE-AA47-43CB-AE65-7F8F93EF1458}"/>
                    </a:ext>
                  </a:extLst>
                </p:cNvPr>
                <p:cNvCxnSpPr/>
                <p:nvPr/>
              </p:nvCxnSpPr>
              <p:spPr>
                <a:xfrm>
                  <a:off x="624689" y="5592361"/>
                  <a:ext cx="293383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xmlns="" id="{42BD2349-FE5F-4F5F-BEBD-08A59EED01D4}"/>
                  </a:ext>
                </a:extLst>
              </p:cNvPr>
              <p:cNvSpPr txBox="1"/>
              <p:nvPr/>
            </p:nvSpPr>
            <p:spPr>
              <a:xfrm>
                <a:off x="1100999" y="5425718"/>
                <a:ext cx="9319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 - C bridge </a:t>
                </a:r>
              </a:p>
            </p:txBody>
          </p:sp>
        </p:grp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2860575D-0A2A-4A6E-9603-58F32D4F8DB1}"/>
              </a:ext>
            </a:extLst>
          </p:cNvPr>
          <p:cNvSpPr txBox="1"/>
          <p:nvPr/>
        </p:nvSpPr>
        <p:spPr>
          <a:xfrm>
            <a:off x="5715895" y="395610"/>
            <a:ext cx="2598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 3ZWX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xmlns="" id="{9F89E43A-4DE3-488E-BCBD-1887F8BFF517}"/>
              </a:ext>
            </a:extLst>
          </p:cNvPr>
          <p:cNvCxnSpPr/>
          <p:nvPr/>
        </p:nvCxnSpPr>
        <p:spPr>
          <a:xfrm flipH="1">
            <a:off x="3629025" y="5845002"/>
            <a:ext cx="208687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C60BEDAD-63E4-45C9-B6C3-AE17651CA7D3}"/>
              </a:ext>
            </a:extLst>
          </p:cNvPr>
          <p:cNvSpPr txBox="1"/>
          <p:nvPr/>
        </p:nvSpPr>
        <p:spPr>
          <a:xfrm>
            <a:off x="5739303" y="5719255"/>
            <a:ext cx="14573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Membran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105BCE30-D32D-4AAD-A917-B7394A9AF96B}"/>
              </a:ext>
            </a:extLst>
          </p:cNvPr>
          <p:cNvSpPr txBox="1"/>
          <p:nvPr/>
        </p:nvSpPr>
        <p:spPr>
          <a:xfrm>
            <a:off x="4085953" y="5818782"/>
            <a:ext cx="16787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GPI anchor</a:t>
            </a:r>
          </a:p>
        </p:txBody>
      </p:sp>
    </p:spTree>
    <p:extLst>
      <p:ext uri="{BB962C8B-B14F-4D97-AF65-F5344CB8AC3E}">
        <p14:creationId xmlns:p14="http://schemas.microsoft.com/office/powerpoint/2010/main" xmlns="" val="398297384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67E07553-1C12-41C6-980C-D603FAC21F9F}"/>
              </a:ext>
            </a:extLst>
          </p:cNvPr>
          <p:cNvSpPr txBox="1"/>
          <p:nvPr/>
        </p:nvSpPr>
        <p:spPr>
          <a:xfrm>
            <a:off x="823864" y="401213"/>
            <a:ext cx="4057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22. </a:t>
            </a:r>
            <a:r>
              <a:rPr lang="en-GB" b="1" dirty="0"/>
              <a:t>Carbonic anhydrase, </a:t>
            </a:r>
            <a:r>
              <a:rPr lang="en-GB" b="1" dirty="0" smtClean="0">
                <a:solidFill>
                  <a:srgbClr val="000000"/>
                </a:solidFill>
                <a:ea typeface="Calibri" panose="020F0502020204030204" pitchFamily="34" charset="0"/>
              </a:rPr>
              <a:t>Smp_168730</a:t>
            </a:r>
            <a:endParaRPr lang="en-GB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C31262BE-2167-4383-A1D5-829A4C27F832}"/>
              </a:ext>
            </a:extLst>
          </p:cNvPr>
          <p:cNvSpPr txBox="1"/>
          <p:nvPr/>
        </p:nvSpPr>
        <p:spPr>
          <a:xfrm>
            <a:off x="5131706" y="401213"/>
            <a:ext cx="3331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 6QQM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xmlns="" id="{426F3ABB-BA00-4698-8A49-DE6AA0F5E319}"/>
              </a:ext>
            </a:extLst>
          </p:cNvPr>
          <p:cNvGrpSpPr/>
          <p:nvPr/>
        </p:nvGrpSpPr>
        <p:grpSpPr>
          <a:xfrm>
            <a:off x="2030810" y="1045491"/>
            <a:ext cx="5559070" cy="4890057"/>
            <a:chOff x="2047875" y="943415"/>
            <a:chExt cx="5559070" cy="4890057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xmlns="" id="{91542A00-5DDA-44A9-8DC7-AC15110CDFAA}"/>
                </a:ext>
              </a:extLst>
            </p:cNvPr>
            <p:cNvGrpSpPr/>
            <p:nvPr/>
          </p:nvGrpSpPr>
          <p:grpSpPr>
            <a:xfrm>
              <a:off x="2047875" y="943415"/>
              <a:ext cx="5238750" cy="4890057"/>
              <a:chOff x="2047875" y="943415"/>
              <a:chExt cx="5238750" cy="4890057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xmlns="" id="{C9371DC1-ED87-43D1-9CC4-BF5B495537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2047875" y="1024527"/>
                <a:ext cx="5238750" cy="4808945"/>
              </a:xfrm>
              <a:prstGeom prst="rect">
                <a:avLst/>
              </a:prstGeom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xmlns="" id="{4621BF0F-3CA9-4457-AE16-204F2217BC3A}"/>
                  </a:ext>
                </a:extLst>
              </p:cNvPr>
              <p:cNvSpPr txBox="1"/>
              <p:nvPr/>
            </p:nvSpPr>
            <p:spPr>
              <a:xfrm>
                <a:off x="5449754" y="4362479"/>
                <a:ext cx="4359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8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xmlns="" id="{957026F0-9E3A-4987-9EE4-CAD402FA7458}"/>
                  </a:ext>
                </a:extLst>
              </p:cNvPr>
              <p:cNvSpPr txBox="1"/>
              <p:nvPr/>
            </p:nvSpPr>
            <p:spPr>
              <a:xfrm>
                <a:off x="4459541" y="2803535"/>
                <a:ext cx="6684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Zn</a:t>
                </a:r>
                <a:r>
                  <a:rPr kumimoji="0" lang="en-GB" sz="1400" b="1" i="0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2+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xmlns="" id="{AD236E9D-5619-4A47-82C7-26EEFFCCF994}"/>
                  </a:ext>
                </a:extLst>
              </p:cNvPr>
              <p:cNvSpPr txBox="1"/>
              <p:nvPr/>
            </p:nvSpPr>
            <p:spPr>
              <a:xfrm>
                <a:off x="4527771" y="3498196"/>
                <a:ext cx="4359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7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xmlns="" id="{16AB9174-B796-4BA0-B391-CFA163D52204}"/>
                  </a:ext>
                </a:extLst>
              </p:cNvPr>
              <p:cNvSpPr txBox="1"/>
              <p:nvPr/>
            </p:nvSpPr>
            <p:spPr>
              <a:xfrm>
                <a:off x="3804904" y="2957423"/>
                <a:ext cx="4359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4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xmlns="" id="{131CF93F-667C-4846-A336-33358BB9B2DA}"/>
                  </a:ext>
                </a:extLst>
              </p:cNvPr>
              <p:cNvSpPr txBox="1"/>
              <p:nvPr/>
            </p:nvSpPr>
            <p:spPr>
              <a:xfrm>
                <a:off x="3873870" y="2219640"/>
                <a:ext cx="4359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5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xmlns="" id="{625126B0-F325-4872-AD39-E14FAC81020B}"/>
                  </a:ext>
                </a:extLst>
              </p:cNvPr>
              <p:cNvSpPr txBox="1"/>
              <p:nvPr/>
            </p:nvSpPr>
            <p:spPr>
              <a:xfrm>
                <a:off x="5312293" y="943415"/>
                <a:ext cx="4359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1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xmlns="" id="{B1D9F6EE-E4FF-42EF-807E-9B736E496823}"/>
                  </a:ext>
                </a:extLst>
              </p:cNvPr>
              <p:cNvSpPr txBox="1"/>
              <p:nvPr/>
            </p:nvSpPr>
            <p:spPr>
              <a:xfrm>
                <a:off x="2599807" y="3023683"/>
                <a:ext cx="4359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9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xmlns="" id="{C1D9CC3E-27F5-4953-BE39-52C07AC160D5}"/>
                  </a:ext>
                </a:extLst>
              </p:cNvPr>
              <p:cNvSpPr txBox="1"/>
              <p:nvPr/>
            </p:nvSpPr>
            <p:spPr>
              <a:xfrm>
                <a:off x="4309804" y="5171889"/>
                <a:ext cx="4359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P3</a:t>
                </a:r>
              </a:p>
            </p:txBody>
          </p:sp>
        </p:grp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xmlns="" id="{C5651AAA-0FB6-463C-ADEC-7E7B83B841E2}"/>
                </a:ext>
              </a:extLst>
            </p:cNvPr>
            <p:cNvCxnSpPr>
              <a:cxnSpLocks/>
            </p:cNvCxnSpPr>
            <p:nvPr/>
          </p:nvCxnSpPr>
          <p:spPr>
            <a:xfrm>
              <a:off x="5108133" y="5479666"/>
              <a:ext cx="105371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xmlns="" id="{1C6512AD-D283-475C-ADD7-A065669AA998}"/>
                </a:ext>
              </a:extLst>
            </p:cNvPr>
            <p:cNvCxnSpPr>
              <a:cxnSpLocks/>
            </p:cNvCxnSpPr>
            <p:nvPr/>
          </p:nvCxnSpPr>
          <p:spPr>
            <a:xfrm>
              <a:off x="3413781" y="5484030"/>
              <a:ext cx="1053712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A4D53F52-D6FC-42D2-A6DA-FBE0E6A29CB7}"/>
                </a:ext>
              </a:extLst>
            </p:cNvPr>
            <p:cNvSpPr txBox="1"/>
            <p:nvPr/>
          </p:nvSpPr>
          <p:spPr>
            <a:xfrm>
              <a:off x="6149620" y="5341166"/>
              <a:ext cx="14573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embrane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5CFC354C-A985-4681-8195-ED486EEEF0E5}"/>
                </a:ext>
              </a:extLst>
            </p:cNvPr>
            <p:cNvSpPr txBox="1"/>
            <p:nvPr/>
          </p:nvSpPr>
          <p:spPr>
            <a:xfrm>
              <a:off x="4898569" y="5438856"/>
              <a:ext cx="16787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GPI ancho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118110004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xmlns="" id="{EED4ECBB-43F1-463C-9069-94CDA45F0541}"/>
              </a:ext>
            </a:extLst>
          </p:cNvPr>
          <p:cNvGrpSpPr/>
          <p:nvPr/>
        </p:nvGrpSpPr>
        <p:grpSpPr>
          <a:xfrm>
            <a:off x="2287677" y="575532"/>
            <a:ext cx="4331450" cy="5448029"/>
            <a:chOff x="2287677" y="575532"/>
            <a:chExt cx="4331450" cy="544802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5F810F41-ED4B-4306-B10A-3E15AAB2F7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287677" y="575532"/>
              <a:ext cx="4157890" cy="544802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DE5E5D35-6CF8-4E04-B098-6ABC0D2D7739}"/>
                </a:ext>
              </a:extLst>
            </p:cNvPr>
            <p:cNvSpPr txBox="1"/>
            <p:nvPr/>
          </p:nvSpPr>
          <p:spPr>
            <a:xfrm>
              <a:off x="3063825" y="2678395"/>
              <a:ext cx="750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353A6BF5-7A48-485B-BB65-720BD5E89F41}"/>
                </a:ext>
              </a:extLst>
            </p:cNvPr>
            <p:cNvSpPr txBox="1"/>
            <p:nvPr/>
          </p:nvSpPr>
          <p:spPr>
            <a:xfrm>
              <a:off x="5140909" y="3474390"/>
              <a:ext cx="750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8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FABB2098-9EFC-439F-A1F2-30A8AC1018FA}"/>
                </a:ext>
              </a:extLst>
            </p:cNvPr>
            <p:cNvSpPr txBox="1"/>
            <p:nvPr/>
          </p:nvSpPr>
          <p:spPr>
            <a:xfrm>
              <a:off x="5868727" y="4255572"/>
              <a:ext cx="750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4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84B0B0F5-D24E-43A3-81B9-1C2725A86C23}"/>
                </a:ext>
              </a:extLst>
            </p:cNvPr>
            <p:cNvSpPr txBox="1"/>
            <p:nvPr/>
          </p:nvSpPr>
          <p:spPr>
            <a:xfrm>
              <a:off x="4404722" y="2872741"/>
              <a:ext cx="750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92B79D01-2219-4447-9285-4CF95BA547A2}"/>
                </a:ext>
              </a:extLst>
            </p:cNvPr>
            <p:cNvSpPr txBox="1"/>
            <p:nvPr/>
          </p:nvSpPr>
          <p:spPr>
            <a:xfrm>
              <a:off x="4657201" y="5067097"/>
              <a:ext cx="750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3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A57A8E2F-AA73-4A63-BF44-DA9F86DCD8A1}"/>
                </a:ext>
              </a:extLst>
            </p:cNvPr>
            <p:cNvSpPr txBox="1"/>
            <p:nvPr/>
          </p:nvSpPr>
          <p:spPr>
            <a:xfrm>
              <a:off x="3343775" y="2435492"/>
              <a:ext cx="750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Ca</a:t>
              </a:r>
              <a:r>
                <a:rPr lang="en-GB" sz="1400" b="1" baseline="30000" dirty="0"/>
                <a:t>2+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294B8D78-9997-4A6F-9179-4383C8D04E24}"/>
              </a:ext>
            </a:extLst>
          </p:cNvPr>
          <p:cNvSpPr txBox="1"/>
          <p:nvPr/>
        </p:nvSpPr>
        <p:spPr>
          <a:xfrm>
            <a:off x="769545" y="402218"/>
            <a:ext cx="3101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23. </a:t>
            </a:r>
            <a:r>
              <a:rPr lang="en-GB" b="1" dirty="0"/>
              <a:t>Calpain, </a:t>
            </a:r>
            <a:r>
              <a:rPr lang="en-GB" b="1" dirty="0">
                <a:ea typeface="Calibri" panose="020F0502020204030204" pitchFamily="34" charset="0"/>
              </a:rPr>
              <a:t>Smp_214190 </a:t>
            </a:r>
            <a:endParaRPr lang="en-GB" b="1" dirty="0"/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xmlns="" id="{A70737BB-9DDC-47C9-ADA2-3BC291A92E39}"/>
              </a:ext>
            </a:extLst>
          </p:cNvPr>
          <p:cNvGrpSpPr/>
          <p:nvPr/>
        </p:nvGrpSpPr>
        <p:grpSpPr>
          <a:xfrm>
            <a:off x="552996" y="5750635"/>
            <a:ext cx="2101194" cy="503083"/>
            <a:chOff x="753756" y="5923242"/>
            <a:chExt cx="1771406" cy="461665"/>
          </a:xfrm>
        </p:grpSpPr>
        <p:sp>
          <p:nvSpPr>
            <p:cNvPr id="17" name="Flowchart: Terminator 16">
              <a:extLst>
                <a:ext uri="{FF2B5EF4-FFF2-40B4-BE49-F238E27FC236}">
                  <a16:creationId xmlns:a16="http://schemas.microsoft.com/office/drawing/2014/main" xmlns="" id="{EF9A03A5-95EC-4F1C-8A29-2C054C82162E}"/>
                </a:ext>
              </a:extLst>
            </p:cNvPr>
            <p:cNvSpPr/>
            <p:nvPr/>
          </p:nvSpPr>
          <p:spPr>
            <a:xfrm>
              <a:off x="753756" y="6049025"/>
              <a:ext cx="488888" cy="51652"/>
            </a:xfrm>
            <a:prstGeom prst="flowChartTerminator">
              <a:avLst/>
            </a:prstGeom>
            <a:solidFill>
              <a:srgbClr val="00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Flowchart: Terminator 19">
              <a:extLst>
                <a:ext uri="{FF2B5EF4-FFF2-40B4-BE49-F238E27FC236}">
                  <a16:creationId xmlns:a16="http://schemas.microsoft.com/office/drawing/2014/main" xmlns="" id="{26D08197-B88F-43F3-851B-3C8219C5606E}"/>
                </a:ext>
              </a:extLst>
            </p:cNvPr>
            <p:cNvSpPr/>
            <p:nvPr/>
          </p:nvSpPr>
          <p:spPr>
            <a:xfrm>
              <a:off x="753756" y="6220564"/>
              <a:ext cx="488888" cy="51652"/>
            </a:xfrm>
            <a:prstGeom prst="flowChartTerminator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6522830A-4D75-4AFF-AB8E-52B2475C7487}"/>
                </a:ext>
              </a:extLst>
            </p:cNvPr>
            <p:cNvSpPr txBox="1"/>
            <p:nvPr/>
          </p:nvSpPr>
          <p:spPr>
            <a:xfrm>
              <a:off x="1239570" y="5923242"/>
              <a:ext cx="12855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Active site</a:t>
              </a:r>
            </a:p>
            <a:p>
              <a:r>
                <a:rPr lang="en-GB" sz="1200" dirty="0"/>
                <a:t>Ligand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00AC908F-4D7B-46C2-8249-A24BE2EBE1AC}"/>
              </a:ext>
            </a:extLst>
          </p:cNvPr>
          <p:cNvSpPr txBox="1"/>
          <p:nvPr/>
        </p:nvSpPr>
        <p:spPr>
          <a:xfrm>
            <a:off x="5560001" y="402218"/>
            <a:ext cx="33181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/>
              <a:t>Mapped on</a:t>
            </a:r>
            <a:r>
              <a:rPr lang="en-GB" dirty="0"/>
              <a:t>to PDB </a:t>
            </a:r>
            <a:r>
              <a:rPr lang="en-GB" sz="1800" dirty="0"/>
              <a:t> 1ZCM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4C6767CD-5CD1-407C-A848-F41F5E3E98BF}"/>
              </a:ext>
            </a:extLst>
          </p:cNvPr>
          <p:cNvSpPr txBox="1"/>
          <p:nvPr/>
        </p:nvSpPr>
        <p:spPr>
          <a:xfrm>
            <a:off x="3120975" y="3376064"/>
            <a:ext cx="750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Ca</a:t>
            </a:r>
            <a:r>
              <a:rPr lang="en-GB" sz="1400" b="1" baseline="30000" dirty="0"/>
              <a:t>2+</a:t>
            </a:r>
          </a:p>
        </p:txBody>
      </p:sp>
    </p:spTree>
    <p:extLst>
      <p:ext uri="{BB962C8B-B14F-4D97-AF65-F5344CB8AC3E}">
        <p14:creationId xmlns:p14="http://schemas.microsoft.com/office/powerpoint/2010/main" xmlns="" val="169868252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FF0E7037-3AF3-41AB-BE53-0A40714D9619}"/>
              </a:ext>
            </a:extLst>
          </p:cNvPr>
          <p:cNvSpPr txBox="1"/>
          <p:nvPr/>
        </p:nvSpPr>
        <p:spPr>
          <a:xfrm>
            <a:off x="508825" y="395843"/>
            <a:ext cx="5038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24. </a:t>
            </a:r>
            <a:r>
              <a:rPr lang="en-GB" b="1" dirty="0"/>
              <a:t>TSP2 large extracellular domain, Smp_335630 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EDED2303-CA12-4655-BBE4-6FCBED7A4A65}"/>
              </a:ext>
            </a:extLst>
          </p:cNvPr>
          <p:cNvGrpSpPr/>
          <p:nvPr/>
        </p:nvGrpSpPr>
        <p:grpSpPr>
          <a:xfrm>
            <a:off x="2743980" y="1155702"/>
            <a:ext cx="4078540" cy="4479553"/>
            <a:chOff x="2743980" y="1155702"/>
            <a:chExt cx="4078540" cy="4479553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xmlns="" id="{865B2D35-ACFE-43E8-99D5-E26A5C818410}"/>
                </a:ext>
              </a:extLst>
            </p:cNvPr>
            <p:cNvGrpSpPr/>
            <p:nvPr/>
          </p:nvGrpSpPr>
          <p:grpSpPr>
            <a:xfrm>
              <a:off x="2743980" y="1155702"/>
              <a:ext cx="3997062" cy="4479553"/>
              <a:chOff x="2737684" y="1274191"/>
              <a:chExt cx="2766824" cy="3884350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xmlns="" id="{2233CCCB-2911-4186-A190-1D5B61778B7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2737684" y="1380190"/>
                <a:ext cx="2766824" cy="3778351"/>
              </a:xfrm>
              <a:prstGeom prst="rect">
                <a:avLst/>
              </a:prstGeom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xmlns="" id="{8B6E7F9D-B604-4B39-A6CC-910EFF5BD9EA}"/>
                  </a:ext>
                </a:extLst>
              </p:cNvPr>
              <p:cNvSpPr txBox="1"/>
              <p:nvPr/>
            </p:nvSpPr>
            <p:spPr>
              <a:xfrm>
                <a:off x="3467478" y="3651244"/>
                <a:ext cx="570368" cy="2401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P3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xmlns="" id="{B7DC9E67-EE98-47C9-9683-A88361503EBD}"/>
                  </a:ext>
                </a:extLst>
              </p:cNvPr>
              <p:cNvSpPr txBox="1"/>
              <p:nvPr/>
            </p:nvSpPr>
            <p:spPr>
              <a:xfrm>
                <a:off x="3550728" y="1274191"/>
                <a:ext cx="570368" cy="2401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/>
                  <a:t>P6</a:t>
                </a:r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xmlns="" id="{DC25C8ED-7580-49D4-A318-063E97D37242}"/>
                </a:ext>
              </a:extLst>
            </p:cNvPr>
            <p:cNvGrpSpPr/>
            <p:nvPr/>
          </p:nvGrpSpPr>
          <p:grpSpPr>
            <a:xfrm>
              <a:off x="3366661" y="3777339"/>
              <a:ext cx="3374381" cy="1798417"/>
              <a:chOff x="3175009" y="3429000"/>
              <a:chExt cx="2335795" cy="1559459"/>
            </a:xfrm>
          </p:grpSpPr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xmlns="" id="{92A360FE-E7F2-4E63-870E-96CFCC66781E}"/>
                  </a:ext>
                </a:extLst>
              </p:cNvPr>
              <p:cNvCxnSpPr/>
              <p:nvPr/>
            </p:nvCxnSpPr>
            <p:spPr>
              <a:xfrm flipV="1">
                <a:off x="3175009" y="3429000"/>
                <a:ext cx="2335795" cy="1559459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xmlns="" id="{A6E3A809-8FF8-4C58-9A0B-99BA82307C9D}"/>
                  </a:ext>
                </a:extLst>
              </p:cNvPr>
              <p:cNvSpPr txBox="1"/>
              <p:nvPr/>
            </p:nvSpPr>
            <p:spPr>
              <a:xfrm rot="19638990">
                <a:off x="4029312" y="4121927"/>
                <a:ext cx="104114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Membrane</a:t>
                </a: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294A3210-FAD6-4E81-9D92-2B4AC155FB69}"/>
                </a:ext>
              </a:extLst>
            </p:cNvPr>
            <p:cNvSpPr txBox="1"/>
            <p:nvPr/>
          </p:nvSpPr>
          <p:spPr>
            <a:xfrm>
              <a:off x="5998544" y="2389142"/>
              <a:ext cx="823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P5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F8CC4A23-6063-466F-9B99-86902FF6946B}"/>
                </a:ext>
              </a:extLst>
            </p:cNvPr>
            <p:cNvSpPr txBox="1"/>
            <p:nvPr/>
          </p:nvSpPr>
          <p:spPr>
            <a:xfrm>
              <a:off x="4723668" y="2942161"/>
              <a:ext cx="823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P4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80647820-B7E7-44C6-B8AF-9CE09AA092D0}"/>
              </a:ext>
            </a:extLst>
          </p:cNvPr>
          <p:cNvGrpSpPr/>
          <p:nvPr/>
        </p:nvGrpSpPr>
        <p:grpSpPr>
          <a:xfrm>
            <a:off x="507053" y="5378093"/>
            <a:ext cx="1525932" cy="276999"/>
            <a:chOff x="507053" y="5425718"/>
            <a:chExt cx="1525932" cy="276999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xmlns="" id="{DE10A7C3-5DC3-4AE3-AB17-6349001765F0}"/>
                </a:ext>
              </a:extLst>
            </p:cNvPr>
            <p:cNvGrpSpPr/>
            <p:nvPr/>
          </p:nvGrpSpPr>
          <p:grpSpPr>
            <a:xfrm>
              <a:off x="507053" y="5536075"/>
              <a:ext cx="579906" cy="61083"/>
              <a:chOff x="507053" y="5536075"/>
              <a:chExt cx="579906" cy="61083"/>
            </a:xfrm>
          </p:grpSpPr>
          <p:sp>
            <p:nvSpPr>
              <p:cNvPr id="18" name="Flowchart: Terminator 17">
                <a:extLst>
                  <a:ext uri="{FF2B5EF4-FFF2-40B4-BE49-F238E27FC236}">
                    <a16:creationId xmlns:a16="http://schemas.microsoft.com/office/drawing/2014/main" xmlns="" id="{63DEDDF0-D0C1-4FFB-B43A-DFB6824D82A9}"/>
                  </a:ext>
                </a:extLst>
              </p:cNvPr>
              <p:cNvSpPr/>
              <p:nvPr/>
            </p:nvSpPr>
            <p:spPr>
              <a:xfrm>
                <a:off x="507053" y="5536075"/>
                <a:ext cx="579906" cy="56286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xmlns="" id="{9D747ABD-6C6C-426A-87A8-0A3F6C17FCC6}"/>
                  </a:ext>
                </a:extLst>
              </p:cNvPr>
              <p:cNvSpPr/>
              <p:nvPr/>
            </p:nvSpPr>
            <p:spPr>
              <a:xfrm>
                <a:off x="704850" y="5539747"/>
                <a:ext cx="177800" cy="57411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xmlns="" id="{CF7F1FC0-5241-483A-AA28-36F0B93863B9}"/>
                  </a:ext>
                </a:extLst>
              </p:cNvPr>
              <p:cNvCxnSpPr/>
              <p:nvPr/>
            </p:nvCxnSpPr>
            <p:spPr>
              <a:xfrm>
                <a:off x="624689" y="5592361"/>
                <a:ext cx="293383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125B2871-0818-4BED-9C5A-58615B61D886}"/>
                </a:ext>
              </a:extLst>
            </p:cNvPr>
            <p:cNvSpPr txBox="1"/>
            <p:nvPr/>
          </p:nvSpPr>
          <p:spPr>
            <a:xfrm>
              <a:off x="1100999" y="5425718"/>
              <a:ext cx="93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 - C bridge 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CD8B0778-7299-4AFB-80AA-428C7563543E}"/>
              </a:ext>
            </a:extLst>
          </p:cNvPr>
          <p:cNvSpPr txBox="1"/>
          <p:nvPr/>
        </p:nvSpPr>
        <p:spPr>
          <a:xfrm>
            <a:off x="5379861" y="395843"/>
            <a:ext cx="3255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2M7Z_sele_1</a:t>
            </a:r>
          </a:p>
        </p:txBody>
      </p:sp>
    </p:spTree>
    <p:extLst>
      <p:ext uri="{BB962C8B-B14F-4D97-AF65-F5344CB8AC3E}">
        <p14:creationId xmlns:p14="http://schemas.microsoft.com/office/powerpoint/2010/main" xmlns="" val="291277126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D447146C-25E6-40A9-9F10-1D0AFE2CAF54}"/>
              </a:ext>
            </a:extLst>
          </p:cNvPr>
          <p:cNvSpPr/>
          <p:nvPr/>
        </p:nvSpPr>
        <p:spPr>
          <a:xfrm>
            <a:off x="918072" y="289711"/>
            <a:ext cx="3305576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GB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25. </a:t>
            </a:r>
            <a:r>
              <a:rPr lang="en-GB" b="1" dirty="0">
                <a:ea typeface="Calibri" panose="020F0502020204030204" pitchFamily="34" charset="0"/>
                <a:cs typeface="Times New Roman" panose="02020603050405020304" pitchFamily="18" charset="0"/>
              </a:rPr>
              <a:t>TSP, lung stage, Smp_194970</a:t>
            </a:r>
            <a:endParaRPr lang="en-GB" sz="2800" b="1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9DB948B3-21E7-4802-894B-CF6D62ED0D4D}"/>
              </a:ext>
            </a:extLst>
          </p:cNvPr>
          <p:cNvGrpSpPr/>
          <p:nvPr/>
        </p:nvGrpSpPr>
        <p:grpSpPr>
          <a:xfrm>
            <a:off x="2443072" y="659043"/>
            <a:ext cx="4652321" cy="5370725"/>
            <a:chOff x="2460860" y="911615"/>
            <a:chExt cx="4652321" cy="537072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D850AE8D-5560-4088-AAA1-3679BA11312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460860" y="911615"/>
              <a:ext cx="4652321" cy="5370725"/>
            </a:xfrm>
            <a:prstGeom prst="rect">
              <a:avLst/>
            </a:prstGeom>
          </p:spPr>
        </p:pic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xmlns="" id="{C8651CC5-76A9-4C81-A831-227C5644F3D2}"/>
                </a:ext>
              </a:extLst>
            </p:cNvPr>
            <p:cNvGrpSpPr/>
            <p:nvPr/>
          </p:nvGrpSpPr>
          <p:grpSpPr>
            <a:xfrm rot="278262">
              <a:off x="3817967" y="4139823"/>
              <a:ext cx="2872747" cy="1929381"/>
              <a:chOff x="3175009" y="3429000"/>
              <a:chExt cx="2335795" cy="1559459"/>
            </a:xfrm>
          </p:grpSpPr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xmlns="" id="{477363A9-7916-495E-A49D-82397DD44F96}"/>
                  </a:ext>
                </a:extLst>
              </p:cNvPr>
              <p:cNvCxnSpPr/>
              <p:nvPr/>
            </p:nvCxnSpPr>
            <p:spPr>
              <a:xfrm flipV="1">
                <a:off x="3175009" y="3429000"/>
                <a:ext cx="2335795" cy="1559459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xmlns="" id="{F330539F-26CC-4D30-9FD1-3F4D8379DBF1}"/>
                  </a:ext>
                </a:extLst>
              </p:cNvPr>
              <p:cNvSpPr txBox="1"/>
              <p:nvPr/>
            </p:nvSpPr>
            <p:spPr>
              <a:xfrm rot="19638990">
                <a:off x="4029312" y="4121927"/>
                <a:ext cx="104114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Membrane</a:t>
                </a:r>
              </a:p>
            </p:txBody>
          </p: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2E50B348-9E09-45AA-9A22-3EF41A74C539}"/>
                </a:ext>
              </a:extLst>
            </p:cNvPr>
            <p:cNvSpPr txBox="1"/>
            <p:nvPr/>
          </p:nvSpPr>
          <p:spPr>
            <a:xfrm>
              <a:off x="3277945" y="3412927"/>
              <a:ext cx="9334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FDA76747-A06D-4499-859D-2DC43AF51D91}"/>
                </a:ext>
              </a:extLst>
            </p:cNvPr>
            <p:cNvSpPr txBox="1"/>
            <p:nvPr/>
          </p:nvSpPr>
          <p:spPr>
            <a:xfrm>
              <a:off x="5299711" y="3105150"/>
              <a:ext cx="9334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17E55A3C-D050-4704-BE74-12EBDF89D63A}"/>
                </a:ext>
              </a:extLst>
            </p:cNvPr>
            <p:cNvSpPr txBox="1"/>
            <p:nvPr/>
          </p:nvSpPr>
          <p:spPr>
            <a:xfrm>
              <a:off x="5830561" y="2272757"/>
              <a:ext cx="9334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4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C3F20CD0-39D2-4546-AA10-4E4F740223E5}"/>
                </a:ext>
              </a:extLst>
            </p:cNvPr>
            <p:cNvSpPr txBox="1"/>
            <p:nvPr/>
          </p:nvSpPr>
          <p:spPr>
            <a:xfrm>
              <a:off x="2963620" y="2110334"/>
              <a:ext cx="9334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3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88D9BDBE-1B0D-45E0-8F61-F3D6A307EE9F}"/>
              </a:ext>
            </a:extLst>
          </p:cNvPr>
          <p:cNvGrpSpPr/>
          <p:nvPr/>
        </p:nvGrpSpPr>
        <p:grpSpPr>
          <a:xfrm>
            <a:off x="507053" y="5378093"/>
            <a:ext cx="1525932" cy="276999"/>
            <a:chOff x="507053" y="5425718"/>
            <a:chExt cx="1525932" cy="276999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xmlns="" id="{2CD8B8B9-D18D-401A-81BF-2E189CA138A0}"/>
                </a:ext>
              </a:extLst>
            </p:cNvPr>
            <p:cNvGrpSpPr/>
            <p:nvPr/>
          </p:nvGrpSpPr>
          <p:grpSpPr>
            <a:xfrm>
              <a:off x="507053" y="5536075"/>
              <a:ext cx="579906" cy="61083"/>
              <a:chOff x="507053" y="5536075"/>
              <a:chExt cx="579906" cy="61083"/>
            </a:xfrm>
          </p:grpSpPr>
          <p:sp>
            <p:nvSpPr>
              <p:cNvPr id="19" name="Flowchart: Terminator 18">
                <a:extLst>
                  <a:ext uri="{FF2B5EF4-FFF2-40B4-BE49-F238E27FC236}">
                    <a16:creationId xmlns:a16="http://schemas.microsoft.com/office/drawing/2014/main" xmlns="" id="{C91E3ED6-DE59-4D07-B658-22E655D439BF}"/>
                  </a:ext>
                </a:extLst>
              </p:cNvPr>
              <p:cNvSpPr/>
              <p:nvPr/>
            </p:nvSpPr>
            <p:spPr>
              <a:xfrm>
                <a:off x="507053" y="5536075"/>
                <a:ext cx="579906" cy="56286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xmlns="" id="{386FED7C-E168-402B-AA08-D09A4A4B8804}"/>
                  </a:ext>
                </a:extLst>
              </p:cNvPr>
              <p:cNvSpPr/>
              <p:nvPr/>
            </p:nvSpPr>
            <p:spPr>
              <a:xfrm>
                <a:off x="704850" y="5539747"/>
                <a:ext cx="177800" cy="57411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xmlns="" id="{07B7BCB4-49B5-4FFB-9955-6AB5968F8559}"/>
                  </a:ext>
                </a:extLst>
              </p:cNvPr>
              <p:cNvCxnSpPr/>
              <p:nvPr/>
            </p:nvCxnSpPr>
            <p:spPr>
              <a:xfrm>
                <a:off x="624689" y="5592361"/>
                <a:ext cx="293383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8D30DBE9-4463-4295-B87A-ABF92A9E23B1}"/>
                </a:ext>
              </a:extLst>
            </p:cNvPr>
            <p:cNvSpPr txBox="1"/>
            <p:nvPr/>
          </p:nvSpPr>
          <p:spPr>
            <a:xfrm>
              <a:off x="1100999" y="5425718"/>
              <a:ext cx="93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 - C bridge 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3874FAD-A222-4C2F-B485-B59C68C7C7A9}"/>
              </a:ext>
            </a:extLst>
          </p:cNvPr>
          <p:cNvSpPr txBox="1"/>
          <p:nvPr/>
        </p:nvSpPr>
        <p:spPr>
          <a:xfrm>
            <a:off x="5428517" y="289711"/>
            <a:ext cx="3305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2M7Z_sele_1</a:t>
            </a:r>
          </a:p>
        </p:txBody>
      </p:sp>
    </p:spTree>
    <p:extLst>
      <p:ext uri="{BB962C8B-B14F-4D97-AF65-F5344CB8AC3E}">
        <p14:creationId xmlns:p14="http://schemas.microsoft.com/office/powerpoint/2010/main" xmlns="" val="171021014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xmlns="" id="{34FBBFA1-E368-4E54-BECC-1C4B314F85E4}"/>
              </a:ext>
            </a:extLst>
          </p:cNvPr>
          <p:cNvGrpSpPr/>
          <p:nvPr/>
        </p:nvGrpSpPr>
        <p:grpSpPr>
          <a:xfrm>
            <a:off x="1881380" y="652434"/>
            <a:ext cx="4397496" cy="5336485"/>
            <a:chOff x="1881380" y="652434"/>
            <a:chExt cx="4397496" cy="5336485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xmlns="" id="{A2B44636-409F-41E4-8CBF-8D6B917BED4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881380" y="652434"/>
              <a:ext cx="4075413" cy="5336485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9F4916E6-87EB-4705-85DB-4EBEEE4B1814}"/>
                </a:ext>
              </a:extLst>
            </p:cNvPr>
            <p:cNvSpPr txBox="1"/>
            <p:nvPr/>
          </p:nvSpPr>
          <p:spPr>
            <a:xfrm>
              <a:off x="5486396" y="3187996"/>
              <a:ext cx="7924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7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DDB17251-912F-4E09-9E1A-FD7BBD7CE567}"/>
                </a:ext>
              </a:extLst>
            </p:cNvPr>
            <p:cNvSpPr txBox="1"/>
            <p:nvPr/>
          </p:nvSpPr>
          <p:spPr>
            <a:xfrm>
              <a:off x="2937548" y="2432264"/>
              <a:ext cx="7924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BD9133BC-FD46-4063-8AA9-51454226DF0D}"/>
                </a:ext>
              </a:extLst>
            </p:cNvPr>
            <p:cNvSpPr txBox="1"/>
            <p:nvPr/>
          </p:nvSpPr>
          <p:spPr>
            <a:xfrm>
              <a:off x="5000414" y="3944435"/>
              <a:ext cx="7924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9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D0ED859-B5E5-49CB-919A-40DD429C9C52}"/>
              </a:ext>
            </a:extLst>
          </p:cNvPr>
          <p:cNvSpPr txBox="1"/>
          <p:nvPr/>
        </p:nvSpPr>
        <p:spPr>
          <a:xfrm>
            <a:off x="627674" y="289711"/>
            <a:ext cx="3177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26. </a:t>
            </a:r>
            <a:r>
              <a:rPr lang="en-GB" b="1" dirty="0"/>
              <a:t>Annexin, Smp_074150 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4D5FC081-122D-4BDF-B647-F90362A41A2F}"/>
              </a:ext>
            </a:extLst>
          </p:cNvPr>
          <p:cNvGrpSpPr/>
          <p:nvPr/>
        </p:nvGrpSpPr>
        <p:grpSpPr>
          <a:xfrm>
            <a:off x="6072369" y="828504"/>
            <a:ext cx="2860178" cy="2972946"/>
            <a:chOff x="5796144" y="599904"/>
            <a:chExt cx="2860178" cy="2972946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D05B9627-B650-4DA6-AEB4-D6F0AF04CA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 rot="21038730">
              <a:off x="5796144" y="599904"/>
              <a:ext cx="2860178" cy="2972946"/>
            </a:xfrm>
            <a:prstGeom prst="rect">
              <a:avLst/>
            </a:prstGeom>
          </p:spPr>
        </p:pic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xmlns="" id="{9B3D1303-87AE-4650-9B04-8D733571BC0A}"/>
                </a:ext>
              </a:extLst>
            </p:cNvPr>
            <p:cNvCxnSpPr/>
            <p:nvPr/>
          </p:nvCxnSpPr>
          <p:spPr>
            <a:xfrm flipH="1" flipV="1">
              <a:off x="7248525" y="2286000"/>
              <a:ext cx="114300" cy="51435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1ECA5B0D-26C4-4E3C-A11C-890D1AC1004F}"/>
                </a:ext>
              </a:extLst>
            </p:cNvPr>
            <p:cNvSpPr txBox="1"/>
            <p:nvPr/>
          </p:nvSpPr>
          <p:spPr>
            <a:xfrm>
              <a:off x="7226233" y="2800350"/>
              <a:ext cx="14001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Inter dimer link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27E2ED6F-01D7-4673-BF9D-EF285FB8A6D7}"/>
              </a:ext>
            </a:extLst>
          </p:cNvPr>
          <p:cNvGrpSpPr/>
          <p:nvPr/>
        </p:nvGrpSpPr>
        <p:grpSpPr>
          <a:xfrm>
            <a:off x="623935" y="5013872"/>
            <a:ext cx="894069" cy="307777"/>
            <a:chOff x="623935" y="5013872"/>
            <a:chExt cx="894069" cy="307777"/>
          </a:xfrm>
        </p:grpSpPr>
        <p:sp>
          <p:nvSpPr>
            <p:cNvPr id="16" name="Oval 15">
              <a:extLst>
                <a:ext uri="{FF2B5EF4-FFF2-40B4-BE49-F238E27FC236}">
                  <a16:creationId xmlns:a16="http://schemas.microsoft.com/office/drawing/2014/main" xmlns="" id="{BD3A9A2A-31B1-4D18-A905-878D0F2425EB}"/>
                </a:ext>
              </a:extLst>
            </p:cNvPr>
            <p:cNvSpPr/>
            <p:nvPr/>
          </p:nvSpPr>
          <p:spPr>
            <a:xfrm>
              <a:off x="630774" y="5013872"/>
              <a:ext cx="287079" cy="307777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xmlns="" id="{C6D6826B-9659-40D3-91D2-8C7DA998DACD}"/>
                </a:ext>
              </a:extLst>
            </p:cNvPr>
            <p:cNvSpPr/>
            <p:nvPr/>
          </p:nvSpPr>
          <p:spPr>
            <a:xfrm>
              <a:off x="623935" y="5013872"/>
              <a:ext cx="287079" cy="307777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9E6425CD-756A-417A-ADFB-BDE6F3B19EDC}"/>
                </a:ext>
              </a:extLst>
            </p:cNvPr>
            <p:cNvSpPr txBox="1"/>
            <p:nvPr/>
          </p:nvSpPr>
          <p:spPr>
            <a:xfrm>
              <a:off x="883068" y="5017320"/>
              <a:ext cx="6349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Ca</a:t>
              </a:r>
              <a:r>
                <a:rPr lang="en-GB" sz="1200" b="1" baseline="30000" dirty="0"/>
                <a:t>2+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3C45E613-A3EF-407A-9E1E-78F0CDEB33F0}"/>
              </a:ext>
            </a:extLst>
          </p:cNvPr>
          <p:cNvSpPr txBox="1"/>
          <p:nvPr/>
        </p:nvSpPr>
        <p:spPr>
          <a:xfrm>
            <a:off x="5428518" y="289711"/>
            <a:ext cx="3124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4MDV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xmlns="" id="{4B1B5356-A26E-4E09-A0E8-D4A89A76B1C6}"/>
              </a:ext>
            </a:extLst>
          </p:cNvPr>
          <p:cNvGrpSpPr/>
          <p:nvPr/>
        </p:nvGrpSpPr>
        <p:grpSpPr>
          <a:xfrm>
            <a:off x="552261" y="5523488"/>
            <a:ext cx="2570884" cy="646331"/>
            <a:chOff x="552261" y="5523488"/>
            <a:chExt cx="2570884" cy="646331"/>
          </a:xfrm>
        </p:grpSpPr>
        <p:sp>
          <p:nvSpPr>
            <p:cNvPr id="7" name="Flowchart: Terminator 6">
              <a:extLst>
                <a:ext uri="{FF2B5EF4-FFF2-40B4-BE49-F238E27FC236}">
                  <a16:creationId xmlns:a16="http://schemas.microsoft.com/office/drawing/2014/main" xmlns="" id="{043ABE96-67F8-470F-A90A-34079801A245}"/>
                </a:ext>
              </a:extLst>
            </p:cNvPr>
            <p:cNvSpPr/>
            <p:nvPr/>
          </p:nvSpPr>
          <p:spPr>
            <a:xfrm>
              <a:off x="552261" y="5997925"/>
              <a:ext cx="689518" cy="63374"/>
            </a:xfrm>
            <a:prstGeom prst="flowChartTerminator">
              <a:avLst/>
            </a:prstGeom>
            <a:solidFill>
              <a:srgbClr val="00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Flowchart: Terminator 7">
              <a:extLst>
                <a:ext uri="{FF2B5EF4-FFF2-40B4-BE49-F238E27FC236}">
                  <a16:creationId xmlns:a16="http://schemas.microsoft.com/office/drawing/2014/main" xmlns="" id="{E5D12B01-6644-49A4-B5A1-81CE59819BE1}"/>
                </a:ext>
              </a:extLst>
            </p:cNvPr>
            <p:cNvSpPr/>
            <p:nvPr/>
          </p:nvSpPr>
          <p:spPr>
            <a:xfrm>
              <a:off x="552261" y="5630383"/>
              <a:ext cx="689518" cy="63374"/>
            </a:xfrm>
            <a:prstGeom prst="flowChartTerminator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Flowchart: Terminator 8">
              <a:extLst>
                <a:ext uri="{FF2B5EF4-FFF2-40B4-BE49-F238E27FC236}">
                  <a16:creationId xmlns:a16="http://schemas.microsoft.com/office/drawing/2014/main" xmlns="" id="{1A0072A6-CAB5-4423-8A8D-9B9FD4CADF60}"/>
                </a:ext>
              </a:extLst>
            </p:cNvPr>
            <p:cNvSpPr/>
            <p:nvPr/>
          </p:nvSpPr>
          <p:spPr>
            <a:xfrm>
              <a:off x="552261" y="5823106"/>
              <a:ext cx="689518" cy="63374"/>
            </a:xfrm>
            <a:prstGeom prst="flowChartTerminator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7BD8B8AA-E0ED-46FD-BA37-6A402670FC05}"/>
                </a:ext>
              </a:extLst>
            </p:cNvPr>
            <p:cNvSpPr txBox="1"/>
            <p:nvPr/>
          </p:nvSpPr>
          <p:spPr>
            <a:xfrm>
              <a:off x="1309972" y="5523488"/>
              <a:ext cx="181317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Membrane binding</a:t>
              </a:r>
            </a:p>
            <a:p>
              <a:r>
                <a:rPr lang="en-GB" sz="1200" dirty="0"/>
                <a:t>Calcium binding</a:t>
              </a:r>
            </a:p>
            <a:p>
              <a:r>
                <a:rPr lang="en-GB" sz="1200" dirty="0"/>
                <a:t>Inter dimer </a:t>
              </a:r>
              <a:r>
                <a:rPr lang="en-GB" sz="1200" dirty="0" err="1"/>
                <a:t>Cys</a:t>
              </a:r>
              <a:endParaRPr lang="en-GB" sz="1200" dirty="0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xmlns="" id="{E6F1CE98-ADF3-42E8-BBD7-9FEB81E569CD}"/>
                </a:ext>
              </a:extLst>
            </p:cNvPr>
            <p:cNvSpPr/>
            <p:nvPr/>
          </p:nvSpPr>
          <p:spPr>
            <a:xfrm>
              <a:off x="808120" y="6002491"/>
              <a:ext cx="177800" cy="56403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xmlns="" val="399540728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1466447D-5D93-4B16-8D66-DC31BB235ED0}"/>
              </a:ext>
            </a:extLst>
          </p:cNvPr>
          <p:cNvGrpSpPr/>
          <p:nvPr/>
        </p:nvGrpSpPr>
        <p:grpSpPr>
          <a:xfrm>
            <a:off x="2860689" y="824838"/>
            <a:ext cx="3901058" cy="5367227"/>
            <a:chOff x="2860689" y="584200"/>
            <a:chExt cx="3901058" cy="536722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65508ED3-1B3C-4EBC-9B55-1B0CF662580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860689" y="584200"/>
              <a:ext cx="3901058" cy="5367227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D91C1A6B-1108-4DB2-840B-7790DD364D04}"/>
                </a:ext>
              </a:extLst>
            </p:cNvPr>
            <p:cNvSpPr txBox="1"/>
            <p:nvPr/>
          </p:nvSpPr>
          <p:spPr>
            <a:xfrm>
              <a:off x="3259765" y="2063932"/>
              <a:ext cx="47026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B26EAFFA-E926-495B-BAB3-4E45DF8DD1B7}"/>
                </a:ext>
              </a:extLst>
            </p:cNvPr>
            <p:cNvSpPr txBox="1"/>
            <p:nvPr/>
          </p:nvSpPr>
          <p:spPr>
            <a:xfrm>
              <a:off x="5789605" y="4101615"/>
              <a:ext cx="47026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802C4C56-241B-4E6E-B858-39AFC4A287B2}"/>
                </a:ext>
              </a:extLst>
            </p:cNvPr>
            <p:cNvSpPr txBox="1"/>
            <p:nvPr/>
          </p:nvSpPr>
          <p:spPr>
            <a:xfrm>
              <a:off x="4170347" y="739624"/>
              <a:ext cx="47026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3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8659E149-33A5-405C-8134-FF3B1C3F0998}"/>
              </a:ext>
            </a:extLst>
          </p:cNvPr>
          <p:cNvSpPr txBox="1"/>
          <p:nvPr/>
        </p:nvSpPr>
        <p:spPr>
          <a:xfrm>
            <a:off x="623935" y="289711"/>
            <a:ext cx="3177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27. </a:t>
            </a:r>
            <a:r>
              <a:rPr lang="en-GB" b="1" dirty="0"/>
              <a:t>Annexin, Smp_07414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5E91069D-EB40-4DF3-8BC6-3AD14DB4AF4C}"/>
              </a:ext>
            </a:extLst>
          </p:cNvPr>
          <p:cNvSpPr txBox="1"/>
          <p:nvPr/>
        </p:nvSpPr>
        <p:spPr>
          <a:xfrm>
            <a:off x="5060887" y="6197682"/>
            <a:ext cx="40831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No </a:t>
            </a:r>
            <a:r>
              <a:rPr lang="en-GB" sz="1400" dirty="0" err="1"/>
              <a:t>Cys</a:t>
            </a:r>
            <a:r>
              <a:rPr lang="en-GB" sz="1400" dirty="0"/>
              <a:t> at position 175 to form inter dimer C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xmlns="" id="{7F8EA2F6-CD75-40D9-9DB8-7F7801B28746}"/>
              </a:ext>
            </a:extLst>
          </p:cNvPr>
          <p:cNvGrpSpPr/>
          <p:nvPr/>
        </p:nvGrpSpPr>
        <p:grpSpPr>
          <a:xfrm>
            <a:off x="552261" y="5523488"/>
            <a:ext cx="2570884" cy="461665"/>
            <a:chOff x="552261" y="5523488"/>
            <a:chExt cx="2570884" cy="461665"/>
          </a:xfrm>
        </p:grpSpPr>
        <p:sp>
          <p:nvSpPr>
            <p:cNvPr id="24" name="Flowchart: Terminator 23">
              <a:extLst>
                <a:ext uri="{FF2B5EF4-FFF2-40B4-BE49-F238E27FC236}">
                  <a16:creationId xmlns:a16="http://schemas.microsoft.com/office/drawing/2014/main" xmlns="" id="{3B939354-1E40-4911-BAC7-1E3D61616E47}"/>
                </a:ext>
              </a:extLst>
            </p:cNvPr>
            <p:cNvSpPr/>
            <p:nvPr/>
          </p:nvSpPr>
          <p:spPr>
            <a:xfrm>
              <a:off x="552261" y="5630383"/>
              <a:ext cx="689518" cy="63374"/>
            </a:xfrm>
            <a:prstGeom prst="flowChartTerminator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Flowchart: Terminator 24">
              <a:extLst>
                <a:ext uri="{FF2B5EF4-FFF2-40B4-BE49-F238E27FC236}">
                  <a16:creationId xmlns:a16="http://schemas.microsoft.com/office/drawing/2014/main" xmlns="" id="{182FDAEB-C748-4BAD-9FC1-9EB5B8D7975C}"/>
                </a:ext>
              </a:extLst>
            </p:cNvPr>
            <p:cNvSpPr/>
            <p:nvPr/>
          </p:nvSpPr>
          <p:spPr>
            <a:xfrm>
              <a:off x="552261" y="5823106"/>
              <a:ext cx="689518" cy="63374"/>
            </a:xfrm>
            <a:prstGeom prst="flowChartTerminator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8250273B-E907-4363-BE67-6A72762FDF92}"/>
                </a:ext>
              </a:extLst>
            </p:cNvPr>
            <p:cNvSpPr txBox="1"/>
            <p:nvPr/>
          </p:nvSpPr>
          <p:spPr>
            <a:xfrm>
              <a:off x="1309972" y="5523488"/>
              <a:ext cx="181317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Membrane binding</a:t>
              </a:r>
            </a:p>
            <a:p>
              <a:r>
                <a:rPr lang="en-GB" sz="1200" dirty="0"/>
                <a:t>Calcium binding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xmlns="" id="{225F3080-31CD-485D-A51D-E831E4670724}"/>
              </a:ext>
            </a:extLst>
          </p:cNvPr>
          <p:cNvGrpSpPr/>
          <p:nvPr/>
        </p:nvGrpSpPr>
        <p:grpSpPr>
          <a:xfrm>
            <a:off x="623935" y="5013872"/>
            <a:ext cx="894069" cy="307777"/>
            <a:chOff x="623935" y="5013872"/>
            <a:chExt cx="894069" cy="307777"/>
          </a:xfrm>
        </p:grpSpPr>
        <p:sp>
          <p:nvSpPr>
            <p:cNvPr id="28" name="Oval 27">
              <a:extLst>
                <a:ext uri="{FF2B5EF4-FFF2-40B4-BE49-F238E27FC236}">
                  <a16:creationId xmlns:a16="http://schemas.microsoft.com/office/drawing/2014/main" xmlns="" id="{A6821AD2-36A1-4D4D-A14B-39995843778C}"/>
                </a:ext>
              </a:extLst>
            </p:cNvPr>
            <p:cNvSpPr/>
            <p:nvPr/>
          </p:nvSpPr>
          <p:spPr>
            <a:xfrm>
              <a:off x="630774" y="5013872"/>
              <a:ext cx="287079" cy="307777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9" name="Oval 28">
              <a:extLst>
                <a:ext uri="{FF2B5EF4-FFF2-40B4-BE49-F238E27FC236}">
                  <a16:creationId xmlns:a16="http://schemas.microsoft.com/office/drawing/2014/main" xmlns="" id="{CA472AE0-EF78-46EE-A746-F5BB63AD199A}"/>
                </a:ext>
              </a:extLst>
            </p:cNvPr>
            <p:cNvSpPr/>
            <p:nvPr/>
          </p:nvSpPr>
          <p:spPr>
            <a:xfrm>
              <a:off x="623935" y="5013872"/>
              <a:ext cx="287079" cy="307777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CAEEF599-CCB4-4C10-A6B1-D83F16788808}"/>
                </a:ext>
              </a:extLst>
            </p:cNvPr>
            <p:cNvSpPr txBox="1"/>
            <p:nvPr/>
          </p:nvSpPr>
          <p:spPr>
            <a:xfrm>
              <a:off x="883068" y="5017320"/>
              <a:ext cx="6349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Ca</a:t>
              </a:r>
              <a:r>
                <a:rPr lang="en-GB" sz="1200" b="1" baseline="30000" dirty="0"/>
                <a:t>2+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0B84C1C8-6203-420F-8793-2BD0DDB329DB}"/>
              </a:ext>
            </a:extLst>
          </p:cNvPr>
          <p:cNvSpPr txBox="1"/>
          <p:nvPr/>
        </p:nvSpPr>
        <p:spPr>
          <a:xfrm>
            <a:off x="5428518" y="289711"/>
            <a:ext cx="3124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4MDV</a:t>
            </a:r>
          </a:p>
        </p:txBody>
      </p:sp>
    </p:spTree>
    <p:extLst>
      <p:ext uri="{BB962C8B-B14F-4D97-AF65-F5344CB8AC3E}">
        <p14:creationId xmlns:p14="http://schemas.microsoft.com/office/powerpoint/2010/main" xmlns="" val="8457635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F0D9C103-13D5-46C9-B982-48C728E2F2B1}"/>
              </a:ext>
            </a:extLst>
          </p:cNvPr>
          <p:cNvGrpSpPr/>
          <p:nvPr/>
        </p:nvGrpSpPr>
        <p:grpSpPr>
          <a:xfrm>
            <a:off x="2755232" y="578491"/>
            <a:ext cx="4334236" cy="5627746"/>
            <a:chOff x="2755232" y="458171"/>
            <a:chExt cx="4334236" cy="5627746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21E1878C-6820-42A9-AE63-9CB9AC668CA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755232" y="458171"/>
              <a:ext cx="4293762" cy="5627746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xmlns="" id="{0532DB55-32A5-42AD-83DA-892970DB3A8F}"/>
                </a:ext>
              </a:extLst>
            </p:cNvPr>
            <p:cNvSpPr txBox="1"/>
            <p:nvPr/>
          </p:nvSpPr>
          <p:spPr>
            <a:xfrm>
              <a:off x="3730028" y="3892731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2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96DFA9A0-6892-45EB-A85E-D24084D88B9A}"/>
                </a:ext>
              </a:extLst>
            </p:cNvPr>
            <p:cNvSpPr txBox="1"/>
            <p:nvPr/>
          </p:nvSpPr>
          <p:spPr>
            <a:xfrm>
              <a:off x="6479868" y="2643052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D3AB238D-2ABD-40D1-9C07-078FB823F9D8}"/>
                </a:ext>
              </a:extLst>
            </p:cNvPr>
            <p:cNvSpPr txBox="1"/>
            <p:nvPr/>
          </p:nvSpPr>
          <p:spPr>
            <a:xfrm>
              <a:off x="6022668" y="1181059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6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A29B91BB-84A9-4750-8D99-F0EBAF9EE9E7}"/>
                </a:ext>
              </a:extLst>
            </p:cNvPr>
            <p:cNvSpPr txBox="1"/>
            <p:nvPr/>
          </p:nvSpPr>
          <p:spPr>
            <a:xfrm>
              <a:off x="6193176" y="4018166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8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E1A4347B-FABB-4E84-8E33-BA2E1D3111A3}"/>
                </a:ext>
              </a:extLst>
            </p:cNvPr>
            <p:cNvSpPr txBox="1"/>
            <p:nvPr/>
          </p:nvSpPr>
          <p:spPr>
            <a:xfrm>
              <a:off x="5344090" y="4388280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A6651D76-8542-450D-8DFD-810C56FC0CBE}"/>
                </a:ext>
              </a:extLst>
            </p:cNvPr>
            <p:cNvSpPr txBox="1"/>
            <p:nvPr/>
          </p:nvSpPr>
          <p:spPr>
            <a:xfrm>
              <a:off x="3011571" y="3171726"/>
              <a:ext cx="609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</a:t>
              </a: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xmlns="" id="{01AAAC77-950B-4996-AB10-8AADD9265512}"/>
              </a:ext>
            </a:extLst>
          </p:cNvPr>
          <p:cNvGrpSpPr/>
          <p:nvPr/>
        </p:nvGrpSpPr>
        <p:grpSpPr>
          <a:xfrm>
            <a:off x="552261" y="5523488"/>
            <a:ext cx="2570884" cy="461665"/>
            <a:chOff x="552261" y="5523488"/>
            <a:chExt cx="2570884" cy="461665"/>
          </a:xfrm>
        </p:grpSpPr>
        <p:sp>
          <p:nvSpPr>
            <p:cNvPr id="24" name="Flowchart: Terminator 23">
              <a:extLst>
                <a:ext uri="{FF2B5EF4-FFF2-40B4-BE49-F238E27FC236}">
                  <a16:creationId xmlns:a16="http://schemas.microsoft.com/office/drawing/2014/main" xmlns="" id="{5737C143-E49D-46FC-999C-1E2F4186D2B8}"/>
                </a:ext>
              </a:extLst>
            </p:cNvPr>
            <p:cNvSpPr/>
            <p:nvPr/>
          </p:nvSpPr>
          <p:spPr>
            <a:xfrm>
              <a:off x="552261" y="5630383"/>
              <a:ext cx="689518" cy="63374"/>
            </a:xfrm>
            <a:prstGeom prst="flowChartTerminator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Flowchart: Terminator 24">
              <a:extLst>
                <a:ext uri="{FF2B5EF4-FFF2-40B4-BE49-F238E27FC236}">
                  <a16:creationId xmlns:a16="http://schemas.microsoft.com/office/drawing/2014/main" xmlns="" id="{32E9AF1A-7CD1-4889-820D-275BC4AA602B}"/>
                </a:ext>
              </a:extLst>
            </p:cNvPr>
            <p:cNvSpPr/>
            <p:nvPr/>
          </p:nvSpPr>
          <p:spPr>
            <a:xfrm>
              <a:off x="552261" y="5823106"/>
              <a:ext cx="689518" cy="63374"/>
            </a:xfrm>
            <a:prstGeom prst="flowChartTerminator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11B1AA0B-B6E2-4A70-A74A-A443FCDEC39B}"/>
                </a:ext>
              </a:extLst>
            </p:cNvPr>
            <p:cNvSpPr txBox="1"/>
            <p:nvPr/>
          </p:nvSpPr>
          <p:spPr>
            <a:xfrm>
              <a:off x="1309972" y="5523488"/>
              <a:ext cx="181317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Membrane binding</a:t>
              </a:r>
            </a:p>
            <a:p>
              <a:r>
                <a:rPr lang="en-GB" sz="1200" dirty="0"/>
                <a:t>Calcium binding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xmlns="" id="{8D145FBF-2D9F-4775-924C-DBEA8E4C4278}"/>
              </a:ext>
            </a:extLst>
          </p:cNvPr>
          <p:cNvGrpSpPr/>
          <p:nvPr/>
        </p:nvGrpSpPr>
        <p:grpSpPr>
          <a:xfrm>
            <a:off x="623935" y="5013872"/>
            <a:ext cx="894069" cy="307777"/>
            <a:chOff x="623935" y="5013872"/>
            <a:chExt cx="894069" cy="307777"/>
          </a:xfrm>
        </p:grpSpPr>
        <p:sp>
          <p:nvSpPr>
            <p:cNvPr id="28" name="Oval 27">
              <a:extLst>
                <a:ext uri="{FF2B5EF4-FFF2-40B4-BE49-F238E27FC236}">
                  <a16:creationId xmlns:a16="http://schemas.microsoft.com/office/drawing/2014/main" xmlns="" id="{B0CB0E23-576D-46A7-BF56-7F2E97638B93}"/>
                </a:ext>
              </a:extLst>
            </p:cNvPr>
            <p:cNvSpPr/>
            <p:nvPr/>
          </p:nvSpPr>
          <p:spPr>
            <a:xfrm>
              <a:off x="630774" y="5013872"/>
              <a:ext cx="287079" cy="307777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9" name="Oval 28">
              <a:extLst>
                <a:ext uri="{FF2B5EF4-FFF2-40B4-BE49-F238E27FC236}">
                  <a16:creationId xmlns:a16="http://schemas.microsoft.com/office/drawing/2014/main" xmlns="" id="{9C37AAD8-4B80-4951-96ED-F2216C4A07A4}"/>
                </a:ext>
              </a:extLst>
            </p:cNvPr>
            <p:cNvSpPr/>
            <p:nvPr/>
          </p:nvSpPr>
          <p:spPr>
            <a:xfrm>
              <a:off x="623935" y="5013872"/>
              <a:ext cx="287079" cy="307777"/>
            </a:xfrm>
            <a:prstGeom prst="ellipse">
              <a:avLst/>
            </a:prstGeom>
            <a:solidFill>
              <a:schemeClr val="bg2">
                <a:lumMod val="50000"/>
              </a:schemeClr>
            </a:solidFill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964600AD-2419-471D-8EF4-CC254A2A970C}"/>
                </a:ext>
              </a:extLst>
            </p:cNvPr>
            <p:cNvSpPr txBox="1"/>
            <p:nvPr/>
          </p:nvSpPr>
          <p:spPr>
            <a:xfrm>
              <a:off x="883068" y="5017320"/>
              <a:ext cx="6349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/>
                <a:t>Ca</a:t>
              </a:r>
              <a:r>
                <a:rPr lang="en-GB" sz="1200" b="1" baseline="30000" dirty="0"/>
                <a:t>2+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E9C546FA-05B5-496B-9B51-4EEE7F2C11E3}"/>
              </a:ext>
            </a:extLst>
          </p:cNvPr>
          <p:cNvSpPr txBox="1"/>
          <p:nvPr/>
        </p:nvSpPr>
        <p:spPr>
          <a:xfrm>
            <a:off x="5428518" y="397999"/>
            <a:ext cx="3124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4MDV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B2E46C32-E774-45D6-82F4-E30312497E5D}"/>
              </a:ext>
            </a:extLst>
          </p:cNvPr>
          <p:cNvSpPr txBox="1"/>
          <p:nvPr/>
        </p:nvSpPr>
        <p:spPr>
          <a:xfrm>
            <a:off x="623935" y="397999"/>
            <a:ext cx="31777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28. </a:t>
            </a:r>
            <a:r>
              <a:rPr lang="en-GB" b="1" dirty="0"/>
              <a:t>Annexin, Smp_077720 </a:t>
            </a:r>
          </a:p>
        </p:txBody>
      </p:sp>
    </p:spTree>
    <p:extLst>
      <p:ext uri="{BB962C8B-B14F-4D97-AF65-F5344CB8AC3E}">
        <p14:creationId xmlns:p14="http://schemas.microsoft.com/office/powerpoint/2010/main" xmlns="" val="19905479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xmlns="" id="{8ED9A853-C461-4E66-A310-34D923F3B3BD}"/>
              </a:ext>
            </a:extLst>
          </p:cNvPr>
          <p:cNvGrpSpPr/>
          <p:nvPr/>
        </p:nvGrpSpPr>
        <p:grpSpPr>
          <a:xfrm>
            <a:off x="2546903" y="1054024"/>
            <a:ext cx="5213466" cy="5135827"/>
            <a:chOff x="2546903" y="1054024"/>
            <a:chExt cx="5213466" cy="5135827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D7307044-CFDF-4CB3-9C67-6594A19B8C9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546903" y="1054024"/>
              <a:ext cx="5213466" cy="5011569"/>
            </a:xfrm>
            <a:prstGeom prst="rect">
              <a:avLst/>
            </a:prstGeom>
          </p:spPr>
        </p:pic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xmlns="" id="{3E9D675F-7BC3-4D01-B49C-C215F614B830}"/>
                </a:ext>
              </a:extLst>
            </p:cNvPr>
            <p:cNvCxnSpPr/>
            <p:nvPr/>
          </p:nvCxnSpPr>
          <p:spPr>
            <a:xfrm>
              <a:off x="5050022" y="5477969"/>
              <a:ext cx="0" cy="632006"/>
            </a:xfrm>
            <a:prstGeom prst="line">
              <a:avLst/>
            </a:prstGeom>
            <a:ln w="28575">
              <a:solidFill>
                <a:schemeClr val="bg2">
                  <a:lumMod val="50000"/>
                </a:schemeClr>
              </a:solidFill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2501F97C-DADD-4D33-BC6E-9C416265EB40}"/>
                </a:ext>
              </a:extLst>
            </p:cNvPr>
            <p:cNvSpPr txBox="1"/>
            <p:nvPr/>
          </p:nvSpPr>
          <p:spPr>
            <a:xfrm>
              <a:off x="2968863" y="3503858"/>
              <a:ext cx="1064780" cy="279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381C9161-0EDA-4C52-B016-6D3C68A079FC}"/>
                </a:ext>
              </a:extLst>
            </p:cNvPr>
            <p:cNvSpPr txBox="1"/>
            <p:nvPr/>
          </p:nvSpPr>
          <p:spPr>
            <a:xfrm>
              <a:off x="3941244" y="5609478"/>
              <a:ext cx="1064780" cy="279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4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6FAFF54C-C7C4-4F8D-BABB-1EBF3627ABE4}"/>
                </a:ext>
              </a:extLst>
            </p:cNvPr>
            <p:cNvSpPr txBox="1"/>
            <p:nvPr/>
          </p:nvSpPr>
          <p:spPr>
            <a:xfrm>
              <a:off x="5153636" y="5882074"/>
              <a:ext cx="10647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GPI Anchor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694D654B-5C05-45BA-9335-CA20D7ED0E62}"/>
              </a:ext>
            </a:extLst>
          </p:cNvPr>
          <p:cNvSpPr txBox="1"/>
          <p:nvPr/>
        </p:nvSpPr>
        <p:spPr>
          <a:xfrm>
            <a:off x="724277" y="397999"/>
            <a:ext cx="30931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29. </a:t>
            </a:r>
            <a:r>
              <a:rPr lang="en-GB" b="1" dirty="0"/>
              <a:t>CD59-like, Smp_105220 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C6BE82EC-D59D-49B7-819D-174C98BC4B7E}"/>
              </a:ext>
            </a:extLst>
          </p:cNvPr>
          <p:cNvSpPr txBox="1"/>
          <p:nvPr/>
        </p:nvSpPr>
        <p:spPr>
          <a:xfrm>
            <a:off x="416959" y="6161824"/>
            <a:ext cx="34004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Note there are four C-C bridges but only two are conserved in </a:t>
            </a:r>
            <a:r>
              <a:rPr lang="en-GB" sz="1400" i="1" dirty="0"/>
              <a:t>S. </a:t>
            </a:r>
            <a:r>
              <a:rPr lang="en-GB" sz="1400" i="1" dirty="0" err="1"/>
              <a:t>mansoni</a:t>
            </a:r>
            <a:r>
              <a:rPr lang="en-GB" sz="1400" dirty="0"/>
              <a:t>.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1EF4BC3A-352A-41C3-85F1-5D7B1624901A}"/>
              </a:ext>
            </a:extLst>
          </p:cNvPr>
          <p:cNvGrpSpPr/>
          <p:nvPr/>
        </p:nvGrpSpPr>
        <p:grpSpPr>
          <a:xfrm>
            <a:off x="507053" y="5378093"/>
            <a:ext cx="1525932" cy="276999"/>
            <a:chOff x="507053" y="5425718"/>
            <a:chExt cx="1525932" cy="276999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xmlns="" id="{193F8812-1A89-4D06-98D1-9FE3C9B3E963}"/>
                </a:ext>
              </a:extLst>
            </p:cNvPr>
            <p:cNvGrpSpPr/>
            <p:nvPr/>
          </p:nvGrpSpPr>
          <p:grpSpPr>
            <a:xfrm>
              <a:off x="507053" y="5536075"/>
              <a:ext cx="579906" cy="61083"/>
              <a:chOff x="507053" y="5536075"/>
              <a:chExt cx="579906" cy="61083"/>
            </a:xfrm>
          </p:grpSpPr>
          <p:sp>
            <p:nvSpPr>
              <p:cNvPr id="15" name="Flowchart: Terminator 14">
                <a:extLst>
                  <a:ext uri="{FF2B5EF4-FFF2-40B4-BE49-F238E27FC236}">
                    <a16:creationId xmlns:a16="http://schemas.microsoft.com/office/drawing/2014/main" xmlns="" id="{95E837F2-6442-4FFA-BD4E-668F1636A311}"/>
                  </a:ext>
                </a:extLst>
              </p:cNvPr>
              <p:cNvSpPr/>
              <p:nvPr/>
            </p:nvSpPr>
            <p:spPr>
              <a:xfrm>
                <a:off x="507053" y="5536075"/>
                <a:ext cx="579906" cy="56286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xmlns="" id="{9988386C-544C-4DD9-A11C-26178177508F}"/>
                  </a:ext>
                </a:extLst>
              </p:cNvPr>
              <p:cNvSpPr/>
              <p:nvPr/>
            </p:nvSpPr>
            <p:spPr>
              <a:xfrm>
                <a:off x="704850" y="5539747"/>
                <a:ext cx="177800" cy="57411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xmlns="" id="{8FB4D648-226F-4D98-97DA-F823DB738528}"/>
                  </a:ext>
                </a:extLst>
              </p:cNvPr>
              <p:cNvCxnSpPr/>
              <p:nvPr/>
            </p:nvCxnSpPr>
            <p:spPr>
              <a:xfrm>
                <a:off x="624689" y="5592361"/>
                <a:ext cx="293383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65717A49-9E0A-4F69-914C-680AEA37A87D}"/>
                </a:ext>
              </a:extLst>
            </p:cNvPr>
            <p:cNvSpPr txBox="1"/>
            <p:nvPr/>
          </p:nvSpPr>
          <p:spPr>
            <a:xfrm>
              <a:off x="1100999" y="5425718"/>
              <a:ext cx="93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 - C bridge 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6B04BB76-B99D-4684-8CF3-9CB6AB1AEE0C}"/>
              </a:ext>
            </a:extLst>
          </p:cNvPr>
          <p:cNvSpPr txBox="1"/>
          <p:nvPr/>
        </p:nvSpPr>
        <p:spPr>
          <a:xfrm>
            <a:off x="5428518" y="397999"/>
            <a:ext cx="3124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2J8B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xmlns="" id="{E9D21E34-5993-4614-B7EC-2714F22D84F4}"/>
              </a:ext>
            </a:extLst>
          </p:cNvPr>
          <p:cNvCxnSpPr>
            <a:cxnSpLocks/>
          </p:cNvCxnSpPr>
          <p:nvPr/>
        </p:nvCxnSpPr>
        <p:spPr>
          <a:xfrm>
            <a:off x="4305300" y="5488450"/>
            <a:ext cx="1524000" cy="0"/>
          </a:xfrm>
          <a:prstGeom prst="line">
            <a:avLst/>
          </a:prstGeom>
          <a:ln w="1905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8170E42C-DD9C-4ADD-9209-040EF52E4F0D}"/>
              </a:ext>
            </a:extLst>
          </p:cNvPr>
          <p:cNvSpPr txBox="1"/>
          <p:nvPr/>
        </p:nvSpPr>
        <p:spPr>
          <a:xfrm>
            <a:off x="5791200" y="5326199"/>
            <a:ext cx="1280487" cy="380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Membrane</a:t>
            </a:r>
          </a:p>
        </p:txBody>
      </p:sp>
    </p:spTree>
    <p:extLst>
      <p:ext uri="{BB962C8B-B14F-4D97-AF65-F5344CB8AC3E}">
        <p14:creationId xmlns:p14="http://schemas.microsoft.com/office/powerpoint/2010/main" xmlns="" val="26026473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xmlns="" id="{15AEA305-9B1D-4007-B195-B80322320C1B}"/>
              </a:ext>
            </a:extLst>
          </p:cNvPr>
          <p:cNvGrpSpPr/>
          <p:nvPr/>
        </p:nvGrpSpPr>
        <p:grpSpPr>
          <a:xfrm>
            <a:off x="2047025" y="692616"/>
            <a:ext cx="4528056" cy="5458693"/>
            <a:chOff x="2047025" y="487222"/>
            <a:chExt cx="4528056" cy="5458693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17996664-7559-447A-B754-D6F330A1347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047025" y="487222"/>
              <a:ext cx="4528056" cy="5458693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A1D8A443-CA99-4C86-AD43-97F722B9EC44}"/>
                </a:ext>
              </a:extLst>
            </p:cNvPr>
            <p:cNvSpPr txBox="1"/>
            <p:nvPr/>
          </p:nvSpPr>
          <p:spPr>
            <a:xfrm>
              <a:off x="2288947" y="3299471"/>
              <a:ext cx="403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7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E9879FA0-CEBB-46B3-B064-DCD515FE6BD7}"/>
                </a:ext>
              </a:extLst>
            </p:cNvPr>
            <p:cNvSpPr txBox="1"/>
            <p:nvPr/>
          </p:nvSpPr>
          <p:spPr>
            <a:xfrm>
              <a:off x="5142392" y="3607248"/>
              <a:ext cx="403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4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B9DD0FEC-D370-4122-BACF-3402233D567D}"/>
                </a:ext>
              </a:extLst>
            </p:cNvPr>
            <p:cNvSpPr txBox="1"/>
            <p:nvPr/>
          </p:nvSpPr>
          <p:spPr>
            <a:xfrm>
              <a:off x="3366649" y="5307830"/>
              <a:ext cx="403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9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87BC0EBD-F0FD-4C0E-B21E-830E7CA2023D}"/>
              </a:ext>
            </a:extLst>
          </p:cNvPr>
          <p:cNvGrpSpPr/>
          <p:nvPr/>
        </p:nvGrpSpPr>
        <p:grpSpPr>
          <a:xfrm>
            <a:off x="507053" y="4958636"/>
            <a:ext cx="2101194" cy="696456"/>
            <a:chOff x="507053" y="4958636"/>
            <a:chExt cx="2101194" cy="696456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xmlns="" id="{3FE6F111-EEFF-4C25-9596-D49E18303DC4}"/>
                </a:ext>
              </a:extLst>
            </p:cNvPr>
            <p:cNvGrpSpPr/>
            <p:nvPr/>
          </p:nvGrpSpPr>
          <p:grpSpPr>
            <a:xfrm>
              <a:off x="507053" y="4958636"/>
              <a:ext cx="2101194" cy="503083"/>
              <a:chOff x="753756" y="5923242"/>
              <a:chExt cx="1771406" cy="461665"/>
            </a:xfrm>
          </p:grpSpPr>
          <p:sp>
            <p:nvSpPr>
              <p:cNvPr id="11" name="Flowchart: Terminator 10">
                <a:extLst>
                  <a:ext uri="{FF2B5EF4-FFF2-40B4-BE49-F238E27FC236}">
                    <a16:creationId xmlns:a16="http://schemas.microsoft.com/office/drawing/2014/main" xmlns="" id="{C89E3473-84D1-42EB-923D-0A15428D6250}"/>
                  </a:ext>
                </a:extLst>
              </p:cNvPr>
              <p:cNvSpPr/>
              <p:nvPr/>
            </p:nvSpPr>
            <p:spPr>
              <a:xfrm>
                <a:off x="753756" y="6049025"/>
                <a:ext cx="488888" cy="51652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Flowchart: Terminator 13">
                <a:extLst>
                  <a:ext uri="{FF2B5EF4-FFF2-40B4-BE49-F238E27FC236}">
                    <a16:creationId xmlns:a16="http://schemas.microsoft.com/office/drawing/2014/main" xmlns="" id="{FA5C2066-009D-42E9-B5EE-5825950464E9}"/>
                  </a:ext>
                </a:extLst>
              </p:cNvPr>
              <p:cNvSpPr/>
              <p:nvPr/>
            </p:nvSpPr>
            <p:spPr>
              <a:xfrm>
                <a:off x="753756" y="6220564"/>
                <a:ext cx="488888" cy="51652"/>
              </a:xfrm>
              <a:prstGeom prst="flowChartTerminator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xmlns="" id="{2AB2D796-0248-4031-B58B-2F100B1F3984}"/>
                  </a:ext>
                </a:extLst>
              </p:cNvPr>
              <p:cNvSpPr txBox="1"/>
              <p:nvPr/>
            </p:nvSpPr>
            <p:spPr>
              <a:xfrm>
                <a:off x="1239570" y="5923242"/>
                <a:ext cx="12855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Active site</a:t>
                </a:r>
              </a:p>
              <a:p>
                <a:r>
                  <a:rPr lang="en-GB" sz="1200" dirty="0"/>
                  <a:t>Ligand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xmlns="" id="{CB67D596-C747-47D8-AB86-251A5EB6818A}"/>
                </a:ext>
              </a:extLst>
            </p:cNvPr>
            <p:cNvGrpSpPr/>
            <p:nvPr/>
          </p:nvGrpSpPr>
          <p:grpSpPr>
            <a:xfrm>
              <a:off x="507053" y="5378093"/>
              <a:ext cx="1525932" cy="276999"/>
              <a:chOff x="507053" y="5425718"/>
              <a:chExt cx="1525932" cy="276999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xmlns="" id="{EF613FBC-2A24-42D3-8776-BB74B21AC34A}"/>
                  </a:ext>
                </a:extLst>
              </p:cNvPr>
              <p:cNvGrpSpPr/>
              <p:nvPr/>
            </p:nvGrpSpPr>
            <p:grpSpPr>
              <a:xfrm>
                <a:off x="507053" y="5536075"/>
                <a:ext cx="579906" cy="61083"/>
                <a:chOff x="507053" y="5536075"/>
                <a:chExt cx="579906" cy="61083"/>
              </a:xfrm>
            </p:grpSpPr>
            <p:sp>
              <p:nvSpPr>
                <p:cNvPr id="2" name="Flowchart: Terminator 1">
                  <a:extLst>
                    <a:ext uri="{FF2B5EF4-FFF2-40B4-BE49-F238E27FC236}">
                      <a16:creationId xmlns:a16="http://schemas.microsoft.com/office/drawing/2014/main" xmlns="" id="{B95E958F-BA66-426F-9B07-081432AF59F0}"/>
                    </a:ext>
                  </a:extLst>
                </p:cNvPr>
                <p:cNvSpPr/>
                <p:nvPr/>
              </p:nvSpPr>
              <p:spPr>
                <a:xfrm>
                  <a:off x="507053" y="5536075"/>
                  <a:ext cx="579906" cy="56286"/>
                </a:xfrm>
                <a:prstGeom prst="flowChartTerminator">
                  <a:avLst/>
                </a:prstGeom>
                <a:solidFill>
                  <a:srgbClr val="00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8" name="Rectangle 7">
                  <a:extLst>
                    <a:ext uri="{FF2B5EF4-FFF2-40B4-BE49-F238E27FC236}">
                      <a16:creationId xmlns:a16="http://schemas.microsoft.com/office/drawing/2014/main" xmlns="" id="{B73BC406-12F3-41B7-B9A5-1AF161D4509B}"/>
                    </a:ext>
                  </a:extLst>
                </p:cNvPr>
                <p:cNvSpPr/>
                <p:nvPr/>
              </p:nvSpPr>
              <p:spPr>
                <a:xfrm>
                  <a:off x="704850" y="5539747"/>
                  <a:ext cx="177800" cy="57411"/>
                </a:xfrm>
                <a:prstGeom prst="rect">
                  <a:avLst/>
                </a:prstGeom>
                <a:solidFill>
                  <a:srgbClr val="FFFF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xmlns="" id="{DDC53E04-6276-430E-85F2-D1ACF9947712}"/>
                    </a:ext>
                  </a:extLst>
                </p:cNvPr>
                <p:cNvCxnSpPr/>
                <p:nvPr/>
              </p:nvCxnSpPr>
              <p:spPr>
                <a:xfrm>
                  <a:off x="624689" y="5592361"/>
                  <a:ext cx="293383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xmlns="" id="{1D4C8FF3-54FD-4465-9909-B3AC9B6FAC65}"/>
                  </a:ext>
                </a:extLst>
              </p:cNvPr>
              <p:cNvSpPr txBox="1"/>
              <p:nvPr/>
            </p:nvSpPr>
            <p:spPr>
              <a:xfrm>
                <a:off x="1100999" y="5425718"/>
                <a:ext cx="9319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 - C bridge </a:t>
                </a:r>
              </a:p>
            </p:txBody>
          </p: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0EBD0296-3465-4F2A-9672-FB227F43FC00}"/>
              </a:ext>
            </a:extLst>
          </p:cNvPr>
          <p:cNvSpPr txBox="1"/>
          <p:nvPr/>
        </p:nvSpPr>
        <p:spPr>
          <a:xfrm>
            <a:off x="624688" y="395476"/>
            <a:ext cx="43938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3. </a:t>
            </a:r>
            <a:r>
              <a:rPr lang="en-GB" b="1" dirty="0"/>
              <a:t>Cathepsin B1.2 </a:t>
            </a:r>
            <a:r>
              <a:rPr lang="pt-BR" b="1" dirty="0">
                <a:ea typeface="Calibri" panose="020F0502020204030204" pitchFamily="34" charset="0"/>
              </a:rPr>
              <a:t>Smp_067060 </a:t>
            </a:r>
            <a:endParaRPr lang="en-GB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BD8D5337-6428-41BC-ACC8-91087A377F77}"/>
              </a:ext>
            </a:extLst>
          </p:cNvPr>
          <p:cNvSpPr txBox="1"/>
          <p:nvPr/>
        </p:nvSpPr>
        <p:spPr>
          <a:xfrm>
            <a:off x="5724526" y="395476"/>
            <a:ext cx="27947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Mapped on 3QSD &amp; 3S3Q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7F226C0E-D491-45CA-BAFD-A6E321CDD2FB}"/>
              </a:ext>
            </a:extLst>
          </p:cNvPr>
          <p:cNvSpPr txBox="1"/>
          <p:nvPr/>
        </p:nvSpPr>
        <p:spPr>
          <a:xfrm>
            <a:off x="5847242" y="2574392"/>
            <a:ext cx="4964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P10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xmlns="" id="{C6E7A4C6-9538-40E2-8E4F-F2D5D940EC4D}"/>
              </a:ext>
            </a:extLst>
          </p:cNvPr>
          <p:cNvCxnSpPr/>
          <p:nvPr/>
        </p:nvCxnSpPr>
        <p:spPr>
          <a:xfrm flipH="1">
            <a:off x="5238750" y="2724150"/>
            <a:ext cx="647700" cy="32385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159806798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F3D4B5C8-3B83-48BA-93A9-51ABC74F5018}"/>
              </a:ext>
            </a:extLst>
          </p:cNvPr>
          <p:cNvSpPr txBox="1"/>
          <p:nvPr/>
        </p:nvSpPr>
        <p:spPr>
          <a:xfrm>
            <a:off x="936747" y="397999"/>
            <a:ext cx="39781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30. </a:t>
            </a:r>
            <a:r>
              <a:rPr lang="en-GB" b="1" dirty="0"/>
              <a:t>Lamp-1 C-terminus, Smp_162770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DF04A5A0-58D2-4A7C-B486-B6C2B7F8A28E}"/>
              </a:ext>
            </a:extLst>
          </p:cNvPr>
          <p:cNvSpPr txBox="1"/>
          <p:nvPr/>
        </p:nvSpPr>
        <p:spPr>
          <a:xfrm>
            <a:off x="1116142" y="5994574"/>
            <a:ext cx="77226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Note, the homology is low so only three out of seven peptide hits can be mapped to the structur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3C35361C-5525-423A-82A0-08B14B4740D0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919287" y="1343171"/>
            <a:ext cx="4706435" cy="344589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867FE122-E40B-4FEF-B8C7-0FF3D44C9567}"/>
              </a:ext>
            </a:extLst>
          </p:cNvPr>
          <p:cNvSpPr txBox="1"/>
          <p:nvPr/>
        </p:nvSpPr>
        <p:spPr>
          <a:xfrm>
            <a:off x="1116142" y="5686797"/>
            <a:ext cx="45176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β</a:t>
            </a:r>
            <a:r>
              <a:rPr lang="en-GB" sz="1400" dirty="0"/>
              <a:t> prism fol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892B24B7-F221-43A5-8F0D-0528EB2FC298}"/>
              </a:ext>
            </a:extLst>
          </p:cNvPr>
          <p:cNvSpPr txBox="1"/>
          <p:nvPr/>
        </p:nvSpPr>
        <p:spPr>
          <a:xfrm>
            <a:off x="3762916" y="2199936"/>
            <a:ext cx="1019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P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675BA036-740A-433B-998F-1BE79732EFE5}"/>
              </a:ext>
            </a:extLst>
          </p:cNvPr>
          <p:cNvSpPr txBox="1"/>
          <p:nvPr/>
        </p:nvSpPr>
        <p:spPr>
          <a:xfrm>
            <a:off x="4377820" y="2912230"/>
            <a:ext cx="1019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P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854C1AF0-C456-47FE-8B9A-A3D8136D9D02}"/>
              </a:ext>
            </a:extLst>
          </p:cNvPr>
          <p:cNvSpPr txBox="1"/>
          <p:nvPr/>
        </p:nvSpPr>
        <p:spPr>
          <a:xfrm>
            <a:off x="4572000" y="1762499"/>
            <a:ext cx="1019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P5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xmlns="" id="{46316EE3-72AF-4734-96D4-E50B60297E4A}"/>
              </a:ext>
            </a:extLst>
          </p:cNvPr>
          <p:cNvGrpSpPr/>
          <p:nvPr/>
        </p:nvGrpSpPr>
        <p:grpSpPr>
          <a:xfrm>
            <a:off x="393355" y="4557669"/>
            <a:ext cx="1525932" cy="276999"/>
            <a:chOff x="507053" y="5425718"/>
            <a:chExt cx="1525932" cy="276999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xmlns="" id="{F9DD6E64-3984-4332-AA4D-EB95E0B0E79A}"/>
                </a:ext>
              </a:extLst>
            </p:cNvPr>
            <p:cNvGrpSpPr/>
            <p:nvPr/>
          </p:nvGrpSpPr>
          <p:grpSpPr>
            <a:xfrm>
              <a:off x="507053" y="5536075"/>
              <a:ext cx="579906" cy="61083"/>
              <a:chOff x="507053" y="5536075"/>
              <a:chExt cx="579906" cy="61083"/>
            </a:xfrm>
          </p:grpSpPr>
          <p:sp>
            <p:nvSpPr>
              <p:cNvPr id="18" name="Flowchart: Terminator 17">
                <a:extLst>
                  <a:ext uri="{FF2B5EF4-FFF2-40B4-BE49-F238E27FC236}">
                    <a16:creationId xmlns:a16="http://schemas.microsoft.com/office/drawing/2014/main" xmlns="" id="{5C4F87C5-B954-4748-92B2-C1B99C7D0393}"/>
                  </a:ext>
                </a:extLst>
              </p:cNvPr>
              <p:cNvSpPr/>
              <p:nvPr/>
            </p:nvSpPr>
            <p:spPr>
              <a:xfrm>
                <a:off x="507053" y="5536075"/>
                <a:ext cx="579906" cy="56286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xmlns="" id="{055FD97D-CBDB-41E6-8D1C-70BD570E6F6F}"/>
                  </a:ext>
                </a:extLst>
              </p:cNvPr>
              <p:cNvSpPr/>
              <p:nvPr/>
            </p:nvSpPr>
            <p:spPr>
              <a:xfrm>
                <a:off x="704850" y="5539747"/>
                <a:ext cx="177800" cy="57411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xmlns="" id="{80C8BCA3-6D07-4E1A-8D6C-81F0B643F422}"/>
                  </a:ext>
                </a:extLst>
              </p:cNvPr>
              <p:cNvCxnSpPr/>
              <p:nvPr/>
            </p:nvCxnSpPr>
            <p:spPr>
              <a:xfrm>
                <a:off x="624689" y="5592361"/>
                <a:ext cx="293383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2CC6D9BF-9493-46C6-8D87-11A64DBF48E4}"/>
                </a:ext>
              </a:extLst>
            </p:cNvPr>
            <p:cNvSpPr txBox="1"/>
            <p:nvPr/>
          </p:nvSpPr>
          <p:spPr>
            <a:xfrm>
              <a:off x="1100999" y="5425718"/>
              <a:ext cx="93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 - C bridge 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EE6A675B-BBB0-4FA4-A015-56DBC7777397}"/>
              </a:ext>
            </a:extLst>
          </p:cNvPr>
          <p:cNvSpPr txBox="1"/>
          <p:nvPr/>
        </p:nvSpPr>
        <p:spPr>
          <a:xfrm>
            <a:off x="5428518" y="397999"/>
            <a:ext cx="3124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5QV0</a:t>
            </a:r>
          </a:p>
        </p:txBody>
      </p:sp>
    </p:spTree>
    <p:extLst>
      <p:ext uri="{BB962C8B-B14F-4D97-AF65-F5344CB8AC3E}">
        <p14:creationId xmlns:p14="http://schemas.microsoft.com/office/powerpoint/2010/main" xmlns="" val="9376807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E736BBD9-7EBA-4545-BBFE-98622B9E43EE}"/>
              </a:ext>
            </a:extLst>
          </p:cNvPr>
          <p:cNvGrpSpPr/>
          <p:nvPr/>
        </p:nvGrpSpPr>
        <p:grpSpPr>
          <a:xfrm>
            <a:off x="452958" y="5185868"/>
            <a:ext cx="2570884" cy="461665"/>
            <a:chOff x="1056181" y="1961903"/>
            <a:chExt cx="1822831" cy="461665"/>
          </a:xfrm>
        </p:grpSpPr>
        <p:sp>
          <p:nvSpPr>
            <p:cNvPr id="6" name="Flowchart: Terminator 5">
              <a:extLst>
                <a:ext uri="{FF2B5EF4-FFF2-40B4-BE49-F238E27FC236}">
                  <a16:creationId xmlns:a16="http://schemas.microsoft.com/office/drawing/2014/main" xmlns="" id="{AD8F0D58-B97E-428A-AFDF-A8D7CD05C47B}"/>
                </a:ext>
              </a:extLst>
            </p:cNvPr>
            <p:cNvSpPr/>
            <p:nvPr/>
          </p:nvSpPr>
          <p:spPr>
            <a:xfrm>
              <a:off x="1059255" y="2073244"/>
              <a:ext cx="488888" cy="63374"/>
            </a:xfrm>
            <a:prstGeom prst="flowChartTerminator">
              <a:avLst/>
            </a:prstGeom>
            <a:solidFill>
              <a:srgbClr val="00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Flowchart: Terminator 6">
              <a:extLst>
                <a:ext uri="{FF2B5EF4-FFF2-40B4-BE49-F238E27FC236}">
                  <a16:creationId xmlns:a16="http://schemas.microsoft.com/office/drawing/2014/main" xmlns="" id="{F67A2A50-009A-4249-A063-49C9A2F37F2D}"/>
                </a:ext>
              </a:extLst>
            </p:cNvPr>
            <p:cNvSpPr/>
            <p:nvPr/>
          </p:nvSpPr>
          <p:spPr>
            <a:xfrm>
              <a:off x="1056181" y="2261521"/>
              <a:ext cx="488888" cy="63374"/>
            </a:xfrm>
            <a:prstGeom prst="flowChartTerminator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25B7028B-3E04-4134-8AB8-A502641C2589}"/>
                </a:ext>
              </a:extLst>
            </p:cNvPr>
            <p:cNvSpPr txBox="1"/>
            <p:nvPr/>
          </p:nvSpPr>
          <p:spPr>
            <a:xfrm>
              <a:off x="1593420" y="1961903"/>
              <a:ext cx="12855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 CAP site</a:t>
              </a:r>
            </a:p>
            <a:p>
              <a:r>
                <a:rPr lang="en-GB" sz="1200" dirty="0"/>
                <a:t> Caveolin binding motif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ADF1C27-0115-4D4E-8D97-4590233CE212}"/>
              </a:ext>
            </a:extLst>
          </p:cNvPr>
          <p:cNvSpPr txBox="1"/>
          <p:nvPr/>
        </p:nvSpPr>
        <p:spPr>
          <a:xfrm>
            <a:off x="5928645" y="6170918"/>
            <a:ext cx="281121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Note two Hs required for Zn binding are absent from VAL-4 and VAL-7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7770E693-97B9-42A3-B9C3-7925ADEDDF11}"/>
              </a:ext>
            </a:extLst>
          </p:cNvPr>
          <p:cNvGrpSpPr/>
          <p:nvPr/>
        </p:nvGrpSpPr>
        <p:grpSpPr>
          <a:xfrm>
            <a:off x="3379073" y="437427"/>
            <a:ext cx="3834862" cy="5422213"/>
            <a:chOff x="3642264" y="632228"/>
            <a:chExt cx="3834862" cy="5422213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xmlns="" id="{C0748933-02C4-44DD-B231-9A8DEFC7B2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42264" y="632228"/>
              <a:ext cx="3834862" cy="5422213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636AE77E-C328-496F-A96B-8DE319C01B9A}"/>
                </a:ext>
              </a:extLst>
            </p:cNvPr>
            <p:cNvSpPr txBox="1"/>
            <p:nvPr/>
          </p:nvSpPr>
          <p:spPr>
            <a:xfrm>
              <a:off x="4805091" y="1114425"/>
              <a:ext cx="843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6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1DE2B8C3-92ED-4259-BE22-655173627A4F}"/>
                </a:ext>
              </a:extLst>
            </p:cNvPr>
            <p:cNvSpPr txBox="1"/>
            <p:nvPr/>
          </p:nvSpPr>
          <p:spPr>
            <a:xfrm>
              <a:off x="6633891" y="4210050"/>
              <a:ext cx="843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3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C89F61F2-36C6-4B70-9704-AD5D109B32B8}"/>
              </a:ext>
            </a:extLst>
          </p:cNvPr>
          <p:cNvSpPr txBox="1"/>
          <p:nvPr/>
        </p:nvSpPr>
        <p:spPr>
          <a:xfrm>
            <a:off x="404144" y="5869405"/>
            <a:ext cx="360555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The caveolin binding motif is on an exposed loop but is not recognised by any mouse pool. The CAP site is largely silent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1DF7EEDC-7A3C-4B4A-A986-C5FABB92ADC4}"/>
              </a:ext>
            </a:extLst>
          </p:cNvPr>
          <p:cNvGrpSpPr/>
          <p:nvPr/>
        </p:nvGrpSpPr>
        <p:grpSpPr>
          <a:xfrm>
            <a:off x="467498" y="4903897"/>
            <a:ext cx="1743535" cy="276999"/>
            <a:chOff x="507053" y="5425718"/>
            <a:chExt cx="1467327" cy="276999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xmlns="" id="{AF9CCE16-45D6-43EA-B115-3F9C73053AC3}"/>
                </a:ext>
              </a:extLst>
            </p:cNvPr>
            <p:cNvGrpSpPr/>
            <p:nvPr/>
          </p:nvGrpSpPr>
          <p:grpSpPr>
            <a:xfrm>
              <a:off x="507053" y="5536075"/>
              <a:ext cx="579906" cy="61083"/>
              <a:chOff x="507053" y="5536075"/>
              <a:chExt cx="579906" cy="61083"/>
            </a:xfrm>
          </p:grpSpPr>
          <p:sp>
            <p:nvSpPr>
              <p:cNvPr id="19" name="Flowchart: Terminator 18">
                <a:extLst>
                  <a:ext uri="{FF2B5EF4-FFF2-40B4-BE49-F238E27FC236}">
                    <a16:creationId xmlns:a16="http://schemas.microsoft.com/office/drawing/2014/main" xmlns="" id="{000A3623-12FD-4C39-B33A-84C774940C29}"/>
                  </a:ext>
                </a:extLst>
              </p:cNvPr>
              <p:cNvSpPr/>
              <p:nvPr/>
            </p:nvSpPr>
            <p:spPr>
              <a:xfrm>
                <a:off x="507053" y="5536075"/>
                <a:ext cx="579906" cy="56286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xmlns="" id="{68F3BD58-ADFA-47FA-A2CC-CA1280DEB06D}"/>
                  </a:ext>
                </a:extLst>
              </p:cNvPr>
              <p:cNvSpPr/>
              <p:nvPr/>
            </p:nvSpPr>
            <p:spPr>
              <a:xfrm>
                <a:off x="704850" y="5539747"/>
                <a:ext cx="177800" cy="57411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xmlns="" id="{693C2682-AAF1-4ED3-B4B5-FEE07F174B7C}"/>
                  </a:ext>
                </a:extLst>
              </p:cNvPr>
              <p:cNvCxnSpPr/>
              <p:nvPr/>
            </p:nvCxnSpPr>
            <p:spPr>
              <a:xfrm>
                <a:off x="624689" y="5592361"/>
                <a:ext cx="293383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4DAA294C-85E6-4945-986B-8ABEDA7B3C5A}"/>
                </a:ext>
              </a:extLst>
            </p:cNvPr>
            <p:cNvSpPr txBox="1"/>
            <p:nvPr/>
          </p:nvSpPr>
          <p:spPr>
            <a:xfrm>
              <a:off x="1100999" y="5425718"/>
              <a:ext cx="8733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  C - C bridge 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4596B0C2-3527-4B9A-BE0F-A0DECD26B0FA}"/>
              </a:ext>
            </a:extLst>
          </p:cNvPr>
          <p:cNvSpPr txBox="1"/>
          <p:nvPr/>
        </p:nvSpPr>
        <p:spPr>
          <a:xfrm>
            <a:off x="5428518" y="361373"/>
            <a:ext cx="3124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4P27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9AC37090-D4E5-4EC8-AF2D-03F0BE1F1969}"/>
              </a:ext>
            </a:extLst>
          </p:cNvPr>
          <p:cNvSpPr txBox="1"/>
          <p:nvPr/>
        </p:nvSpPr>
        <p:spPr>
          <a:xfrm>
            <a:off x="404144" y="361373"/>
            <a:ext cx="37139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31. </a:t>
            </a:r>
            <a:r>
              <a:rPr lang="en-GB" b="1" dirty="0"/>
              <a:t>VAL-7, Smp_242990 mapped to SmVAL-4</a:t>
            </a:r>
          </a:p>
        </p:txBody>
      </p:sp>
    </p:spTree>
    <p:extLst>
      <p:ext uri="{BB962C8B-B14F-4D97-AF65-F5344CB8AC3E}">
        <p14:creationId xmlns:p14="http://schemas.microsoft.com/office/powerpoint/2010/main" xmlns="" val="37377336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230518BF-6955-4144-8656-1831A917AF32}"/>
              </a:ext>
            </a:extLst>
          </p:cNvPr>
          <p:cNvSpPr/>
          <p:nvPr/>
        </p:nvSpPr>
        <p:spPr>
          <a:xfrm>
            <a:off x="527965" y="395476"/>
            <a:ext cx="33457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>
                <a:solidFill>
                  <a:srgbClr val="000000"/>
                </a:solidFill>
                <a:ea typeface="Calibri" panose="020F0502020204030204" pitchFamily="34" charset="0"/>
              </a:rPr>
              <a:t>4. </a:t>
            </a:r>
            <a:r>
              <a:rPr lang="en-GB" b="1" dirty="0" err="1">
                <a:solidFill>
                  <a:srgbClr val="000000"/>
                </a:solidFill>
                <a:ea typeface="Calibri" panose="020F0502020204030204" pitchFamily="34" charset="0"/>
              </a:rPr>
              <a:t>Cathepsin</a:t>
            </a:r>
            <a:r>
              <a:rPr lang="en-GB" b="1" dirty="0">
                <a:solidFill>
                  <a:srgbClr val="000000"/>
                </a:solidFill>
                <a:ea typeface="Calibri" panose="020F0502020204030204" pitchFamily="34" charset="0"/>
              </a:rPr>
              <a:t> </a:t>
            </a:r>
            <a:r>
              <a:rPr lang="en-GB" b="1" dirty="0" smtClean="0">
                <a:solidFill>
                  <a:srgbClr val="000000"/>
                </a:solidFill>
                <a:ea typeface="Calibri" panose="020F0502020204030204" pitchFamily="34" charset="0"/>
              </a:rPr>
              <a:t>B2. </a:t>
            </a:r>
            <a:r>
              <a:rPr lang="en-GB" b="1" dirty="0">
                <a:solidFill>
                  <a:srgbClr val="000000"/>
                </a:solidFill>
                <a:ea typeface="Calibri" panose="020F0502020204030204" pitchFamily="34" charset="0"/>
              </a:rPr>
              <a:t>Smp_141610.1 </a:t>
            </a:r>
            <a:endParaRPr lang="en-GB" b="1" dirty="0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A3E78830-C0D2-485F-AA43-FC74ADD12EFA}"/>
              </a:ext>
            </a:extLst>
          </p:cNvPr>
          <p:cNvGrpSpPr/>
          <p:nvPr/>
        </p:nvGrpSpPr>
        <p:grpSpPr>
          <a:xfrm>
            <a:off x="2447121" y="1156378"/>
            <a:ext cx="5631853" cy="5207156"/>
            <a:chOff x="2447121" y="1156378"/>
            <a:chExt cx="5631853" cy="5207156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xmlns="" id="{4F3C66BF-AE24-4A2D-B5F3-4155F9149EF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447121" y="1156378"/>
              <a:ext cx="5631853" cy="5207156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20592098-31E4-489D-88DC-BB128C968C76}"/>
                </a:ext>
              </a:extLst>
            </p:cNvPr>
            <p:cNvSpPr txBox="1"/>
            <p:nvPr/>
          </p:nvSpPr>
          <p:spPr>
            <a:xfrm>
              <a:off x="4506057" y="5573839"/>
              <a:ext cx="5978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5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858710D6-9E17-49DF-B747-B8C39AEADD41}"/>
                </a:ext>
              </a:extLst>
            </p:cNvPr>
            <p:cNvSpPr txBox="1"/>
            <p:nvPr/>
          </p:nvSpPr>
          <p:spPr>
            <a:xfrm>
              <a:off x="4559000" y="1284161"/>
              <a:ext cx="491929" cy="195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3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A438BA28-7B72-423D-80CA-283044BC6E0B}"/>
                </a:ext>
              </a:extLst>
            </p:cNvPr>
            <p:cNvSpPr txBox="1"/>
            <p:nvPr/>
          </p:nvSpPr>
          <p:spPr>
            <a:xfrm>
              <a:off x="6477047" y="2254839"/>
              <a:ext cx="491929" cy="2881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9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F7535E55-E581-4933-A456-24DFCF3AAF20}"/>
              </a:ext>
            </a:extLst>
          </p:cNvPr>
          <p:cNvGrpSpPr/>
          <p:nvPr/>
        </p:nvGrpSpPr>
        <p:grpSpPr>
          <a:xfrm>
            <a:off x="639489" y="5128089"/>
            <a:ext cx="1774480" cy="925879"/>
            <a:chOff x="639489" y="5128089"/>
            <a:chExt cx="1774480" cy="925879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xmlns="" id="{A6C7767A-FAB1-4F77-93CC-F6B22809D7E8}"/>
                </a:ext>
              </a:extLst>
            </p:cNvPr>
            <p:cNvGrpSpPr/>
            <p:nvPr/>
          </p:nvGrpSpPr>
          <p:grpSpPr>
            <a:xfrm>
              <a:off x="639489" y="5128089"/>
              <a:ext cx="1774480" cy="646331"/>
              <a:chOff x="1056181" y="1896700"/>
              <a:chExt cx="1774480" cy="793015"/>
            </a:xfrm>
          </p:grpSpPr>
          <p:sp>
            <p:nvSpPr>
              <p:cNvPr id="5" name="Flowchart: Terminator 4">
                <a:extLst>
                  <a:ext uri="{FF2B5EF4-FFF2-40B4-BE49-F238E27FC236}">
                    <a16:creationId xmlns:a16="http://schemas.microsoft.com/office/drawing/2014/main" xmlns="" id="{7F870E15-28E5-4D59-917C-A5B5DF55D94C}"/>
                  </a:ext>
                </a:extLst>
              </p:cNvPr>
              <p:cNvSpPr/>
              <p:nvPr/>
            </p:nvSpPr>
            <p:spPr>
              <a:xfrm>
                <a:off x="1059255" y="2073244"/>
                <a:ext cx="488888" cy="63374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" name="Flowchart: Terminator 5">
                <a:extLst>
                  <a:ext uri="{FF2B5EF4-FFF2-40B4-BE49-F238E27FC236}">
                    <a16:creationId xmlns:a16="http://schemas.microsoft.com/office/drawing/2014/main" xmlns="" id="{AFEFDA4F-BF1F-438E-9B6E-5714C5730CBD}"/>
                  </a:ext>
                </a:extLst>
              </p:cNvPr>
              <p:cNvSpPr/>
              <p:nvPr/>
            </p:nvSpPr>
            <p:spPr>
              <a:xfrm>
                <a:off x="1059255" y="2449798"/>
                <a:ext cx="488888" cy="63374"/>
              </a:xfrm>
              <a:prstGeom prst="flowChartTerminator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" name="Flowchart: Terminator 6">
                <a:extLst>
                  <a:ext uri="{FF2B5EF4-FFF2-40B4-BE49-F238E27FC236}">
                    <a16:creationId xmlns:a16="http://schemas.microsoft.com/office/drawing/2014/main" xmlns="" id="{A69F99F6-9247-4E1E-A3B7-5C544DEEF6DD}"/>
                  </a:ext>
                </a:extLst>
              </p:cNvPr>
              <p:cNvSpPr/>
              <p:nvPr/>
            </p:nvSpPr>
            <p:spPr>
              <a:xfrm>
                <a:off x="1056181" y="2261521"/>
                <a:ext cx="488888" cy="63374"/>
              </a:xfrm>
              <a:prstGeom prst="flowChartTerminator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xmlns="" id="{791452D4-CD47-4B9A-B8B0-FC93CD1BF6FB}"/>
                  </a:ext>
                </a:extLst>
              </p:cNvPr>
              <p:cNvSpPr txBox="1"/>
              <p:nvPr/>
            </p:nvSpPr>
            <p:spPr>
              <a:xfrm>
                <a:off x="1545069" y="1896700"/>
                <a:ext cx="1285592" cy="7930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Active site</a:t>
                </a:r>
              </a:p>
              <a:p>
                <a:r>
                  <a:rPr lang="en-GB" sz="1200" dirty="0"/>
                  <a:t>Occluding loop</a:t>
                </a:r>
              </a:p>
              <a:p>
                <a:r>
                  <a:rPr lang="en-GB" sz="1200" dirty="0"/>
                  <a:t>Ligand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xmlns="" id="{24E2B3D7-6A54-4308-9155-90B689B7CFCF}"/>
                </a:ext>
              </a:extLst>
            </p:cNvPr>
            <p:cNvGrpSpPr/>
            <p:nvPr/>
          </p:nvGrpSpPr>
          <p:grpSpPr>
            <a:xfrm>
              <a:off x="639489" y="5776969"/>
              <a:ext cx="1525932" cy="276999"/>
              <a:chOff x="507053" y="5425718"/>
              <a:chExt cx="1525932" cy="276999"/>
            </a:xfrm>
          </p:grpSpPr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xmlns="" id="{CE4A6354-3EBC-493C-9E48-B881B46E54AD}"/>
                  </a:ext>
                </a:extLst>
              </p:cNvPr>
              <p:cNvGrpSpPr/>
              <p:nvPr/>
            </p:nvGrpSpPr>
            <p:grpSpPr>
              <a:xfrm>
                <a:off x="507053" y="5536075"/>
                <a:ext cx="579906" cy="61083"/>
                <a:chOff x="507053" y="5536075"/>
                <a:chExt cx="579906" cy="61083"/>
              </a:xfrm>
            </p:grpSpPr>
            <p:sp>
              <p:nvSpPr>
                <p:cNvPr id="29" name="Flowchart: Terminator 28">
                  <a:extLst>
                    <a:ext uri="{FF2B5EF4-FFF2-40B4-BE49-F238E27FC236}">
                      <a16:creationId xmlns:a16="http://schemas.microsoft.com/office/drawing/2014/main" xmlns="" id="{7E4DED55-ED85-4D28-B9A7-D666D388C725}"/>
                    </a:ext>
                  </a:extLst>
                </p:cNvPr>
                <p:cNvSpPr/>
                <p:nvPr/>
              </p:nvSpPr>
              <p:spPr>
                <a:xfrm>
                  <a:off x="507053" y="5536075"/>
                  <a:ext cx="579906" cy="56286"/>
                </a:xfrm>
                <a:prstGeom prst="flowChartTerminator">
                  <a:avLst/>
                </a:prstGeom>
                <a:solidFill>
                  <a:srgbClr val="00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0" name="Rectangle 29">
                  <a:extLst>
                    <a:ext uri="{FF2B5EF4-FFF2-40B4-BE49-F238E27FC236}">
                      <a16:creationId xmlns:a16="http://schemas.microsoft.com/office/drawing/2014/main" xmlns="" id="{23B45C46-1F1A-4141-94F0-754D633F1D19}"/>
                    </a:ext>
                  </a:extLst>
                </p:cNvPr>
                <p:cNvSpPr/>
                <p:nvPr/>
              </p:nvSpPr>
              <p:spPr>
                <a:xfrm>
                  <a:off x="704850" y="5539747"/>
                  <a:ext cx="177800" cy="57411"/>
                </a:xfrm>
                <a:prstGeom prst="rect">
                  <a:avLst/>
                </a:prstGeom>
                <a:solidFill>
                  <a:srgbClr val="FFFF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xmlns="" id="{2C1C52D5-7A1E-4178-9AC7-7AC4C0166909}"/>
                    </a:ext>
                  </a:extLst>
                </p:cNvPr>
                <p:cNvCxnSpPr/>
                <p:nvPr/>
              </p:nvCxnSpPr>
              <p:spPr>
                <a:xfrm>
                  <a:off x="624689" y="5592361"/>
                  <a:ext cx="293383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xmlns="" id="{D692E0E3-5243-4569-AFDB-99588082D46B}"/>
                  </a:ext>
                </a:extLst>
              </p:cNvPr>
              <p:cNvSpPr txBox="1"/>
              <p:nvPr/>
            </p:nvSpPr>
            <p:spPr>
              <a:xfrm>
                <a:off x="1100999" y="5425718"/>
                <a:ext cx="9319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 - C bridge </a:t>
                </a:r>
              </a:p>
            </p:txBody>
          </p:sp>
        </p:grp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C9EAAEEB-F12D-479E-8F03-387CC115EF46}"/>
              </a:ext>
            </a:extLst>
          </p:cNvPr>
          <p:cNvSpPr txBox="1"/>
          <p:nvPr/>
        </p:nvSpPr>
        <p:spPr>
          <a:xfrm>
            <a:off x="5724526" y="395476"/>
            <a:ext cx="27947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Mapped onto PDB  3S3Q</a:t>
            </a:r>
          </a:p>
        </p:txBody>
      </p:sp>
    </p:spTree>
    <p:extLst>
      <p:ext uri="{BB962C8B-B14F-4D97-AF65-F5344CB8AC3E}">
        <p14:creationId xmlns:p14="http://schemas.microsoft.com/office/powerpoint/2010/main" xmlns="" val="3318423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3FA490BC-68DF-4DB6-8FAA-1DFB0E62868F}"/>
              </a:ext>
            </a:extLst>
          </p:cNvPr>
          <p:cNvSpPr txBox="1"/>
          <p:nvPr/>
        </p:nvSpPr>
        <p:spPr>
          <a:xfrm>
            <a:off x="750367" y="401529"/>
            <a:ext cx="3467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5. </a:t>
            </a:r>
            <a:r>
              <a:rPr lang="en-GB" b="1" dirty="0" err="1"/>
              <a:t>Cathepsin</a:t>
            </a:r>
            <a:r>
              <a:rPr lang="en-GB" b="1" dirty="0"/>
              <a:t> </a:t>
            </a:r>
            <a:r>
              <a:rPr lang="en-GB" b="1" dirty="0" smtClean="0"/>
              <a:t>L, </a:t>
            </a:r>
            <a:r>
              <a:rPr lang="pt-BR" b="1" dirty="0">
                <a:solidFill>
                  <a:srgbClr val="000000"/>
                </a:solidFill>
                <a:ea typeface="Calibri" panose="020F0502020204030204" pitchFamily="34" charset="0"/>
              </a:rPr>
              <a:t>Smp_139160 </a:t>
            </a:r>
            <a:endParaRPr lang="en-GB" b="1" dirty="0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87CDEC62-15C4-4CD9-A5DF-C3E07B938030}"/>
              </a:ext>
            </a:extLst>
          </p:cNvPr>
          <p:cNvGrpSpPr/>
          <p:nvPr/>
        </p:nvGrpSpPr>
        <p:grpSpPr>
          <a:xfrm>
            <a:off x="1552204" y="922445"/>
            <a:ext cx="6395951" cy="4416076"/>
            <a:chOff x="1552204" y="922445"/>
            <a:chExt cx="6395951" cy="441607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C69F280A-34C6-444F-B876-A2A25B8C471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552204" y="922445"/>
              <a:ext cx="4681572" cy="4401810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C30E2110-1422-4A48-916B-990D116692E1}"/>
                </a:ext>
              </a:extLst>
            </p:cNvPr>
            <p:cNvSpPr txBox="1"/>
            <p:nvPr/>
          </p:nvSpPr>
          <p:spPr>
            <a:xfrm>
              <a:off x="4778464" y="5030744"/>
              <a:ext cx="6864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2</a:t>
              </a:r>
            </a:p>
          </p:txBody>
        </p:sp>
        <p:sp>
          <p:nvSpPr>
            <p:cNvPr id="13" name="Freeform: Shape 12">
              <a:extLst>
                <a:ext uri="{FF2B5EF4-FFF2-40B4-BE49-F238E27FC236}">
                  <a16:creationId xmlns:a16="http://schemas.microsoft.com/office/drawing/2014/main" xmlns="" id="{46D11F18-F998-4CD5-9DA9-E1E85EC828B9}"/>
                </a:ext>
              </a:extLst>
            </p:cNvPr>
            <p:cNvSpPr/>
            <p:nvPr/>
          </p:nvSpPr>
          <p:spPr>
            <a:xfrm rot="882852">
              <a:off x="5888689" y="2003731"/>
              <a:ext cx="52301" cy="398352"/>
            </a:xfrm>
            <a:custGeom>
              <a:avLst/>
              <a:gdLst>
                <a:gd name="connsiteX0" fmla="*/ 36214 w 52301"/>
                <a:gd name="connsiteY0" fmla="*/ 0 h 398352"/>
                <a:gd name="connsiteX1" fmla="*/ 36214 w 52301"/>
                <a:gd name="connsiteY1" fmla="*/ 334978 h 398352"/>
                <a:gd name="connsiteX2" fmla="*/ 18107 w 52301"/>
                <a:gd name="connsiteY2" fmla="*/ 362139 h 398352"/>
                <a:gd name="connsiteX3" fmla="*/ 0 w 52301"/>
                <a:gd name="connsiteY3" fmla="*/ 398352 h 39835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52301" h="398352">
                  <a:moveTo>
                    <a:pt x="36214" y="0"/>
                  </a:moveTo>
                  <a:cubicBezTo>
                    <a:pt x="58508" y="133771"/>
                    <a:pt x="56802" y="101639"/>
                    <a:pt x="36214" y="334978"/>
                  </a:cubicBezTo>
                  <a:cubicBezTo>
                    <a:pt x="35258" y="345817"/>
                    <a:pt x="23506" y="352692"/>
                    <a:pt x="18107" y="362139"/>
                  </a:cubicBezTo>
                  <a:cubicBezTo>
                    <a:pt x="11411" y="373857"/>
                    <a:pt x="0" y="398352"/>
                    <a:pt x="0" y="398352"/>
                  </a:cubicBezTo>
                </a:path>
              </a:pathLst>
            </a:custGeom>
            <a:ln w="19050" cap="flat" cmpd="sng" algn="ctr">
              <a:solidFill>
                <a:schemeClr val="accent3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3DE7CF0F-C81F-4BEE-B0DE-5C5127323195}"/>
                </a:ext>
              </a:extLst>
            </p:cNvPr>
            <p:cNvSpPr txBox="1"/>
            <p:nvPr/>
          </p:nvSpPr>
          <p:spPr>
            <a:xfrm>
              <a:off x="5557030" y="1582353"/>
              <a:ext cx="23911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7 (junction with </a:t>
              </a:r>
              <a:r>
                <a:rPr lang="en-GB" sz="1400" b="1" dirty="0" err="1"/>
                <a:t>propeptide</a:t>
              </a:r>
              <a:r>
                <a:rPr lang="en-GB" sz="1400" b="1" dirty="0"/>
                <a:t>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531609C8-FA9A-4069-91B8-B75FD40FDF12}"/>
                </a:ext>
              </a:extLst>
            </p:cNvPr>
            <p:cNvSpPr txBox="1"/>
            <p:nvPr/>
          </p:nvSpPr>
          <p:spPr>
            <a:xfrm>
              <a:off x="4451163" y="3745759"/>
              <a:ext cx="6864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9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0901E92D-DE25-4CCF-82F1-AC5821BD9A02}"/>
              </a:ext>
            </a:extLst>
          </p:cNvPr>
          <p:cNvSpPr txBox="1"/>
          <p:nvPr/>
        </p:nvSpPr>
        <p:spPr>
          <a:xfrm>
            <a:off x="5308387" y="401529"/>
            <a:ext cx="3272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 206X &amp; 1FH0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08EBF009-9424-4708-B0C0-3DEDAABB53C1}"/>
              </a:ext>
            </a:extLst>
          </p:cNvPr>
          <p:cNvGrpSpPr/>
          <p:nvPr/>
        </p:nvGrpSpPr>
        <p:grpSpPr>
          <a:xfrm>
            <a:off x="425513" y="5420095"/>
            <a:ext cx="2110536" cy="674521"/>
            <a:chOff x="507053" y="4980571"/>
            <a:chExt cx="2110536" cy="674521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xmlns="" id="{6ACC5A7F-5FBA-472A-A091-9DAF41C2AF46}"/>
                </a:ext>
              </a:extLst>
            </p:cNvPr>
            <p:cNvGrpSpPr/>
            <p:nvPr/>
          </p:nvGrpSpPr>
          <p:grpSpPr>
            <a:xfrm>
              <a:off x="516395" y="4980571"/>
              <a:ext cx="2101194" cy="503083"/>
              <a:chOff x="753756" y="5923242"/>
              <a:chExt cx="1771406" cy="461665"/>
            </a:xfrm>
          </p:grpSpPr>
          <p:sp>
            <p:nvSpPr>
              <p:cNvPr id="23" name="Flowchart: Terminator 22">
                <a:extLst>
                  <a:ext uri="{FF2B5EF4-FFF2-40B4-BE49-F238E27FC236}">
                    <a16:creationId xmlns:a16="http://schemas.microsoft.com/office/drawing/2014/main" xmlns="" id="{63FC1E33-FFE4-4E61-B8A4-7CF0F73DC820}"/>
                  </a:ext>
                </a:extLst>
              </p:cNvPr>
              <p:cNvSpPr/>
              <p:nvPr/>
            </p:nvSpPr>
            <p:spPr>
              <a:xfrm>
                <a:off x="753756" y="6049025"/>
                <a:ext cx="488888" cy="51652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Flowchart: Terminator 23">
                <a:extLst>
                  <a:ext uri="{FF2B5EF4-FFF2-40B4-BE49-F238E27FC236}">
                    <a16:creationId xmlns:a16="http://schemas.microsoft.com/office/drawing/2014/main" xmlns="" id="{ED7662AD-37AD-445C-98EE-B1EA62B71A1C}"/>
                  </a:ext>
                </a:extLst>
              </p:cNvPr>
              <p:cNvSpPr/>
              <p:nvPr/>
            </p:nvSpPr>
            <p:spPr>
              <a:xfrm>
                <a:off x="753756" y="6220564"/>
                <a:ext cx="488888" cy="51652"/>
              </a:xfrm>
              <a:prstGeom prst="flowChartTerminator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xmlns="" id="{61E2EB4C-DFBD-4E25-858A-61350EC4261A}"/>
                  </a:ext>
                </a:extLst>
              </p:cNvPr>
              <p:cNvSpPr txBox="1"/>
              <p:nvPr/>
            </p:nvSpPr>
            <p:spPr>
              <a:xfrm>
                <a:off x="1239570" y="5923242"/>
                <a:ext cx="12855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Active site</a:t>
                </a:r>
              </a:p>
              <a:p>
                <a:r>
                  <a:rPr lang="en-GB" sz="1200" dirty="0"/>
                  <a:t>Ligand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xmlns="" id="{1ADA27E0-E811-47BD-87B6-C2557A702CA0}"/>
                </a:ext>
              </a:extLst>
            </p:cNvPr>
            <p:cNvGrpSpPr/>
            <p:nvPr/>
          </p:nvGrpSpPr>
          <p:grpSpPr>
            <a:xfrm>
              <a:off x="507053" y="5378093"/>
              <a:ext cx="1525932" cy="276999"/>
              <a:chOff x="507053" y="5425718"/>
              <a:chExt cx="1525932" cy="276999"/>
            </a:xfrm>
          </p:grpSpPr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xmlns="" id="{402DAD5E-94ED-48F7-8218-7719679B5FA8}"/>
                  </a:ext>
                </a:extLst>
              </p:cNvPr>
              <p:cNvGrpSpPr/>
              <p:nvPr/>
            </p:nvGrpSpPr>
            <p:grpSpPr>
              <a:xfrm>
                <a:off x="507053" y="5536075"/>
                <a:ext cx="579906" cy="61083"/>
                <a:chOff x="507053" y="5536075"/>
                <a:chExt cx="579906" cy="61083"/>
              </a:xfrm>
            </p:grpSpPr>
            <p:sp>
              <p:nvSpPr>
                <p:cNvPr id="20" name="Flowchart: Terminator 19">
                  <a:extLst>
                    <a:ext uri="{FF2B5EF4-FFF2-40B4-BE49-F238E27FC236}">
                      <a16:creationId xmlns:a16="http://schemas.microsoft.com/office/drawing/2014/main" xmlns="" id="{FE5F4284-2B0E-4C95-BB1A-183D8FA67742}"/>
                    </a:ext>
                  </a:extLst>
                </p:cNvPr>
                <p:cNvSpPr/>
                <p:nvPr/>
              </p:nvSpPr>
              <p:spPr>
                <a:xfrm>
                  <a:off x="507053" y="5536075"/>
                  <a:ext cx="579906" cy="56286"/>
                </a:xfrm>
                <a:prstGeom prst="flowChartTerminator">
                  <a:avLst/>
                </a:prstGeom>
                <a:solidFill>
                  <a:srgbClr val="00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xmlns="" id="{FBEC8456-C0CC-4D49-81EB-E05733FDCC6C}"/>
                    </a:ext>
                  </a:extLst>
                </p:cNvPr>
                <p:cNvSpPr/>
                <p:nvPr/>
              </p:nvSpPr>
              <p:spPr>
                <a:xfrm>
                  <a:off x="704850" y="5539747"/>
                  <a:ext cx="177800" cy="57411"/>
                </a:xfrm>
                <a:prstGeom prst="rect">
                  <a:avLst/>
                </a:prstGeom>
                <a:solidFill>
                  <a:srgbClr val="FFFF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22" name="Straight Connector 21">
                  <a:extLst>
                    <a:ext uri="{FF2B5EF4-FFF2-40B4-BE49-F238E27FC236}">
                      <a16:creationId xmlns:a16="http://schemas.microsoft.com/office/drawing/2014/main" xmlns="" id="{471CDD0D-7447-4AA8-84CA-88521B63402D}"/>
                    </a:ext>
                  </a:extLst>
                </p:cNvPr>
                <p:cNvCxnSpPr/>
                <p:nvPr/>
              </p:nvCxnSpPr>
              <p:spPr>
                <a:xfrm>
                  <a:off x="624689" y="5592361"/>
                  <a:ext cx="293383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xmlns="" id="{ED6034AD-478A-433B-B4B9-6F9BE2EE9EE0}"/>
                  </a:ext>
                </a:extLst>
              </p:cNvPr>
              <p:cNvSpPr txBox="1"/>
              <p:nvPr/>
            </p:nvSpPr>
            <p:spPr>
              <a:xfrm>
                <a:off x="1100999" y="5425718"/>
                <a:ext cx="9319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 - C bridge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xmlns="" val="29810472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A221B961-D334-4ADD-BEC0-AE73EE28943A}"/>
              </a:ext>
            </a:extLst>
          </p:cNvPr>
          <p:cNvSpPr txBox="1"/>
          <p:nvPr/>
        </p:nvSpPr>
        <p:spPr>
          <a:xfrm>
            <a:off x="712210" y="400572"/>
            <a:ext cx="3467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6. </a:t>
            </a:r>
            <a:r>
              <a:rPr lang="en-GB" b="1" dirty="0"/>
              <a:t>Cathepsin S, </a:t>
            </a:r>
            <a:r>
              <a:rPr lang="pt-BR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mp_139240 </a:t>
            </a:r>
            <a:endParaRPr lang="en-GB" b="1" dirty="0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94C9AE89-F3F3-4EB9-B7CF-5605330AE5A0}"/>
              </a:ext>
            </a:extLst>
          </p:cNvPr>
          <p:cNvGrpSpPr/>
          <p:nvPr/>
        </p:nvGrpSpPr>
        <p:grpSpPr>
          <a:xfrm>
            <a:off x="1565733" y="1400283"/>
            <a:ext cx="6174335" cy="4232605"/>
            <a:chOff x="1578186" y="1120037"/>
            <a:chExt cx="6174335" cy="423260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xmlns="" id="{03CA1152-08BF-48A2-84B1-53A5E0F5106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578186" y="1120037"/>
              <a:ext cx="6174335" cy="4232605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3F243359-9EC4-4AB8-AF5F-780257AB18B7}"/>
                </a:ext>
              </a:extLst>
            </p:cNvPr>
            <p:cNvSpPr txBox="1"/>
            <p:nvPr/>
          </p:nvSpPr>
          <p:spPr>
            <a:xfrm>
              <a:off x="5106154" y="2688879"/>
              <a:ext cx="117695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cs typeface="Courier New" panose="02070309020205020404" pitchFamily="49" charset="0"/>
                </a:rPr>
                <a:t>P1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0C534B64-C42B-4394-9E84-8B4C2BD17B4F}"/>
                </a:ext>
              </a:extLst>
            </p:cNvPr>
            <p:cNvSpPr txBox="1"/>
            <p:nvPr/>
          </p:nvSpPr>
          <p:spPr>
            <a:xfrm>
              <a:off x="2819865" y="3816761"/>
              <a:ext cx="117695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cs typeface="Courier New" panose="02070309020205020404" pitchFamily="49" charset="0"/>
                </a:rPr>
                <a:t>P13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37FD73F4-7CEE-48A6-8472-0412A30BC38B}"/>
              </a:ext>
            </a:extLst>
          </p:cNvPr>
          <p:cNvGrpSpPr/>
          <p:nvPr/>
        </p:nvGrpSpPr>
        <p:grpSpPr>
          <a:xfrm>
            <a:off x="425513" y="5420095"/>
            <a:ext cx="2110536" cy="674521"/>
            <a:chOff x="507053" y="4980571"/>
            <a:chExt cx="2110536" cy="674521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xmlns="" id="{15D74C53-FB5B-46B9-BFDA-F25F9274AE76}"/>
                </a:ext>
              </a:extLst>
            </p:cNvPr>
            <p:cNvGrpSpPr/>
            <p:nvPr/>
          </p:nvGrpSpPr>
          <p:grpSpPr>
            <a:xfrm>
              <a:off x="516395" y="4980571"/>
              <a:ext cx="2101194" cy="503083"/>
              <a:chOff x="753756" y="5923242"/>
              <a:chExt cx="1771406" cy="461665"/>
            </a:xfrm>
          </p:grpSpPr>
          <p:sp>
            <p:nvSpPr>
              <p:cNvPr id="23" name="Flowchart: Terminator 22">
                <a:extLst>
                  <a:ext uri="{FF2B5EF4-FFF2-40B4-BE49-F238E27FC236}">
                    <a16:creationId xmlns:a16="http://schemas.microsoft.com/office/drawing/2014/main" xmlns="" id="{C8C3B408-A010-46E2-9413-911F18752DE5}"/>
                  </a:ext>
                </a:extLst>
              </p:cNvPr>
              <p:cNvSpPr/>
              <p:nvPr/>
            </p:nvSpPr>
            <p:spPr>
              <a:xfrm>
                <a:off x="753756" y="6049025"/>
                <a:ext cx="488888" cy="51652"/>
              </a:xfrm>
              <a:prstGeom prst="flowChartTerminator">
                <a:avLst/>
              </a:prstGeom>
              <a:solidFill>
                <a:srgbClr val="00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Flowchart: Terminator 23">
                <a:extLst>
                  <a:ext uri="{FF2B5EF4-FFF2-40B4-BE49-F238E27FC236}">
                    <a16:creationId xmlns:a16="http://schemas.microsoft.com/office/drawing/2014/main" xmlns="" id="{DB4AEB58-DA74-4774-BBEF-085229D29149}"/>
                  </a:ext>
                </a:extLst>
              </p:cNvPr>
              <p:cNvSpPr/>
              <p:nvPr/>
            </p:nvSpPr>
            <p:spPr>
              <a:xfrm>
                <a:off x="753756" y="6220564"/>
                <a:ext cx="488888" cy="51652"/>
              </a:xfrm>
              <a:prstGeom prst="flowChartTerminator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xmlns="" id="{4EF5E9A2-C306-4ECD-97CD-F8BB64F2429B}"/>
                  </a:ext>
                </a:extLst>
              </p:cNvPr>
              <p:cNvSpPr txBox="1"/>
              <p:nvPr/>
            </p:nvSpPr>
            <p:spPr>
              <a:xfrm>
                <a:off x="1239570" y="5923242"/>
                <a:ext cx="12855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Active site</a:t>
                </a:r>
              </a:p>
              <a:p>
                <a:r>
                  <a:rPr lang="en-GB" sz="1200" dirty="0"/>
                  <a:t>Ligand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xmlns="" id="{53CFB5A2-6AD5-4AE5-842C-42501A0DDCF1}"/>
                </a:ext>
              </a:extLst>
            </p:cNvPr>
            <p:cNvGrpSpPr/>
            <p:nvPr/>
          </p:nvGrpSpPr>
          <p:grpSpPr>
            <a:xfrm>
              <a:off x="507053" y="5378093"/>
              <a:ext cx="1525932" cy="276999"/>
              <a:chOff x="507053" y="5425718"/>
              <a:chExt cx="1525932" cy="276999"/>
            </a:xfrm>
          </p:grpSpPr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xmlns="" id="{63AFBDAF-A32E-43C2-A13B-AB65E11D67FD}"/>
                  </a:ext>
                </a:extLst>
              </p:cNvPr>
              <p:cNvGrpSpPr/>
              <p:nvPr/>
            </p:nvGrpSpPr>
            <p:grpSpPr>
              <a:xfrm>
                <a:off x="507053" y="5536075"/>
                <a:ext cx="579906" cy="61083"/>
                <a:chOff x="507053" y="5536075"/>
                <a:chExt cx="579906" cy="61083"/>
              </a:xfrm>
            </p:grpSpPr>
            <p:sp>
              <p:nvSpPr>
                <p:cNvPr id="29" name="Flowchart: Terminator 28">
                  <a:extLst>
                    <a:ext uri="{FF2B5EF4-FFF2-40B4-BE49-F238E27FC236}">
                      <a16:creationId xmlns:a16="http://schemas.microsoft.com/office/drawing/2014/main" xmlns="" id="{396C6393-5AD7-4452-BD3E-DC9953826776}"/>
                    </a:ext>
                  </a:extLst>
                </p:cNvPr>
                <p:cNvSpPr/>
                <p:nvPr/>
              </p:nvSpPr>
              <p:spPr>
                <a:xfrm>
                  <a:off x="507053" y="5536075"/>
                  <a:ext cx="579906" cy="56286"/>
                </a:xfrm>
                <a:prstGeom prst="flowChartTerminator">
                  <a:avLst/>
                </a:prstGeom>
                <a:solidFill>
                  <a:srgbClr val="00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0" name="Rectangle 29">
                  <a:extLst>
                    <a:ext uri="{FF2B5EF4-FFF2-40B4-BE49-F238E27FC236}">
                      <a16:creationId xmlns:a16="http://schemas.microsoft.com/office/drawing/2014/main" xmlns="" id="{C7AF7234-7460-4775-91AF-FD2C2916C169}"/>
                    </a:ext>
                  </a:extLst>
                </p:cNvPr>
                <p:cNvSpPr/>
                <p:nvPr/>
              </p:nvSpPr>
              <p:spPr>
                <a:xfrm>
                  <a:off x="704850" y="5539747"/>
                  <a:ext cx="177800" cy="57411"/>
                </a:xfrm>
                <a:prstGeom prst="rect">
                  <a:avLst/>
                </a:prstGeom>
                <a:solidFill>
                  <a:srgbClr val="FFFF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xmlns="" id="{5DDE6A8C-2CB5-4781-8086-F7374AD396E3}"/>
                    </a:ext>
                  </a:extLst>
                </p:cNvPr>
                <p:cNvCxnSpPr/>
                <p:nvPr/>
              </p:nvCxnSpPr>
              <p:spPr>
                <a:xfrm>
                  <a:off x="624689" y="5592361"/>
                  <a:ext cx="293383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xmlns="" id="{7D227641-43D3-4A31-AF1B-BA2B0CDFB66A}"/>
                  </a:ext>
                </a:extLst>
              </p:cNvPr>
              <p:cNvSpPr txBox="1"/>
              <p:nvPr/>
            </p:nvSpPr>
            <p:spPr>
              <a:xfrm>
                <a:off x="1100999" y="5425718"/>
                <a:ext cx="9319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 - C bridge </a:t>
                </a:r>
              </a:p>
            </p:txBody>
          </p:sp>
        </p:grp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65309809-4843-467E-BE28-87D3811494FD}"/>
              </a:ext>
            </a:extLst>
          </p:cNvPr>
          <p:cNvSpPr txBox="1"/>
          <p:nvPr/>
        </p:nvSpPr>
        <p:spPr>
          <a:xfrm>
            <a:off x="5462546" y="400572"/>
            <a:ext cx="2616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 3OVX</a:t>
            </a:r>
          </a:p>
        </p:txBody>
      </p:sp>
    </p:spTree>
    <p:extLst>
      <p:ext uri="{BB962C8B-B14F-4D97-AF65-F5344CB8AC3E}">
        <p14:creationId xmlns:p14="http://schemas.microsoft.com/office/powerpoint/2010/main" xmlns="" val="14784898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E979C769-3A3B-4B33-83BA-334608E0FA9B}"/>
              </a:ext>
            </a:extLst>
          </p:cNvPr>
          <p:cNvSpPr txBox="1"/>
          <p:nvPr/>
        </p:nvSpPr>
        <p:spPr>
          <a:xfrm>
            <a:off x="470779" y="395017"/>
            <a:ext cx="60147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7. </a:t>
            </a:r>
            <a:r>
              <a:rPr lang="en-GB" b="1" dirty="0"/>
              <a:t>Asparaginyl endopeptidase, mature protein, </a:t>
            </a:r>
            <a:r>
              <a:rPr lang="pt-BR" b="1" dirty="0">
                <a:ea typeface="Calibri" panose="020F0502020204030204" pitchFamily="34" charset="0"/>
              </a:rPr>
              <a:t>Smp_075800 </a:t>
            </a:r>
            <a:endParaRPr lang="en-GB" b="1" dirty="0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xmlns="" id="{4D128644-D3DF-4949-BEB1-DEF80EF6039E}"/>
              </a:ext>
            </a:extLst>
          </p:cNvPr>
          <p:cNvGrpSpPr/>
          <p:nvPr/>
        </p:nvGrpSpPr>
        <p:grpSpPr>
          <a:xfrm>
            <a:off x="2439687" y="1499881"/>
            <a:ext cx="5106867" cy="4826157"/>
            <a:chOff x="2439687" y="1499881"/>
            <a:chExt cx="5106867" cy="4826157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xmlns="" id="{8E14B26D-DEB0-4CCA-A45B-2C3836EFEB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rcRect r="503"/>
            <a:stretch>
              <a:fillRect/>
            </a:stretch>
          </p:blipFill>
          <p:spPr>
            <a:xfrm>
              <a:off x="2439687" y="1499881"/>
              <a:ext cx="5106867" cy="4826157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5EEBA1E2-E8FE-48AA-8FDE-C4E9C0735B6C}"/>
                </a:ext>
              </a:extLst>
            </p:cNvPr>
            <p:cNvSpPr txBox="1"/>
            <p:nvPr/>
          </p:nvSpPr>
          <p:spPr>
            <a:xfrm>
              <a:off x="3292143" y="4489830"/>
              <a:ext cx="5703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5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C0FD3B4D-39B1-48D1-8114-AFC174AF6E94}"/>
                </a:ext>
              </a:extLst>
            </p:cNvPr>
            <p:cNvSpPr txBox="1"/>
            <p:nvPr/>
          </p:nvSpPr>
          <p:spPr>
            <a:xfrm>
              <a:off x="6269224" y="5560160"/>
              <a:ext cx="5703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9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1D9CB316-07E4-4B2F-807D-90E92E624AB1}"/>
                </a:ext>
              </a:extLst>
            </p:cNvPr>
            <p:cNvSpPr txBox="1"/>
            <p:nvPr/>
          </p:nvSpPr>
          <p:spPr>
            <a:xfrm>
              <a:off x="5380476" y="3092578"/>
              <a:ext cx="5703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P10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8F913B0B-B9F8-495F-ABBD-CA96CECC25E6}"/>
              </a:ext>
            </a:extLst>
          </p:cNvPr>
          <p:cNvSpPr txBox="1"/>
          <p:nvPr/>
        </p:nvSpPr>
        <p:spPr>
          <a:xfrm>
            <a:off x="6485519" y="395020"/>
            <a:ext cx="25622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Mapped onto PDB  4AW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2EACAB2A-3836-4922-83F6-195A6CE6BABC}"/>
              </a:ext>
            </a:extLst>
          </p:cNvPr>
          <p:cNvSpPr txBox="1"/>
          <p:nvPr/>
        </p:nvSpPr>
        <p:spPr>
          <a:xfrm>
            <a:off x="713138" y="857250"/>
            <a:ext cx="4887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Model rotated through 90⁰ to show active site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xmlns="" id="{D226E072-027A-482C-B3E7-8D9C3B37C5B9}"/>
              </a:ext>
            </a:extLst>
          </p:cNvPr>
          <p:cNvGrpSpPr/>
          <p:nvPr/>
        </p:nvGrpSpPr>
        <p:grpSpPr>
          <a:xfrm>
            <a:off x="434855" y="5420095"/>
            <a:ext cx="2101194" cy="503083"/>
            <a:chOff x="753756" y="5923242"/>
            <a:chExt cx="1771406" cy="461665"/>
          </a:xfrm>
        </p:grpSpPr>
        <p:sp>
          <p:nvSpPr>
            <p:cNvPr id="34" name="Flowchart: Terminator 33">
              <a:extLst>
                <a:ext uri="{FF2B5EF4-FFF2-40B4-BE49-F238E27FC236}">
                  <a16:creationId xmlns:a16="http://schemas.microsoft.com/office/drawing/2014/main" xmlns="" id="{23EDC76A-DE5A-48B9-A884-93F089C0EA85}"/>
                </a:ext>
              </a:extLst>
            </p:cNvPr>
            <p:cNvSpPr/>
            <p:nvPr/>
          </p:nvSpPr>
          <p:spPr>
            <a:xfrm>
              <a:off x="753756" y="6049025"/>
              <a:ext cx="488888" cy="51652"/>
            </a:xfrm>
            <a:prstGeom prst="flowChartTerminator">
              <a:avLst/>
            </a:prstGeom>
            <a:solidFill>
              <a:srgbClr val="00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Flowchart: Terminator 34">
              <a:extLst>
                <a:ext uri="{FF2B5EF4-FFF2-40B4-BE49-F238E27FC236}">
                  <a16:creationId xmlns:a16="http://schemas.microsoft.com/office/drawing/2014/main" xmlns="" id="{8A4FEFD0-3520-48DE-A9C5-B4FA34AC0818}"/>
                </a:ext>
              </a:extLst>
            </p:cNvPr>
            <p:cNvSpPr/>
            <p:nvPr/>
          </p:nvSpPr>
          <p:spPr>
            <a:xfrm>
              <a:off x="753756" y="6220564"/>
              <a:ext cx="488888" cy="51652"/>
            </a:xfrm>
            <a:prstGeom prst="flowChartTerminator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xmlns="" id="{FF8A892F-7345-4E12-86DE-2DB98AA4BCF9}"/>
                </a:ext>
              </a:extLst>
            </p:cNvPr>
            <p:cNvSpPr txBox="1"/>
            <p:nvPr/>
          </p:nvSpPr>
          <p:spPr>
            <a:xfrm>
              <a:off x="1239570" y="5923242"/>
              <a:ext cx="12855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Active site</a:t>
              </a:r>
            </a:p>
            <a:p>
              <a:r>
                <a:rPr lang="en-GB" sz="1200" dirty="0"/>
                <a:t>Ligan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1361439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87FFADD9-0709-4156-9241-236B56723FE2}"/>
              </a:ext>
            </a:extLst>
          </p:cNvPr>
          <p:cNvSpPr txBox="1"/>
          <p:nvPr/>
        </p:nvSpPr>
        <p:spPr>
          <a:xfrm>
            <a:off x="599970" y="406201"/>
            <a:ext cx="55024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8. </a:t>
            </a:r>
            <a:r>
              <a:rPr lang="en-GB" b="1" dirty="0"/>
              <a:t>Asparaginyl endopeptidase, preprotein, </a:t>
            </a:r>
            <a:r>
              <a:rPr lang="pt-BR" b="1" dirty="0">
                <a:ea typeface="Calibri" panose="020F0502020204030204" pitchFamily="34" charset="0"/>
              </a:rPr>
              <a:t>Smp_075800 </a:t>
            </a:r>
            <a:endParaRPr lang="en-GB" b="1" dirty="0"/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xmlns="" id="{DB2C7567-DBCB-4DF6-A6FC-3F27C79F3C09}"/>
              </a:ext>
            </a:extLst>
          </p:cNvPr>
          <p:cNvGrpSpPr/>
          <p:nvPr/>
        </p:nvGrpSpPr>
        <p:grpSpPr>
          <a:xfrm>
            <a:off x="1966697" y="1827511"/>
            <a:ext cx="6191964" cy="3736990"/>
            <a:chOff x="1371273" y="1807281"/>
            <a:chExt cx="6191964" cy="3736990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xmlns="" id="{E7841DAE-119A-4BCF-8272-01EF8E5F0114}"/>
                </a:ext>
              </a:extLst>
            </p:cNvPr>
            <p:cNvGrpSpPr/>
            <p:nvPr/>
          </p:nvGrpSpPr>
          <p:grpSpPr>
            <a:xfrm>
              <a:off x="1371273" y="1807281"/>
              <a:ext cx="6191964" cy="3736990"/>
              <a:chOff x="1308830" y="1735133"/>
              <a:chExt cx="6191964" cy="3736990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xmlns="" id="{99A9F5BE-CB0E-4A69-91CF-6298393344F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 rot="20923296">
                <a:off x="1561308" y="1864414"/>
                <a:ext cx="3535794" cy="3607709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xmlns="" id="{573618ED-82F1-46F8-83CF-BE9CF5F76C1E}"/>
                  </a:ext>
                </a:extLst>
              </p:cNvPr>
              <p:cNvSpPr txBox="1"/>
              <p:nvPr/>
            </p:nvSpPr>
            <p:spPr>
              <a:xfrm>
                <a:off x="1308830" y="1908705"/>
                <a:ext cx="216377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Death domain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xmlns="" id="{E12C6FE4-43A2-4E60-A12B-AA1F696C43C0}"/>
                  </a:ext>
                </a:extLst>
              </p:cNvPr>
              <p:cNvSpPr txBox="1"/>
              <p:nvPr/>
            </p:nvSpPr>
            <p:spPr>
              <a:xfrm>
                <a:off x="4719637" y="4771981"/>
                <a:ext cx="216377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P13</a:t>
                </a:r>
              </a:p>
              <a:p>
                <a:r>
                  <a:rPr lang="en-GB" sz="1400" dirty="0"/>
                  <a:t>Alpha cleavage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xmlns="" id="{6BB65260-D5D9-4F77-987C-D01319320823}"/>
                  </a:ext>
                </a:extLst>
              </p:cNvPr>
              <p:cNvSpPr txBox="1"/>
              <p:nvPr/>
            </p:nvSpPr>
            <p:spPr>
              <a:xfrm>
                <a:off x="3953280" y="1735133"/>
                <a:ext cx="216377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Beta ND/NN cleavage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xmlns="" id="{1C3A8BCF-ED17-4E7E-AACE-8515EF48B433}"/>
                  </a:ext>
                </a:extLst>
              </p:cNvPr>
              <p:cNvSpPr txBox="1"/>
              <p:nvPr/>
            </p:nvSpPr>
            <p:spPr>
              <a:xfrm>
                <a:off x="5337016" y="3290113"/>
                <a:ext cx="216377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/>
                  <a:t>Activation peptide</a:t>
                </a:r>
              </a:p>
            </p:txBody>
          </p:sp>
          <p:sp>
            <p:nvSpPr>
              <p:cNvPr id="8" name="Left Brace 7">
                <a:extLst>
                  <a:ext uri="{FF2B5EF4-FFF2-40B4-BE49-F238E27FC236}">
                    <a16:creationId xmlns:a16="http://schemas.microsoft.com/office/drawing/2014/main" xmlns="" id="{1E3C9FEA-3A2A-42F2-A239-D3760C54DC63}"/>
                  </a:ext>
                </a:extLst>
              </p:cNvPr>
              <p:cNvSpPr/>
              <p:nvPr/>
            </p:nvSpPr>
            <p:spPr>
              <a:xfrm rot="3682511">
                <a:off x="2491316" y="1039143"/>
                <a:ext cx="213305" cy="2516285"/>
              </a:xfrm>
              <a:prstGeom prst="leftBrac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" name="Left Brace 8">
                <a:extLst>
                  <a:ext uri="{FF2B5EF4-FFF2-40B4-BE49-F238E27FC236}">
                    <a16:creationId xmlns:a16="http://schemas.microsoft.com/office/drawing/2014/main" xmlns="" id="{5109BC43-7293-4101-A4A7-4005D03285EE}"/>
                  </a:ext>
                </a:extLst>
              </p:cNvPr>
              <p:cNvSpPr/>
              <p:nvPr/>
            </p:nvSpPr>
            <p:spPr>
              <a:xfrm rot="10367558">
                <a:off x="5086703" y="2075063"/>
                <a:ext cx="248253" cy="2691980"/>
              </a:xfrm>
              <a:prstGeom prst="leftBrac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A41D79B9-8451-4080-8FF1-9699F2627D2C}"/>
                </a:ext>
              </a:extLst>
            </p:cNvPr>
            <p:cNvSpPr txBox="1"/>
            <p:nvPr/>
          </p:nvSpPr>
          <p:spPr>
            <a:xfrm>
              <a:off x="4680641" y="3018355"/>
              <a:ext cx="914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/>
                <a:t>P14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FBF6447-1AC0-4421-9973-491D4126A76B}"/>
              </a:ext>
            </a:extLst>
          </p:cNvPr>
          <p:cNvSpPr txBox="1"/>
          <p:nvPr/>
        </p:nvSpPr>
        <p:spPr>
          <a:xfrm>
            <a:off x="6190465" y="406201"/>
            <a:ext cx="25416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apped onto PDB  4FGU</a:t>
            </a:r>
          </a:p>
        </p:txBody>
      </p:sp>
    </p:spTree>
    <p:extLst>
      <p:ext uri="{BB962C8B-B14F-4D97-AF65-F5344CB8AC3E}">
        <p14:creationId xmlns:p14="http://schemas.microsoft.com/office/powerpoint/2010/main" xmlns="" val="11749211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4377DFA5-7D97-485A-8B6F-C35F52FFBC8B}"/>
              </a:ext>
            </a:extLst>
          </p:cNvPr>
          <p:cNvSpPr txBox="1"/>
          <p:nvPr/>
        </p:nvSpPr>
        <p:spPr>
          <a:xfrm>
            <a:off x="419100" y="395843"/>
            <a:ext cx="289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9. </a:t>
            </a:r>
            <a:r>
              <a:rPr lang="en-GB" b="1" dirty="0"/>
              <a:t>Ferritin nanocage model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509DE535-F9F2-4147-BC40-7346CAAEE7E5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rcRect l="1927" t="1492"/>
          <a:stretch>
            <a:fillRect/>
          </a:stretch>
        </p:blipFill>
        <p:spPr>
          <a:xfrm>
            <a:off x="3184634" y="1387366"/>
            <a:ext cx="4044840" cy="396896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1F13D37B-4792-4B94-A08F-2EEAED9857E0}"/>
              </a:ext>
            </a:extLst>
          </p:cNvPr>
          <p:cNvSpPr txBox="1"/>
          <p:nvPr/>
        </p:nvSpPr>
        <p:spPr>
          <a:xfrm>
            <a:off x="647700" y="6122709"/>
            <a:ext cx="7048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0" u="none" strike="noStrike" baseline="0" dirty="0">
                <a:latin typeface="AdvPA189"/>
              </a:rPr>
              <a:t>From Thiel, E. Current Opinion in Chemical Biology </a:t>
            </a:r>
            <a:r>
              <a:rPr lang="en-US" sz="1400" b="1" i="0" u="none" strike="noStrike" baseline="0" dirty="0">
                <a:latin typeface="AdvPA183"/>
              </a:rPr>
              <a:t>2011, </a:t>
            </a:r>
            <a:r>
              <a:rPr lang="en-US" sz="1400" b="1" i="0" u="none" strike="noStrike" baseline="0" dirty="0">
                <a:latin typeface="AdvPA189"/>
              </a:rPr>
              <a:t>15</a:t>
            </a:r>
            <a:r>
              <a:rPr lang="en-US" sz="1400" b="1" i="0" u="none" strike="noStrike" baseline="0" dirty="0">
                <a:latin typeface="AdvPA183"/>
              </a:rPr>
              <a:t>:304–311</a:t>
            </a:r>
            <a:endParaRPr lang="en-GB" sz="14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6D61567B-D691-432E-9E3D-EBD00FAF1D2D}"/>
              </a:ext>
            </a:extLst>
          </p:cNvPr>
          <p:cNvSpPr txBox="1"/>
          <p:nvPr/>
        </p:nvSpPr>
        <p:spPr>
          <a:xfrm>
            <a:off x="419100" y="1442675"/>
            <a:ext cx="14763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a, iron channel round threefold axi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B417AF67-A391-45E5-98B3-41BF27E10F08}"/>
              </a:ext>
            </a:extLst>
          </p:cNvPr>
          <p:cNvSpPr txBox="1"/>
          <p:nvPr/>
        </p:nvSpPr>
        <p:spPr>
          <a:xfrm>
            <a:off x="7296150" y="1442675"/>
            <a:ext cx="14763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b, cross section through the cag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650EA14F-7958-49D9-A81E-7DC87EBE04F2}"/>
              </a:ext>
            </a:extLst>
          </p:cNvPr>
          <p:cNvSpPr txBox="1"/>
          <p:nvPr/>
        </p:nvSpPr>
        <p:spPr>
          <a:xfrm>
            <a:off x="419100" y="2910353"/>
            <a:ext cx="26193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1200" b="1" dirty="0"/>
              <a:t>c, </a:t>
            </a:r>
            <a:r>
              <a:rPr lang="en-US" sz="1200" b="1" i="0" u="none" strike="noStrike" baseline="0" dirty="0">
                <a:latin typeface="AdvPA183"/>
              </a:rPr>
              <a:t>iron moving through ferritin external pores to Fe(II) ion channels and to oxidoreductase sites, then through the Fe(III)O nucleation channels into the mineralization cavity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xmlns="" val="12638722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83</TotalTime>
  <Words>1015</Words>
  <Application>Microsoft Office PowerPoint</Application>
  <PresentationFormat>Apresentação na tela (4:3)</PresentationFormat>
  <Paragraphs>305</Paragraphs>
  <Slides>31</Slides>
  <Notes>8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31</vt:i4>
      </vt:variant>
    </vt:vector>
  </HeadingPairs>
  <TitlesOfParts>
    <vt:vector size="32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  <vt:lpstr>Slide 24</vt:lpstr>
      <vt:lpstr>Slide 25</vt:lpstr>
      <vt:lpstr>Slide 26</vt:lpstr>
      <vt:lpstr>Slide 27</vt:lpstr>
      <vt:lpstr>Slide 28</vt:lpstr>
      <vt:lpstr>Slide 29</vt:lpstr>
      <vt:lpstr>Slide 30</vt:lpstr>
      <vt:lpstr>Slide 3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Wilson</dc:creator>
  <cp:lastModifiedBy>Leonardo Paiva Farias</cp:lastModifiedBy>
  <cp:revision>286</cp:revision>
  <dcterms:created xsi:type="dcterms:W3CDTF">2020-06-18T15:14:31Z</dcterms:created>
  <dcterms:modified xsi:type="dcterms:W3CDTF">2021-01-27T19:19:21Z</dcterms:modified>
</cp:coreProperties>
</file>